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79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470"/>
    <p:restoredTop sz="94966"/>
  </p:normalViewPr>
  <p:slideViewPr>
    <p:cSldViewPr snapToGrid="0" snapToObjects="1">
      <p:cViewPr varScale="1">
        <p:scale>
          <a:sx n="81" d="100"/>
          <a:sy n="81" d="100"/>
        </p:scale>
        <p:origin x="388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AE31C-EE95-E743-852F-77E70336199A}" type="datetimeFigureOut">
              <a:rPr lang="en-GB" smtClean="0"/>
              <a:t>15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CADF9-2242-1C45-8A95-C3B7B81A72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97499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AE31C-EE95-E743-852F-77E70336199A}" type="datetimeFigureOut">
              <a:rPr lang="en-GB" smtClean="0"/>
              <a:t>15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CADF9-2242-1C45-8A95-C3B7B81A72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99036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AE31C-EE95-E743-852F-77E70336199A}" type="datetimeFigureOut">
              <a:rPr lang="en-GB" smtClean="0"/>
              <a:t>15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CADF9-2242-1C45-8A95-C3B7B81A72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56590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AE31C-EE95-E743-852F-77E70336199A}" type="datetimeFigureOut">
              <a:rPr lang="en-GB" smtClean="0"/>
              <a:t>15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CADF9-2242-1C45-8A95-C3B7B81A72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89315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AE31C-EE95-E743-852F-77E70336199A}" type="datetimeFigureOut">
              <a:rPr lang="en-GB" smtClean="0"/>
              <a:t>15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CADF9-2242-1C45-8A95-C3B7B81A72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47984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AE31C-EE95-E743-852F-77E70336199A}" type="datetimeFigureOut">
              <a:rPr lang="en-GB" smtClean="0"/>
              <a:t>15/08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CADF9-2242-1C45-8A95-C3B7B81A72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49294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AE31C-EE95-E743-852F-77E70336199A}" type="datetimeFigureOut">
              <a:rPr lang="en-GB" smtClean="0"/>
              <a:t>15/08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CADF9-2242-1C45-8A95-C3B7B81A72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87625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AE31C-EE95-E743-852F-77E70336199A}" type="datetimeFigureOut">
              <a:rPr lang="en-GB" smtClean="0"/>
              <a:t>15/08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CADF9-2242-1C45-8A95-C3B7B81A72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18449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AE31C-EE95-E743-852F-77E70336199A}" type="datetimeFigureOut">
              <a:rPr lang="en-GB" smtClean="0"/>
              <a:t>15/08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CADF9-2242-1C45-8A95-C3B7B81A72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99839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AE31C-EE95-E743-852F-77E70336199A}" type="datetimeFigureOut">
              <a:rPr lang="en-GB" smtClean="0"/>
              <a:t>15/08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CADF9-2242-1C45-8A95-C3B7B81A72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85459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AE31C-EE95-E743-852F-77E70336199A}" type="datetimeFigureOut">
              <a:rPr lang="en-GB" smtClean="0"/>
              <a:t>15/08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CCADF9-2242-1C45-8A95-C3B7B81A72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562337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2AE31C-EE95-E743-852F-77E70336199A}" type="datetimeFigureOut">
              <a:rPr lang="en-GB" smtClean="0"/>
              <a:t>15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CCADF9-2242-1C45-8A95-C3B7B81A725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26291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Rectangle 79">
            <a:extLst>
              <a:ext uri="{FF2B5EF4-FFF2-40B4-BE49-F238E27FC236}">
                <a16:creationId xmlns:a16="http://schemas.microsoft.com/office/drawing/2014/main" id="{E298D13C-6110-1241-9BF7-150D2CA1B41F}"/>
              </a:ext>
            </a:extLst>
          </p:cNvPr>
          <p:cNvSpPr/>
          <p:nvPr/>
        </p:nvSpPr>
        <p:spPr>
          <a:xfrm>
            <a:off x="3114431" y="5969448"/>
            <a:ext cx="847969" cy="1134319"/>
          </a:xfrm>
          <a:prstGeom prst="rect">
            <a:avLst/>
          </a:prstGeom>
          <a:solidFill>
            <a:schemeClr val="tx2">
              <a:lumMod val="20000"/>
              <a:lumOff val="80000"/>
              <a:alpha val="40000"/>
            </a:schemeClr>
          </a:solidFill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Rectangle 78">
            <a:extLst>
              <a:ext uri="{FF2B5EF4-FFF2-40B4-BE49-F238E27FC236}">
                <a16:creationId xmlns:a16="http://schemas.microsoft.com/office/drawing/2014/main" id="{CF1B2827-2437-894C-8CF7-3D13FAC0F4EC}"/>
              </a:ext>
            </a:extLst>
          </p:cNvPr>
          <p:cNvSpPr/>
          <p:nvPr/>
        </p:nvSpPr>
        <p:spPr>
          <a:xfrm>
            <a:off x="3137878" y="4461080"/>
            <a:ext cx="879230" cy="1134319"/>
          </a:xfrm>
          <a:prstGeom prst="rect">
            <a:avLst/>
          </a:prstGeom>
          <a:solidFill>
            <a:schemeClr val="tx2">
              <a:lumMod val="20000"/>
              <a:lumOff val="80000"/>
              <a:alpha val="40000"/>
            </a:schemeClr>
          </a:solidFill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Rectangle 77">
            <a:extLst>
              <a:ext uri="{FF2B5EF4-FFF2-40B4-BE49-F238E27FC236}">
                <a16:creationId xmlns:a16="http://schemas.microsoft.com/office/drawing/2014/main" id="{CDE02910-3C3F-D74E-BDEB-5108BDE1F960}"/>
              </a:ext>
            </a:extLst>
          </p:cNvPr>
          <p:cNvSpPr/>
          <p:nvPr/>
        </p:nvSpPr>
        <p:spPr>
          <a:xfrm>
            <a:off x="3137877" y="2968341"/>
            <a:ext cx="930031" cy="1134319"/>
          </a:xfrm>
          <a:prstGeom prst="rect">
            <a:avLst/>
          </a:prstGeom>
          <a:solidFill>
            <a:schemeClr val="tx2">
              <a:lumMod val="20000"/>
              <a:lumOff val="80000"/>
              <a:alpha val="40000"/>
            </a:schemeClr>
          </a:solidFill>
          <a:ln w="63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9575E2D6-5EA8-DA4D-8C1B-CF75AF343690}"/>
              </a:ext>
            </a:extLst>
          </p:cNvPr>
          <p:cNvSpPr txBox="1"/>
          <p:nvPr/>
        </p:nvSpPr>
        <p:spPr>
          <a:xfrm>
            <a:off x="3004044" y="9506740"/>
            <a:ext cx="849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5CE2F222-8370-D74D-8F12-FCD7A1A5964C}"/>
              </a:ext>
            </a:extLst>
          </p:cNvPr>
          <p:cNvGrpSpPr/>
          <p:nvPr/>
        </p:nvGrpSpPr>
        <p:grpSpPr>
          <a:xfrm>
            <a:off x="2145547" y="2718606"/>
            <a:ext cx="2566907" cy="4468789"/>
            <a:chOff x="2057254" y="3121852"/>
            <a:chExt cx="2566907" cy="4468789"/>
          </a:xfrm>
        </p:grpSpPr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A67CCCC1-A1DA-6F40-9227-8BF9538F6F9A}"/>
                </a:ext>
              </a:extLst>
            </p:cNvPr>
            <p:cNvSpPr txBox="1"/>
            <p:nvPr/>
          </p:nvSpPr>
          <p:spPr>
            <a:xfrm rot="16200000">
              <a:off x="4191029" y="5314415"/>
              <a:ext cx="681598" cy="184666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% GC Content</a:t>
              </a:r>
            </a:p>
          </p:txBody>
        </p:sp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990421A0-AB9A-4344-8D16-5C918EFF75D8}"/>
                </a:ext>
              </a:extLst>
            </p:cNvPr>
            <p:cNvGrpSpPr/>
            <p:nvPr/>
          </p:nvGrpSpPr>
          <p:grpSpPr>
            <a:xfrm>
              <a:off x="2322522" y="3297597"/>
              <a:ext cx="2168032" cy="1285312"/>
              <a:chOff x="2322522" y="5517286"/>
              <a:chExt cx="2168032" cy="1285312"/>
            </a:xfrm>
          </p:grpSpPr>
          <p:cxnSp>
            <p:nvCxnSpPr>
              <p:cNvPr id="117" name="Straight Connector 116">
                <a:extLst>
                  <a:ext uri="{FF2B5EF4-FFF2-40B4-BE49-F238E27FC236}">
                    <a16:creationId xmlns:a16="http://schemas.microsoft.com/office/drawing/2014/main" id="{4E3812D7-CB61-4741-B528-CDB9E5E567D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71972" y="5592602"/>
                <a:ext cx="36000" cy="0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8" name="Straight Connector 117">
                <a:extLst>
                  <a:ext uri="{FF2B5EF4-FFF2-40B4-BE49-F238E27FC236}">
                    <a16:creationId xmlns:a16="http://schemas.microsoft.com/office/drawing/2014/main" id="{7BEE3B63-6112-A94E-81B8-85F4D444B6B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71972" y="6068761"/>
                <a:ext cx="36000" cy="0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Straight Connector 38">
                <a:extLst>
                  <a:ext uri="{FF2B5EF4-FFF2-40B4-BE49-F238E27FC236}">
                    <a16:creationId xmlns:a16="http://schemas.microsoft.com/office/drawing/2014/main" id="{216A2C33-F239-8543-AE72-3827F17F927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325697" y="6070698"/>
                <a:ext cx="1944000" cy="0"/>
              </a:xfrm>
              <a:prstGeom prst="line">
                <a:avLst/>
              </a:prstGeom>
              <a:ln w="6350">
                <a:solidFill>
                  <a:schemeClr val="bg1">
                    <a:lumMod val="50000"/>
                  </a:schemeClr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8" name="Group 7">
                <a:extLst>
                  <a:ext uri="{FF2B5EF4-FFF2-40B4-BE49-F238E27FC236}">
                    <a16:creationId xmlns:a16="http://schemas.microsoft.com/office/drawing/2014/main" id="{29101CD0-7F78-9347-B2D0-03B961E88292}"/>
                  </a:ext>
                </a:extLst>
              </p:cNvPr>
              <p:cNvGrpSpPr/>
              <p:nvPr/>
            </p:nvGrpSpPr>
            <p:grpSpPr>
              <a:xfrm>
                <a:off x="2322522" y="5640019"/>
                <a:ext cx="1962151" cy="870720"/>
                <a:chOff x="3063875" y="1206500"/>
                <a:chExt cx="1962151" cy="590550"/>
              </a:xfrm>
            </p:grpSpPr>
            <p:sp>
              <p:nvSpPr>
                <p:cNvPr id="45" name="Freeform 44">
                  <a:extLst>
                    <a:ext uri="{FF2B5EF4-FFF2-40B4-BE49-F238E27FC236}">
                      <a16:creationId xmlns:a16="http://schemas.microsoft.com/office/drawing/2014/main" id="{093DD2B8-0278-AC44-B1E3-C495CD1E19B1}"/>
                    </a:ext>
                  </a:extLst>
                </p:cNvPr>
                <p:cNvSpPr/>
                <p:nvPr/>
              </p:nvSpPr>
              <p:spPr>
                <a:xfrm>
                  <a:off x="3063875" y="1206500"/>
                  <a:ext cx="1765300" cy="590550"/>
                </a:xfrm>
                <a:custGeom>
                  <a:avLst/>
                  <a:gdLst>
                    <a:gd name="connsiteX0" fmla="*/ 0 w 1765300"/>
                    <a:gd name="connsiteY0" fmla="*/ 520700 h 590550"/>
                    <a:gd name="connsiteX1" fmla="*/ 12700 w 1765300"/>
                    <a:gd name="connsiteY1" fmla="*/ 571500 h 590550"/>
                    <a:gd name="connsiteX2" fmla="*/ 47625 w 1765300"/>
                    <a:gd name="connsiteY2" fmla="*/ 0 h 590550"/>
                    <a:gd name="connsiteX3" fmla="*/ 50800 w 1765300"/>
                    <a:gd name="connsiteY3" fmla="*/ 41275 h 590550"/>
                    <a:gd name="connsiteX4" fmla="*/ 53975 w 1765300"/>
                    <a:gd name="connsiteY4" fmla="*/ 98425 h 590550"/>
                    <a:gd name="connsiteX5" fmla="*/ 63500 w 1765300"/>
                    <a:gd name="connsiteY5" fmla="*/ 101600 h 590550"/>
                    <a:gd name="connsiteX6" fmla="*/ 92075 w 1765300"/>
                    <a:gd name="connsiteY6" fmla="*/ 304800 h 590550"/>
                    <a:gd name="connsiteX7" fmla="*/ 88900 w 1765300"/>
                    <a:gd name="connsiteY7" fmla="*/ 247650 h 590550"/>
                    <a:gd name="connsiteX8" fmla="*/ 95250 w 1765300"/>
                    <a:gd name="connsiteY8" fmla="*/ 250825 h 590550"/>
                    <a:gd name="connsiteX9" fmla="*/ 101600 w 1765300"/>
                    <a:gd name="connsiteY9" fmla="*/ 203200 h 590550"/>
                    <a:gd name="connsiteX10" fmla="*/ 101600 w 1765300"/>
                    <a:gd name="connsiteY10" fmla="*/ 203200 h 590550"/>
                    <a:gd name="connsiteX11" fmla="*/ 117475 w 1765300"/>
                    <a:gd name="connsiteY11" fmla="*/ 257175 h 590550"/>
                    <a:gd name="connsiteX12" fmla="*/ 123825 w 1765300"/>
                    <a:gd name="connsiteY12" fmla="*/ 222250 h 590550"/>
                    <a:gd name="connsiteX13" fmla="*/ 136525 w 1765300"/>
                    <a:gd name="connsiteY13" fmla="*/ 225425 h 590550"/>
                    <a:gd name="connsiteX14" fmla="*/ 146050 w 1765300"/>
                    <a:gd name="connsiteY14" fmla="*/ 276225 h 590550"/>
                    <a:gd name="connsiteX15" fmla="*/ 146050 w 1765300"/>
                    <a:gd name="connsiteY15" fmla="*/ 304800 h 590550"/>
                    <a:gd name="connsiteX16" fmla="*/ 165100 w 1765300"/>
                    <a:gd name="connsiteY16" fmla="*/ 215900 h 590550"/>
                    <a:gd name="connsiteX17" fmla="*/ 177800 w 1765300"/>
                    <a:gd name="connsiteY17" fmla="*/ 263525 h 590550"/>
                    <a:gd name="connsiteX18" fmla="*/ 177800 w 1765300"/>
                    <a:gd name="connsiteY18" fmla="*/ 263525 h 590550"/>
                    <a:gd name="connsiteX19" fmla="*/ 196850 w 1765300"/>
                    <a:gd name="connsiteY19" fmla="*/ 127000 h 590550"/>
                    <a:gd name="connsiteX20" fmla="*/ 209550 w 1765300"/>
                    <a:gd name="connsiteY20" fmla="*/ 117475 h 590550"/>
                    <a:gd name="connsiteX21" fmla="*/ 215900 w 1765300"/>
                    <a:gd name="connsiteY21" fmla="*/ 41275 h 590550"/>
                    <a:gd name="connsiteX22" fmla="*/ 222250 w 1765300"/>
                    <a:gd name="connsiteY22" fmla="*/ 101600 h 590550"/>
                    <a:gd name="connsiteX23" fmla="*/ 228600 w 1765300"/>
                    <a:gd name="connsiteY23" fmla="*/ 161925 h 590550"/>
                    <a:gd name="connsiteX24" fmla="*/ 234950 w 1765300"/>
                    <a:gd name="connsiteY24" fmla="*/ 200025 h 590550"/>
                    <a:gd name="connsiteX25" fmla="*/ 247650 w 1765300"/>
                    <a:gd name="connsiteY25" fmla="*/ 139700 h 590550"/>
                    <a:gd name="connsiteX26" fmla="*/ 257175 w 1765300"/>
                    <a:gd name="connsiteY26" fmla="*/ 193675 h 590550"/>
                    <a:gd name="connsiteX27" fmla="*/ 269875 w 1765300"/>
                    <a:gd name="connsiteY27" fmla="*/ 155575 h 590550"/>
                    <a:gd name="connsiteX28" fmla="*/ 301625 w 1765300"/>
                    <a:gd name="connsiteY28" fmla="*/ 368300 h 590550"/>
                    <a:gd name="connsiteX29" fmla="*/ 317500 w 1765300"/>
                    <a:gd name="connsiteY29" fmla="*/ 206375 h 590550"/>
                    <a:gd name="connsiteX30" fmla="*/ 336550 w 1765300"/>
                    <a:gd name="connsiteY30" fmla="*/ 133350 h 590550"/>
                    <a:gd name="connsiteX31" fmla="*/ 346075 w 1765300"/>
                    <a:gd name="connsiteY31" fmla="*/ 123825 h 590550"/>
                    <a:gd name="connsiteX32" fmla="*/ 368300 w 1765300"/>
                    <a:gd name="connsiteY32" fmla="*/ 209550 h 590550"/>
                    <a:gd name="connsiteX33" fmla="*/ 374650 w 1765300"/>
                    <a:gd name="connsiteY33" fmla="*/ 241300 h 590550"/>
                    <a:gd name="connsiteX34" fmla="*/ 390525 w 1765300"/>
                    <a:gd name="connsiteY34" fmla="*/ 349250 h 590550"/>
                    <a:gd name="connsiteX35" fmla="*/ 406400 w 1765300"/>
                    <a:gd name="connsiteY35" fmla="*/ 276225 h 590550"/>
                    <a:gd name="connsiteX36" fmla="*/ 412750 w 1765300"/>
                    <a:gd name="connsiteY36" fmla="*/ 320675 h 590550"/>
                    <a:gd name="connsiteX37" fmla="*/ 434975 w 1765300"/>
                    <a:gd name="connsiteY37" fmla="*/ 228600 h 590550"/>
                    <a:gd name="connsiteX38" fmla="*/ 441325 w 1765300"/>
                    <a:gd name="connsiteY38" fmla="*/ 285750 h 590550"/>
                    <a:gd name="connsiteX39" fmla="*/ 466725 w 1765300"/>
                    <a:gd name="connsiteY39" fmla="*/ 107950 h 590550"/>
                    <a:gd name="connsiteX40" fmla="*/ 469900 w 1765300"/>
                    <a:gd name="connsiteY40" fmla="*/ 168275 h 590550"/>
                    <a:gd name="connsiteX41" fmla="*/ 476250 w 1765300"/>
                    <a:gd name="connsiteY41" fmla="*/ 123825 h 590550"/>
                    <a:gd name="connsiteX42" fmla="*/ 482600 w 1765300"/>
                    <a:gd name="connsiteY42" fmla="*/ 152400 h 590550"/>
                    <a:gd name="connsiteX43" fmla="*/ 482600 w 1765300"/>
                    <a:gd name="connsiteY43" fmla="*/ 152400 h 590550"/>
                    <a:gd name="connsiteX44" fmla="*/ 498475 w 1765300"/>
                    <a:gd name="connsiteY44" fmla="*/ 177800 h 590550"/>
                    <a:gd name="connsiteX45" fmla="*/ 498475 w 1765300"/>
                    <a:gd name="connsiteY45" fmla="*/ 177800 h 590550"/>
                    <a:gd name="connsiteX46" fmla="*/ 520700 w 1765300"/>
                    <a:gd name="connsiteY46" fmla="*/ 196850 h 590550"/>
                    <a:gd name="connsiteX47" fmla="*/ 536575 w 1765300"/>
                    <a:gd name="connsiteY47" fmla="*/ 133350 h 590550"/>
                    <a:gd name="connsiteX48" fmla="*/ 549275 w 1765300"/>
                    <a:gd name="connsiteY48" fmla="*/ 149225 h 590550"/>
                    <a:gd name="connsiteX49" fmla="*/ 549275 w 1765300"/>
                    <a:gd name="connsiteY49" fmla="*/ 98425 h 590550"/>
                    <a:gd name="connsiteX50" fmla="*/ 561975 w 1765300"/>
                    <a:gd name="connsiteY50" fmla="*/ 142875 h 590550"/>
                    <a:gd name="connsiteX51" fmla="*/ 581025 w 1765300"/>
                    <a:gd name="connsiteY51" fmla="*/ 120650 h 590550"/>
                    <a:gd name="connsiteX52" fmla="*/ 587375 w 1765300"/>
                    <a:gd name="connsiteY52" fmla="*/ 203200 h 590550"/>
                    <a:gd name="connsiteX53" fmla="*/ 596900 w 1765300"/>
                    <a:gd name="connsiteY53" fmla="*/ 165100 h 590550"/>
                    <a:gd name="connsiteX54" fmla="*/ 596900 w 1765300"/>
                    <a:gd name="connsiteY54" fmla="*/ 165100 h 590550"/>
                    <a:gd name="connsiteX55" fmla="*/ 612775 w 1765300"/>
                    <a:gd name="connsiteY55" fmla="*/ 184150 h 590550"/>
                    <a:gd name="connsiteX56" fmla="*/ 622300 w 1765300"/>
                    <a:gd name="connsiteY56" fmla="*/ 279400 h 590550"/>
                    <a:gd name="connsiteX57" fmla="*/ 631825 w 1765300"/>
                    <a:gd name="connsiteY57" fmla="*/ 247650 h 590550"/>
                    <a:gd name="connsiteX58" fmla="*/ 641350 w 1765300"/>
                    <a:gd name="connsiteY58" fmla="*/ 215900 h 590550"/>
                    <a:gd name="connsiteX59" fmla="*/ 644525 w 1765300"/>
                    <a:gd name="connsiteY59" fmla="*/ 247650 h 590550"/>
                    <a:gd name="connsiteX60" fmla="*/ 654050 w 1765300"/>
                    <a:gd name="connsiteY60" fmla="*/ 285750 h 590550"/>
                    <a:gd name="connsiteX61" fmla="*/ 657225 w 1765300"/>
                    <a:gd name="connsiteY61" fmla="*/ 222250 h 590550"/>
                    <a:gd name="connsiteX62" fmla="*/ 666750 w 1765300"/>
                    <a:gd name="connsiteY62" fmla="*/ 285750 h 590550"/>
                    <a:gd name="connsiteX63" fmla="*/ 679450 w 1765300"/>
                    <a:gd name="connsiteY63" fmla="*/ 269875 h 590550"/>
                    <a:gd name="connsiteX64" fmla="*/ 685800 w 1765300"/>
                    <a:gd name="connsiteY64" fmla="*/ 317500 h 590550"/>
                    <a:gd name="connsiteX65" fmla="*/ 692150 w 1765300"/>
                    <a:gd name="connsiteY65" fmla="*/ 203200 h 590550"/>
                    <a:gd name="connsiteX66" fmla="*/ 701675 w 1765300"/>
                    <a:gd name="connsiteY66" fmla="*/ 266700 h 590550"/>
                    <a:gd name="connsiteX67" fmla="*/ 717550 w 1765300"/>
                    <a:gd name="connsiteY67" fmla="*/ 358775 h 590550"/>
                    <a:gd name="connsiteX68" fmla="*/ 717550 w 1765300"/>
                    <a:gd name="connsiteY68" fmla="*/ 295275 h 590550"/>
                    <a:gd name="connsiteX69" fmla="*/ 739775 w 1765300"/>
                    <a:gd name="connsiteY69" fmla="*/ 454025 h 590550"/>
                    <a:gd name="connsiteX70" fmla="*/ 742950 w 1765300"/>
                    <a:gd name="connsiteY70" fmla="*/ 390525 h 590550"/>
                    <a:gd name="connsiteX71" fmla="*/ 749300 w 1765300"/>
                    <a:gd name="connsiteY71" fmla="*/ 279400 h 590550"/>
                    <a:gd name="connsiteX72" fmla="*/ 755650 w 1765300"/>
                    <a:gd name="connsiteY72" fmla="*/ 314325 h 590550"/>
                    <a:gd name="connsiteX73" fmla="*/ 765175 w 1765300"/>
                    <a:gd name="connsiteY73" fmla="*/ 219075 h 590550"/>
                    <a:gd name="connsiteX74" fmla="*/ 771525 w 1765300"/>
                    <a:gd name="connsiteY74" fmla="*/ 203200 h 590550"/>
                    <a:gd name="connsiteX75" fmla="*/ 777875 w 1765300"/>
                    <a:gd name="connsiteY75" fmla="*/ 231775 h 590550"/>
                    <a:gd name="connsiteX76" fmla="*/ 784225 w 1765300"/>
                    <a:gd name="connsiteY76" fmla="*/ 184150 h 590550"/>
                    <a:gd name="connsiteX77" fmla="*/ 793750 w 1765300"/>
                    <a:gd name="connsiteY77" fmla="*/ 247650 h 590550"/>
                    <a:gd name="connsiteX78" fmla="*/ 803275 w 1765300"/>
                    <a:gd name="connsiteY78" fmla="*/ 273050 h 590550"/>
                    <a:gd name="connsiteX79" fmla="*/ 828675 w 1765300"/>
                    <a:gd name="connsiteY79" fmla="*/ 434975 h 590550"/>
                    <a:gd name="connsiteX80" fmla="*/ 841375 w 1765300"/>
                    <a:gd name="connsiteY80" fmla="*/ 346075 h 590550"/>
                    <a:gd name="connsiteX81" fmla="*/ 854075 w 1765300"/>
                    <a:gd name="connsiteY81" fmla="*/ 384175 h 590550"/>
                    <a:gd name="connsiteX82" fmla="*/ 857250 w 1765300"/>
                    <a:gd name="connsiteY82" fmla="*/ 311150 h 590550"/>
                    <a:gd name="connsiteX83" fmla="*/ 882650 w 1765300"/>
                    <a:gd name="connsiteY83" fmla="*/ 384175 h 590550"/>
                    <a:gd name="connsiteX84" fmla="*/ 898525 w 1765300"/>
                    <a:gd name="connsiteY84" fmla="*/ 263525 h 590550"/>
                    <a:gd name="connsiteX85" fmla="*/ 898525 w 1765300"/>
                    <a:gd name="connsiteY85" fmla="*/ 263525 h 590550"/>
                    <a:gd name="connsiteX86" fmla="*/ 914400 w 1765300"/>
                    <a:gd name="connsiteY86" fmla="*/ 155575 h 590550"/>
                    <a:gd name="connsiteX87" fmla="*/ 927100 w 1765300"/>
                    <a:gd name="connsiteY87" fmla="*/ 180975 h 590550"/>
                    <a:gd name="connsiteX88" fmla="*/ 933450 w 1765300"/>
                    <a:gd name="connsiteY88" fmla="*/ 136525 h 590550"/>
                    <a:gd name="connsiteX89" fmla="*/ 946150 w 1765300"/>
                    <a:gd name="connsiteY89" fmla="*/ 190500 h 590550"/>
                    <a:gd name="connsiteX90" fmla="*/ 946150 w 1765300"/>
                    <a:gd name="connsiteY90" fmla="*/ 142875 h 590550"/>
                    <a:gd name="connsiteX91" fmla="*/ 952500 w 1765300"/>
                    <a:gd name="connsiteY91" fmla="*/ 288925 h 590550"/>
                    <a:gd name="connsiteX92" fmla="*/ 974725 w 1765300"/>
                    <a:gd name="connsiteY92" fmla="*/ 352425 h 590550"/>
                    <a:gd name="connsiteX93" fmla="*/ 974725 w 1765300"/>
                    <a:gd name="connsiteY93" fmla="*/ 352425 h 590550"/>
                    <a:gd name="connsiteX94" fmla="*/ 993775 w 1765300"/>
                    <a:gd name="connsiteY94" fmla="*/ 361950 h 590550"/>
                    <a:gd name="connsiteX95" fmla="*/ 1003300 w 1765300"/>
                    <a:gd name="connsiteY95" fmla="*/ 257175 h 590550"/>
                    <a:gd name="connsiteX96" fmla="*/ 1003300 w 1765300"/>
                    <a:gd name="connsiteY96" fmla="*/ 257175 h 590550"/>
                    <a:gd name="connsiteX97" fmla="*/ 1031875 w 1765300"/>
                    <a:gd name="connsiteY97" fmla="*/ 292100 h 590550"/>
                    <a:gd name="connsiteX98" fmla="*/ 1044575 w 1765300"/>
                    <a:gd name="connsiteY98" fmla="*/ 412750 h 590550"/>
                    <a:gd name="connsiteX99" fmla="*/ 1076325 w 1765300"/>
                    <a:gd name="connsiteY99" fmla="*/ 314325 h 590550"/>
                    <a:gd name="connsiteX100" fmla="*/ 1089025 w 1765300"/>
                    <a:gd name="connsiteY100" fmla="*/ 241300 h 590550"/>
                    <a:gd name="connsiteX101" fmla="*/ 1101725 w 1765300"/>
                    <a:gd name="connsiteY101" fmla="*/ 314325 h 590550"/>
                    <a:gd name="connsiteX102" fmla="*/ 1127125 w 1765300"/>
                    <a:gd name="connsiteY102" fmla="*/ 209550 h 590550"/>
                    <a:gd name="connsiteX103" fmla="*/ 1149350 w 1765300"/>
                    <a:gd name="connsiteY103" fmla="*/ 301625 h 590550"/>
                    <a:gd name="connsiteX104" fmla="*/ 1146175 w 1765300"/>
                    <a:gd name="connsiteY104" fmla="*/ 222250 h 590550"/>
                    <a:gd name="connsiteX105" fmla="*/ 1174750 w 1765300"/>
                    <a:gd name="connsiteY105" fmla="*/ 355600 h 590550"/>
                    <a:gd name="connsiteX106" fmla="*/ 1187450 w 1765300"/>
                    <a:gd name="connsiteY106" fmla="*/ 288925 h 590550"/>
                    <a:gd name="connsiteX107" fmla="*/ 1187450 w 1765300"/>
                    <a:gd name="connsiteY107" fmla="*/ 288925 h 590550"/>
                    <a:gd name="connsiteX108" fmla="*/ 1203325 w 1765300"/>
                    <a:gd name="connsiteY108" fmla="*/ 298450 h 590550"/>
                    <a:gd name="connsiteX109" fmla="*/ 1216025 w 1765300"/>
                    <a:gd name="connsiteY109" fmla="*/ 225425 h 590550"/>
                    <a:gd name="connsiteX110" fmla="*/ 1222375 w 1765300"/>
                    <a:gd name="connsiteY110" fmla="*/ 193675 h 590550"/>
                    <a:gd name="connsiteX111" fmla="*/ 1235075 w 1765300"/>
                    <a:gd name="connsiteY111" fmla="*/ 288925 h 590550"/>
                    <a:gd name="connsiteX112" fmla="*/ 1235075 w 1765300"/>
                    <a:gd name="connsiteY112" fmla="*/ 288925 h 590550"/>
                    <a:gd name="connsiteX113" fmla="*/ 1260475 w 1765300"/>
                    <a:gd name="connsiteY113" fmla="*/ 323850 h 590550"/>
                    <a:gd name="connsiteX114" fmla="*/ 1263650 w 1765300"/>
                    <a:gd name="connsiteY114" fmla="*/ 263525 h 590550"/>
                    <a:gd name="connsiteX115" fmla="*/ 1289050 w 1765300"/>
                    <a:gd name="connsiteY115" fmla="*/ 234950 h 590550"/>
                    <a:gd name="connsiteX116" fmla="*/ 1289050 w 1765300"/>
                    <a:gd name="connsiteY116" fmla="*/ 158750 h 590550"/>
                    <a:gd name="connsiteX117" fmla="*/ 1298575 w 1765300"/>
                    <a:gd name="connsiteY117" fmla="*/ 263525 h 590550"/>
                    <a:gd name="connsiteX118" fmla="*/ 1308100 w 1765300"/>
                    <a:gd name="connsiteY118" fmla="*/ 225425 h 590550"/>
                    <a:gd name="connsiteX119" fmla="*/ 1327150 w 1765300"/>
                    <a:gd name="connsiteY119" fmla="*/ 403225 h 590550"/>
                    <a:gd name="connsiteX120" fmla="*/ 1327150 w 1765300"/>
                    <a:gd name="connsiteY120" fmla="*/ 374650 h 590550"/>
                    <a:gd name="connsiteX121" fmla="*/ 1358900 w 1765300"/>
                    <a:gd name="connsiteY121" fmla="*/ 419100 h 590550"/>
                    <a:gd name="connsiteX122" fmla="*/ 1371600 w 1765300"/>
                    <a:gd name="connsiteY122" fmla="*/ 273050 h 590550"/>
                    <a:gd name="connsiteX123" fmla="*/ 1374775 w 1765300"/>
                    <a:gd name="connsiteY123" fmla="*/ 314325 h 590550"/>
                    <a:gd name="connsiteX124" fmla="*/ 1384300 w 1765300"/>
                    <a:gd name="connsiteY124" fmla="*/ 263525 h 590550"/>
                    <a:gd name="connsiteX125" fmla="*/ 1403350 w 1765300"/>
                    <a:gd name="connsiteY125" fmla="*/ 342900 h 590550"/>
                    <a:gd name="connsiteX126" fmla="*/ 1416050 w 1765300"/>
                    <a:gd name="connsiteY126" fmla="*/ 263525 h 590550"/>
                    <a:gd name="connsiteX127" fmla="*/ 1425575 w 1765300"/>
                    <a:gd name="connsiteY127" fmla="*/ 323850 h 590550"/>
                    <a:gd name="connsiteX128" fmla="*/ 1435100 w 1765300"/>
                    <a:gd name="connsiteY128" fmla="*/ 222250 h 590550"/>
                    <a:gd name="connsiteX129" fmla="*/ 1450975 w 1765300"/>
                    <a:gd name="connsiteY129" fmla="*/ 282575 h 590550"/>
                    <a:gd name="connsiteX130" fmla="*/ 1463675 w 1765300"/>
                    <a:gd name="connsiteY130" fmla="*/ 222250 h 590550"/>
                    <a:gd name="connsiteX131" fmla="*/ 1476375 w 1765300"/>
                    <a:gd name="connsiteY131" fmla="*/ 311150 h 590550"/>
                    <a:gd name="connsiteX132" fmla="*/ 1508125 w 1765300"/>
                    <a:gd name="connsiteY132" fmla="*/ 231775 h 590550"/>
                    <a:gd name="connsiteX133" fmla="*/ 1527175 w 1765300"/>
                    <a:gd name="connsiteY133" fmla="*/ 257175 h 590550"/>
                    <a:gd name="connsiteX134" fmla="*/ 1549400 w 1765300"/>
                    <a:gd name="connsiteY134" fmla="*/ 349250 h 590550"/>
                    <a:gd name="connsiteX135" fmla="*/ 1565275 w 1765300"/>
                    <a:gd name="connsiteY135" fmla="*/ 257175 h 590550"/>
                    <a:gd name="connsiteX136" fmla="*/ 1571625 w 1765300"/>
                    <a:gd name="connsiteY136" fmla="*/ 301625 h 590550"/>
                    <a:gd name="connsiteX137" fmla="*/ 1577975 w 1765300"/>
                    <a:gd name="connsiteY137" fmla="*/ 285750 h 590550"/>
                    <a:gd name="connsiteX138" fmla="*/ 1581150 w 1765300"/>
                    <a:gd name="connsiteY138" fmla="*/ 409575 h 590550"/>
                    <a:gd name="connsiteX139" fmla="*/ 1590675 w 1765300"/>
                    <a:gd name="connsiteY139" fmla="*/ 361950 h 590550"/>
                    <a:gd name="connsiteX140" fmla="*/ 1600200 w 1765300"/>
                    <a:gd name="connsiteY140" fmla="*/ 495300 h 590550"/>
                    <a:gd name="connsiteX141" fmla="*/ 1628775 w 1765300"/>
                    <a:gd name="connsiteY141" fmla="*/ 330200 h 590550"/>
                    <a:gd name="connsiteX142" fmla="*/ 1647825 w 1765300"/>
                    <a:gd name="connsiteY142" fmla="*/ 520700 h 590550"/>
                    <a:gd name="connsiteX143" fmla="*/ 1666875 w 1765300"/>
                    <a:gd name="connsiteY143" fmla="*/ 590550 h 590550"/>
                    <a:gd name="connsiteX144" fmla="*/ 1689100 w 1765300"/>
                    <a:gd name="connsiteY144" fmla="*/ 374650 h 590550"/>
                    <a:gd name="connsiteX145" fmla="*/ 1714500 w 1765300"/>
                    <a:gd name="connsiteY145" fmla="*/ 139700 h 590550"/>
                    <a:gd name="connsiteX146" fmla="*/ 1720850 w 1765300"/>
                    <a:gd name="connsiteY146" fmla="*/ 190500 h 590550"/>
                    <a:gd name="connsiteX147" fmla="*/ 1727200 w 1765300"/>
                    <a:gd name="connsiteY147" fmla="*/ 155575 h 590550"/>
                    <a:gd name="connsiteX148" fmla="*/ 1746250 w 1765300"/>
                    <a:gd name="connsiteY148" fmla="*/ 304800 h 590550"/>
                    <a:gd name="connsiteX149" fmla="*/ 1765300 w 1765300"/>
                    <a:gd name="connsiteY149" fmla="*/ 215900 h 59055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  <a:cxn ang="0">
                      <a:pos x="connsiteX38" y="connsiteY38"/>
                    </a:cxn>
                    <a:cxn ang="0">
                      <a:pos x="connsiteX39" y="connsiteY39"/>
                    </a:cxn>
                    <a:cxn ang="0">
                      <a:pos x="connsiteX40" y="connsiteY40"/>
                    </a:cxn>
                    <a:cxn ang="0">
                      <a:pos x="connsiteX41" y="connsiteY41"/>
                    </a:cxn>
                    <a:cxn ang="0">
                      <a:pos x="connsiteX42" y="connsiteY42"/>
                    </a:cxn>
                    <a:cxn ang="0">
                      <a:pos x="connsiteX43" y="connsiteY43"/>
                    </a:cxn>
                    <a:cxn ang="0">
                      <a:pos x="connsiteX44" y="connsiteY44"/>
                    </a:cxn>
                    <a:cxn ang="0">
                      <a:pos x="connsiteX45" y="connsiteY45"/>
                    </a:cxn>
                    <a:cxn ang="0">
                      <a:pos x="connsiteX46" y="connsiteY46"/>
                    </a:cxn>
                    <a:cxn ang="0">
                      <a:pos x="connsiteX47" y="connsiteY47"/>
                    </a:cxn>
                    <a:cxn ang="0">
                      <a:pos x="connsiteX48" y="connsiteY48"/>
                    </a:cxn>
                    <a:cxn ang="0">
                      <a:pos x="connsiteX49" y="connsiteY49"/>
                    </a:cxn>
                    <a:cxn ang="0">
                      <a:pos x="connsiteX50" y="connsiteY50"/>
                    </a:cxn>
                    <a:cxn ang="0">
                      <a:pos x="connsiteX51" y="connsiteY51"/>
                    </a:cxn>
                    <a:cxn ang="0">
                      <a:pos x="connsiteX52" y="connsiteY52"/>
                    </a:cxn>
                    <a:cxn ang="0">
                      <a:pos x="connsiteX53" y="connsiteY53"/>
                    </a:cxn>
                    <a:cxn ang="0">
                      <a:pos x="connsiteX54" y="connsiteY54"/>
                    </a:cxn>
                    <a:cxn ang="0">
                      <a:pos x="connsiteX55" y="connsiteY55"/>
                    </a:cxn>
                    <a:cxn ang="0">
                      <a:pos x="connsiteX56" y="connsiteY56"/>
                    </a:cxn>
                    <a:cxn ang="0">
                      <a:pos x="connsiteX57" y="connsiteY57"/>
                    </a:cxn>
                    <a:cxn ang="0">
                      <a:pos x="connsiteX58" y="connsiteY58"/>
                    </a:cxn>
                    <a:cxn ang="0">
                      <a:pos x="connsiteX59" y="connsiteY59"/>
                    </a:cxn>
                    <a:cxn ang="0">
                      <a:pos x="connsiteX60" y="connsiteY60"/>
                    </a:cxn>
                    <a:cxn ang="0">
                      <a:pos x="connsiteX61" y="connsiteY61"/>
                    </a:cxn>
                    <a:cxn ang="0">
                      <a:pos x="connsiteX62" y="connsiteY62"/>
                    </a:cxn>
                    <a:cxn ang="0">
                      <a:pos x="connsiteX63" y="connsiteY63"/>
                    </a:cxn>
                    <a:cxn ang="0">
                      <a:pos x="connsiteX64" y="connsiteY64"/>
                    </a:cxn>
                    <a:cxn ang="0">
                      <a:pos x="connsiteX65" y="connsiteY65"/>
                    </a:cxn>
                    <a:cxn ang="0">
                      <a:pos x="connsiteX66" y="connsiteY66"/>
                    </a:cxn>
                    <a:cxn ang="0">
                      <a:pos x="connsiteX67" y="connsiteY67"/>
                    </a:cxn>
                    <a:cxn ang="0">
                      <a:pos x="connsiteX68" y="connsiteY68"/>
                    </a:cxn>
                    <a:cxn ang="0">
                      <a:pos x="connsiteX69" y="connsiteY69"/>
                    </a:cxn>
                    <a:cxn ang="0">
                      <a:pos x="connsiteX70" y="connsiteY70"/>
                    </a:cxn>
                    <a:cxn ang="0">
                      <a:pos x="connsiteX71" y="connsiteY71"/>
                    </a:cxn>
                    <a:cxn ang="0">
                      <a:pos x="connsiteX72" y="connsiteY72"/>
                    </a:cxn>
                    <a:cxn ang="0">
                      <a:pos x="connsiteX73" y="connsiteY73"/>
                    </a:cxn>
                    <a:cxn ang="0">
                      <a:pos x="connsiteX74" y="connsiteY74"/>
                    </a:cxn>
                    <a:cxn ang="0">
                      <a:pos x="connsiteX75" y="connsiteY75"/>
                    </a:cxn>
                    <a:cxn ang="0">
                      <a:pos x="connsiteX76" y="connsiteY76"/>
                    </a:cxn>
                    <a:cxn ang="0">
                      <a:pos x="connsiteX77" y="connsiteY77"/>
                    </a:cxn>
                    <a:cxn ang="0">
                      <a:pos x="connsiteX78" y="connsiteY78"/>
                    </a:cxn>
                    <a:cxn ang="0">
                      <a:pos x="connsiteX79" y="connsiteY79"/>
                    </a:cxn>
                    <a:cxn ang="0">
                      <a:pos x="connsiteX80" y="connsiteY80"/>
                    </a:cxn>
                    <a:cxn ang="0">
                      <a:pos x="connsiteX81" y="connsiteY81"/>
                    </a:cxn>
                    <a:cxn ang="0">
                      <a:pos x="connsiteX82" y="connsiteY82"/>
                    </a:cxn>
                    <a:cxn ang="0">
                      <a:pos x="connsiteX83" y="connsiteY83"/>
                    </a:cxn>
                    <a:cxn ang="0">
                      <a:pos x="connsiteX84" y="connsiteY84"/>
                    </a:cxn>
                    <a:cxn ang="0">
                      <a:pos x="connsiteX85" y="connsiteY85"/>
                    </a:cxn>
                    <a:cxn ang="0">
                      <a:pos x="connsiteX86" y="connsiteY86"/>
                    </a:cxn>
                    <a:cxn ang="0">
                      <a:pos x="connsiteX87" y="connsiteY87"/>
                    </a:cxn>
                    <a:cxn ang="0">
                      <a:pos x="connsiteX88" y="connsiteY88"/>
                    </a:cxn>
                    <a:cxn ang="0">
                      <a:pos x="connsiteX89" y="connsiteY89"/>
                    </a:cxn>
                    <a:cxn ang="0">
                      <a:pos x="connsiteX90" y="connsiteY90"/>
                    </a:cxn>
                    <a:cxn ang="0">
                      <a:pos x="connsiteX91" y="connsiteY91"/>
                    </a:cxn>
                    <a:cxn ang="0">
                      <a:pos x="connsiteX92" y="connsiteY92"/>
                    </a:cxn>
                    <a:cxn ang="0">
                      <a:pos x="connsiteX93" y="connsiteY93"/>
                    </a:cxn>
                    <a:cxn ang="0">
                      <a:pos x="connsiteX94" y="connsiteY94"/>
                    </a:cxn>
                    <a:cxn ang="0">
                      <a:pos x="connsiteX95" y="connsiteY95"/>
                    </a:cxn>
                    <a:cxn ang="0">
                      <a:pos x="connsiteX96" y="connsiteY96"/>
                    </a:cxn>
                    <a:cxn ang="0">
                      <a:pos x="connsiteX97" y="connsiteY97"/>
                    </a:cxn>
                    <a:cxn ang="0">
                      <a:pos x="connsiteX98" y="connsiteY98"/>
                    </a:cxn>
                    <a:cxn ang="0">
                      <a:pos x="connsiteX99" y="connsiteY99"/>
                    </a:cxn>
                    <a:cxn ang="0">
                      <a:pos x="connsiteX100" y="connsiteY100"/>
                    </a:cxn>
                    <a:cxn ang="0">
                      <a:pos x="connsiteX101" y="connsiteY101"/>
                    </a:cxn>
                    <a:cxn ang="0">
                      <a:pos x="connsiteX102" y="connsiteY102"/>
                    </a:cxn>
                    <a:cxn ang="0">
                      <a:pos x="connsiteX103" y="connsiteY103"/>
                    </a:cxn>
                    <a:cxn ang="0">
                      <a:pos x="connsiteX104" y="connsiteY104"/>
                    </a:cxn>
                    <a:cxn ang="0">
                      <a:pos x="connsiteX105" y="connsiteY105"/>
                    </a:cxn>
                    <a:cxn ang="0">
                      <a:pos x="connsiteX106" y="connsiteY106"/>
                    </a:cxn>
                    <a:cxn ang="0">
                      <a:pos x="connsiteX107" y="connsiteY107"/>
                    </a:cxn>
                    <a:cxn ang="0">
                      <a:pos x="connsiteX108" y="connsiteY108"/>
                    </a:cxn>
                    <a:cxn ang="0">
                      <a:pos x="connsiteX109" y="connsiteY109"/>
                    </a:cxn>
                    <a:cxn ang="0">
                      <a:pos x="connsiteX110" y="connsiteY110"/>
                    </a:cxn>
                    <a:cxn ang="0">
                      <a:pos x="connsiteX111" y="connsiteY111"/>
                    </a:cxn>
                    <a:cxn ang="0">
                      <a:pos x="connsiteX112" y="connsiteY112"/>
                    </a:cxn>
                    <a:cxn ang="0">
                      <a:pos x="connsiteX113" y="connsiteY113"/>
                    </a:cxn>
                    <a:cxn ang="0">
                      <a:pos x="connsiteX114" y="connsiteY114"/>
                    </a:cxn>
                    <a:cxn ang="0">
                      <a:pos x="connsiteX115" y="connsiteY115"/>
                    </a:cxn>
                    <a:cxn ang="0">
                      <a:pos x="connsiteX116" y="connsiteY116"/>
                    </a:cxn>
                    <a:cxn ang="0">
                      <a:pos x="connsiteX117" y="connsiteY117"/>
                    </a:cxn>
                    <a:cxn ang="0">
                      <a:pos x="connsiteX118" y="connsiteY118"/>
                    </a:cxn>
                    <a:cxn ang="0">
                      <a:pos x="connsiteX119" y="connsiteY119"/>
                    </a:cxn>
                    <a:cxn ang="0">
                      <a:pos x="connsiteX120" y="connsiteY120"/>
                    </a:cxn>
                    <a:cxn ang="0">
                      <a:pos x="connsiteX121" y="connsiteY121"/>
                    </a:cxn>
                    <a:cxn ang="0">
                      <a:pos x="connsiteX122" y="connsiteY122"/>
                    </a:cxn>
                    <a:cxn ang="0">
                      <a:pos x="connsiteX123" y="connsiteY123"/>
                    </a:cxn>
                    <a:cxn ang="0">
                      <a:pos x="connsiteX124" y="connsiteY124"/>
                    </a:cxn>
                    <a:cxn ang="0">
                      <a:pos x="connsiteX125" y="connsiteY125"/>
                    </a:cxn>
                    <a:cxn ang="0">
                      <a:pos x="connsiteX126" y="connsiteY126"/>
                    </a:cxn>
                    <a:cxn ang="0">
                      <a:pos x="connsiteX127" y="connsiteY127"/>
                    </a:cxn>
                    <a:cxn ang="0">
                      <a:pos x="connsiteX128" y="connsiteY128"/>
                    </a:cxn>
                    <a:cxn ang="0">
                      <a:pos x="connsiteX129" y="connsiteY129"/>
                    </a:cxn>
                    <a:cxn ang="0">
                      <a:pos x="connsiteX130" y="connsiteY130"/>
                    </a:cxn>
                    <a:cxn ang="0">
                      <a:pos x="connsiteX131" y="connsiteY131"/>
                    </a:cxn>
                    <a:cxn ang="0">
                      <a:pos x="connsiteX132" y="connsiteY132"/>
                    </a:cxn>
                    <a:cxn ang="0">
                      <a:pos x="connsiteX133" y="connsiteY133"/>
                    </a:cxn>
                    <a:cxn ang="0">
                      <a:pos x="connsiteX134" y="connsiteY134"/>
                    </a:cxn>
                    <a:cxn ang="0">
                      <a:pos x="connsiteX135" y="connsiteY135"/>
                    </a:cxn>
                    <a:cxn ang="0">
                      <a:pos x="connsiteX136" y="connsiteY136"/>
                    </a:cxn>
                    <a:cxn ang="0">
                      <a:pos x="connsiteX137" y="connsiteY137"/>
                    </a:cxn>
                    <a:cxn ang="0">
                      <a:pos x="connsiteX138" y="connsiteY138"/>
                    </a:cxn>
                    <a:cxn ang="0">
                      <a:pos x="connsiteX139" y="connsiteY139"/>
                    </a:cxn>
                    <a:cxn ang="0">
                      <a:pos x="connsiteX140" y="connsiteY140"/>
                    </a:cxn>
                    <a:cxn ang="0">
                      <a:pos x="connsiteX141" y="connsiteY141"/>
                    </a:cxn>
                    <a:cxn ang="0">
                      <a:pos x="connsiteX142" y="connsiteY142"/>
                    </a:cxn>
                    <a:cxn ang="0">
                      <a:pos x="connsiteX143" y="connsiteY143"/>
                    </a:cxn>
                    <a:cxn ang="0">
                      <a:pos x="connsiteX144" y="connsiteY144"/>
                    </a:cxn>
                    <a:cxn ang="0">
                      <a:pos x="connsiteX145" y="connsiteY145"/>
                    </a:cxn>
                    <a:cxn ang="0">
                      <a:pos x="connsiteX146" y="connsiteY146"/>
                    </a:cxn>
                    <a:cxn ang="0">
                      <a:pos x="connsiteX147" y="connsiteY147"/>
                    </a:cxn>
                    <a:cxn ang="0">
                      <a:pos x="connsiteX148" y="connsiteY148"/>
                    </a:cxn>
                    <a:cxn ang="0">
                      <a:pos x="connsiteX149" y="connsiteY149"/>
                    </a:cxn>
                  </a:cxnLst>
                  <a:rect l="l" t="t" r="r" b="b"/>
                  <a:pathLst>
                    <a:path w="1765300" h="590550">
                      <a:moveTo>
                        <a:pt x="0" y="520700"/>
                      </a:moveTo>
                      <a:lnTo>
                        <a:pt x="12700" y="571500"/>
                      </a:lnTo>
                      <a:lnTo>
                        <a:pt x="47625" y="0"/>
                      </a:lnTo>
                      <a:lnTo>
                        <a:pt x="50800" y="41275"/>
                      </a:lnTo>
                      <a:lnTo>
                        <a:pt x="53975" y="98425"/>
                      </a:lnTo>
                      <a:lnTo>
                        <a:pt x="63500" y="101600"/>
                      </a:lnTo>
                      <a:lnTo>
                        <a:pt x="92075" y="304800"/>
                      </a:lnTo>
                      <a:lnTo>
                        <a:pt x="88900" y="247650"/>
                      </a:lnTo>
                      <a:lnTo>
                        <a:pt x="95250" y="250825"/>
                      </a:lnTo>
                      <a:lnTo>
                        <a:pt x="101600" y="203200"/>
                      </a:lnTo>
                      <a:lnTo>
                        <a:pt x="101600" y="203200"/>
                      </a:lnTo>
                      <a:lnTo>
                        <a:pt x="117475" y="257175"/>
                      </a:lnTo>
                      <a:lnTo>
                        <a:pt x="123825" y="222250"/>
                      </a:lnTo>
                      <a:lnTo>
                        <a:pt x="136525" y="225425"/>
                      </a:lnTo>
                      <a:lnTo>
                        <a:pt x="146050" y="276225"/>
                      </a:lnTo>
                      <a:lnTo>
                        <a:pt x="146050" y="304800"/>
                      </a:lnTo>
                      <a:lnTo>
                        <a:pt x="165100" y="215900"/>
                      </a:lnTo>
                      <a:lnTo>
                        <a:pt x="177800" y="263525"/>
                      </a:lnTo>
                      <a:lnTo>
                        <a:pt x="177800" y="263525"/>
                      </a:lnTo>
                      <a:lnTo>
                        <a:pt x="196850" y="127000"/>
                      </a:lnTo>
                      <a:lnTo>
                        <a:pt x="209550" y="117475"/>
                      </a:lnTo>
                      <a:lnTo>
                        <a:pt x="215900" y="41275"/>
                      </a:lnTo>
                      <a:lnTo>
                        <a:pt x="222250" y="101600"/>
                      </a:lnTo>
                      <a:lnTo>
                        <a:pt x="228600" y="161925"/>
                      </a:lnTo>
                      <a:lnTo>
                        <a:pt x="234950" y="200025"/>
                      </a:lnTo>
                      <a:lnTo>
                        <a:pt x="247650" y="139700"/>
                      </a:lnTo>
                      <a:lnTo>
                        <a:pt x="257175" y="193675"/>
                      </a:lnTo>
                      <a:lnTo>
                        <a:pt x="269875" y="155575"/>
                      </a:lnTo>
                      <a:lnTo>
                        <a:pt x="301625" y="368300"/>
                      </a:lnTo>
                      <a:lnTo>
                        <a:pt x="317500" y="206375"/>
                      </a:lnTo>
                      <a:lnTo>
                        <a:pt x="336550" y="133350"/>
                      </a:lnTo>
                      <a:lnTo>
                        <a:pt x="346075" y="123825"/>
                      </a:lnTo>
                      <a:lnTo>
                        <a:pt x="368300" y="209550"/>
                      </a:lnTo>
                      <a:lnTo>
                        <a:pt x="374650" y="241300"/>
                      </a:lnTo>
                      <a:lnTo>
                        <a:pt x="390525" y="349250"/>
                      </a:lnTo>
                      <a:lnTo>
                        <a:pt x="406400" y="276225"/>
                      </a:lnTo>
                      <a:lnTo>
                        <a:pt x="412750" y="320675"/>
                      </a:lnTo>
                      <a:lnTo>
                        <a:pt x="434975" y="228600"/>
                      </a:lnTo>
                      <a:lnTo>
                        <a:pt x="441325" y="285750"/>
                      </a:lnTo>
                      <a:lnTo>
                        <a:pt x="466725" y="107950"/>
                      </a:lnTo>
                      <a:lnTo>
                        <a:pt x="469900" y="168275"/>
                      </a:lnTo>
                      <a:lnTo>
                        <a:pt x="476250" y="123825"/>
                      </a:lnTo>
                      <a:lnTo>
                        <a:pt x="482600" y="152400"/>
                      </a:lnTo>
                      <a:lnTo>
                        <a:pt x="482600" y="152400"/>
                      </a:lnTo>
                      <a:lnTo>
                        <a:pt x="498475" y="177800"/>
                      </a:lnTo>
                      <a:lnTo>
                        <a:pt x="498475" y="177800"/>
                      </a:lnTo>
                      <a:lnTo>
                        <a:pt x="520700" y="196850"/>
                      </a:lnTo>
                      <a:lnTo>
                        <a:pt x="536575" y="133350"/>
                      </a:lnTo>
                      <a:lnTo>
                        <a:pt x="549275" y="149225"/>
                      </a:lnTo>
                      <a:lnTo>
                        <a:pt x="549275" y="98425"/>
                      </a:lnTo>
                      <a:lnTo>
                        <a:pt x="561975" y="142875"/>
                      </a:lnTo>
                      <a:lnTo>
                        <a:pt x="581025" y="120650"/>
                      </a:lnTo>
                      <a:lnTo>
                        <a:pt x="587375" y="203200"/>
                      </a:lnTo>
                      <a:lnTo>
                        <a:pt x="596900" y="165100"/>
                      </a:lnTo>
                      <a:lnTo>
                        <a:pt x="596900" y="165100"/>
                      </a:lnTo>
                      <a:lnTo>
                        <a:pt x="612775" y="184150"/>
                      </a:lnTo>
                      <a:lnTo>
                        <a:pt x="622300" y="279400"/>
                      </a:lnTo>
                      <a:lnTo>
                        <a:pt x="631825" y="247650"/>
                      </a:lnTo>
                      <a:lnTo>
                        <a:pt x="641350" y="215900"/>
                      </a:lnTo>
                      <a:lnTo>
                        <a:pt x="644525" y="247650"/>
                      </a:lnTo>
                      <a:lnTo>
                        <a:pt x="654050" y="285750"/>
                      </a:lnTo>
                      <a:lnTo>
                        <a:pt x="657225" y="222250"/>
                      </a:lnTo>
                      <a:lnTo>
                        <a:pt x="666750" y="285750"/>
                      </a:lnTo>
                      <a:lnTo>
                        <a:pt x="679450" y="269875"/>
                      </a:lnTo>
                      <a:lnTo>
                        <a:pt x="685800" y="317500"/>
                      </a:lnTo>
                      <a:lnTo>
                        <a:pt x="692150" y="203200"/>
                      </a:lnTo>
                      <a:lnTo>
                        <a:pt x="701675" y="266700"/>
                      </a:lnTo>
                      <a:lnTo>
                        <a:pt x="717550" y="358775"/>
                      </a:lnTo>
                      <a:lnTo>
                        <a:pt x="717550" y="295275"/>
                      </a:lnTo>
                      <a:lnTo>
                        <a:pt x="739775" y="454025"/>
                      </a:lnTo>
                      <a:lnTo>
                        <a:pt x="742950" y="390525"/>
                      </a:lnTo>
                      <a:lnTo>
                        <a:pt x="749300" y="279400"/>
                      </a:lnTo>
                      <a:lnTo>
                        <a:pt x="755650" y="314325"/>
                      </a:lnTo>
                      <a:lnTo>
                        <a:pt x="765175" y="219075"/>
                      </a:lnTo>
                      <a:lnTo>
                        <a:pt x="771525" y="203200"/>
                      </a:lnTo>
                      <a:lnTo>
                        <a:pt x="777875" y="231775"/>
                      </a:lnTo>
                      <a:lnTo>
                        <a:pt x="784225" y="184150"/>
                      </a:lnTo>
                      <a:lnTo>
                        <a:pt x="793750" y="247650"/>
                      </a:lnTo>
                      <a:lnTo>
                        <a:pt x="803275" y="273050"/>
                      </a:lnTo>
                      <a:lnTo>
                        <a:pt x="828675" y="434975"/>
                      </a:lnTo>
                      <a:lnTo>
                        <a:pt x="841375" y="346075"/>
                      </a:lnTo>
                      <a:lnTo>
                        <a:pt x="854075" y="384175"/>
                      </a:lnTo>
                      <a:lnTo>
                        <a:pt x="857250" y="311150"/>
                      </a:lnTo>
                      <a:lnTo>
                        <a:pt x="882650" y="384175"/>
                      </a:lnTo>
                      <a:lnTo>
                        <a:pt x="898525" y="263525"/>
                      </a:lnTo>
                      <a:lnTo>
                        <a:pt x="898525" y="263525"/>
                      </a:lnTo>
                      <a:lnTo>
                        <a:pt x="914400" y="155575"/>
                      </a:lnTo>
                      <a:lnTo>
                        <a:pt x="927100" y="180975"/>
                      </a:lnTo>
                      <a:lnTo>
                        <a:pt x="933450" y="136525"/>
                      </a:lnTo>
                      <a:lnTo>
                        <a:pt x="946150" y="190500"/>
                      </a:lnTo>
                      <a:lnTo>
                        <a:pt x="946150" y="142875"/>
                      </a:lnTo>
                      <a:lnTo>
                        <a:pt x="952500" y="288925"/>
                      </a:lnTo>
                      <a:lnTo>
                        <a:pt x="974725" y="352425"/>
                      </a:lnTo>
                      <a:lnTo>
                        <a:pt x="974725" y="352425"/>
                      </a:lnTo>
                      <a:lnTo>
                        <a:pt x="993775" y="361950"/>
                      </a:lnTo>
                      <a:lnTo>
                        <a:pt x="1003300" y="257175"/>
                      </a:lnTo>
                      <a:lnTo>
                        <a:pt x="1003300" y="257175"/>
                      </a:lnTo>
                      <a:lnTo>
                        <a:pt x="1031875" y="292100"/>
                      </a:lnTo>
                      <a:lnTo>
                        <a:pt x="1044575" y="412750"/>
                      </a:lnTo>
                      <a:lnTo>
                        <a:pt x="1076325" y="314325"/>
                      </a:lnTo>
                      <a:lnTo>
                        <a:pt x="1089025" y="241300"/>
                      </a:lnTo>
                      <a:lnTo>
                        <a:pt x="1101725" y="314325"/>
                      </a:lnTo>
                      <a:lnTo>
                        <a:pt x="1127125" y="209550"/>
                      </a:lnTo>
                      <a:lnTo>
                        <a:pt x="1149350" y="301625"/>
                      </a:lnTo>
                      <a:lnTo>
                        <a:pt x="1146175" y="222250"/>
                      </a:lnTo>
                      <a:lnTo>
                        <a:pt x="1174750" y="355600"/>
                      </a:lnTo>
                      <a:lnTo>
                        <a:pt x="1187450" y="288925"/>
                      </a:lnTo>
                      <a:lnTo>
                        <a:pt x="1187450" y="288925"/>
                      </a:lnTo>
                      <a:lnTo>
                        <a:pt x="1203325" y="298450"/>
                      </a:lnTo>
                      <a:lnTo>
                        <a:pt x="1216025" y="225425"/>
                      </a:lnTo>
                      <a:lnTo>
                        <a:pt x="1222375" y="193675"/>
                      </a:lnTo>
                      <a:lnTo>
                        <a:pt x="1235075" y="288925"/>
                      </a:lnTo>
                      <a:lnTo>
                        <a:pt x="1235075" y="288925"/>
                      </a:lnTo>
                      <a:lnTo>
                        <a:pt x="1260475" y="323850"/>
                      </a:lnTo>
                      <a:lnTo>
                        <a:pt x="1263650" y="263525"/>
                      </a:lnTo>
                      <a:lnTo>
                        <a:pt x="1289050" y="234950"/>
                      </a:lnTo>
                      <a:lnTo>
                        <a:pt x="1289050" y="158750"/>
                      </a:lnTo>
                      <a:lnTo>
                        <a:pt x="1298575" y="263525"/>
                      </a:lnTo>
                      <a:lnTo>
                        <a:pt x="1308100" y="225425"/>
                      </a:lnTo>
                      <a:lnTo>
                        <a:pt x="1327150" y="403225"/>
                      </a:lnTo>
                      <a:lnTo>
                        <a:pt x="1327150" y="374650"/>
                      </a:lnTo>
                      <a:lnTo>
                        <a:pt x="1358900" y="419100"/>
                      </a:lnTo>
                      <a:lnTo>
                        <a:pt x="1371600" y="273050"/>
                      </a:lnTo>
                      <a:lnTo>
                        <a:pt x="1374775" y="314325"/>
                      </a:lnTo>
                      <a:lnTo>
                        <a:pt x="1384300" y="263525"/>
                      </a:lnTo>
                      <a:lnTo>
                        <a:pt x="1403350" y="342900"/>
                      </a:lnTo>
                      <a:lnTo>
                        <a:pt x="1416050" y="263525"/>
                      </a:lnTo>
                      <a:lnTo>
                        <a:pt x="1425575" y="323850"/>
                      </a:lnTo>
                      <a:lnTo>
                        <a:pt x="1435100" y="222250"/>
                      </a:lnTo>
                      <a:lnTo>
                        <a:pt x="1450975" y="282575"/>
                      </a:lnTo>
                      <a:lnTo>
                        <a:pt x="1463675" y="222250"/>
                      </a:lnTo>
                      <a:lnTo>
                        <a:pt x="1476375" y="311150"/>
                      </a:lnTo>
                      <a:lnTo>
                        <a:pt x="1508125" y="231775"/>
                      </a:lnTo>
                      <a:lnTo>
                        <a:pt x="1527175" y="257175"/>
                      </a:lnTo>
                      <a:lnTo>
                        <a:pt x="1549400" y="349250"/>
                      </a:lnTo>
                      <a:lnTo>
                        <a:pt x="1565275" y="257175"/>
                      </a:lnTo>
                      <a:lnTo>
                        <a:pt x="1571625" y="301625"/>
                      </a:lnTo>
                      <a:lnTo>
                        <a:pt x="1577975" y="285750"/>
                      </a:lnTo>
                      <a:cubicBezTo>
                        <a:pt x="1579033" y="327025"/>
                        <a:pt x="1580092" y="368300"/>
                        <a:pt x="1581150" y="409575"/>
                      </a:cubicBezTo>
                      <a:lnTo>
                        <a:pt x="1590675" y="361950"/>
                      </a:lnTo>
                      <a:lnTo>
                        <a:pt x="1600200" y="495300"/>
                      </a:lnTo>
                      <a:lnTo>
                        <a:pt x="1628775" y="330200"/>
                      </a:lnTo>
                      <a:lnTo>
                        <a:pt x="1647825" y="520700"/>
                      </a:lnTo>
                      <a:lnTo>
                        <a:pt x="1666875" y="590550"/>
                      </a:lnTo>
                      <a:lnTo>
                        <a:pt x="1689100" y="374650"/>
                      </a:lnTo>
                      <a:lnTo>
                        <a:pt x="1714500" y="139700"/>
                      </a:lnTo>
                      <a:lnTo>
                        <a:pt x="1720850" y="190500"/>
                      </a:lnTo>
                      <a:lnTo>
                        <a:pt x="1727200" y="155575"/>
                      </a:lnTo>
                      <a:lnTo>
                        <a:pt x="1746250" y="304800"/>
                      </a:lnTo>
                      <a:lnTo>
                        <a:pt x="1765300" y="215900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" name="Freeform 3">
                  <a:extLst>
                    <a:ext uri="{FF2B5EF4-FFF2-40B4-BE49-F238E27FC236}">
                      <a16:creationId xmlns:a16="http://schemas.microsoft.com/office/drawing/2014/main" id="{6C2757BA-4656-0643-8936-1527376C2DEE}"/>
                    </a:ext>
                  </a:extLst>
                </p:cNvPr>
                <p:cNvSpPr/>
                <p:nvPr/>
              </p:nvSpPr>
              <p:spPr>
                <a:xfrm>
                  <a:off x="4829176" y="1365250"/>
                  <a:ext cx="196850" cy="193675"/>
                </a:xfrm>
                <a:custGeom>
                  <a:avLst/>
                  <a:gdLst>
                    <a:gd name="connsiteX0" fmla="*/ 180975 w 180975"/>
                    <a:gd name="connsiteY0" fmla="*/ 193675 h 193675"/>
                    <a:gd name="connsiteX1" fmla="*/ 158750 w 180975"/>
                    <a:gd name="connsiteY1" fmla="*/ 171450 h 193675"/>
                    <a:gd name="connsiteX2" fmla="*/ 149225 w 180975"/>
                    <a:gd name="connsiteY2" fmla="*/ 15875 h 193675"/>
                    <a:gd name="connsiteX3" fmla="*/ 139700 w 180975"/>
                    <a:gd name="connsiteY3" fmla="*/ 114300 h 193675"/>
                    <a:gd name="connsiteX4" fmla="*/ 130175 w 180975"/>
                    <a:gd name="connsiteY4" fmla="*/ 82550 h 193675"/>
                    <a:gd name="connsiteX5" fmla="*/ 104775 w 180975"/>
                    <a:gd name="connsiteY5" fmla="*/ 184150 h 193675"/>
                    <a:gd name="connsiteX6" fmla="*/ 88900 w 180975"/>
                    <a:gd name="connsiteY6" fmla="*/ 104775 h 193675"/>
                    <a:gd name="connsiteX7" fmla="*/ 60325 w 180975"/>
                    <a:gd name="connsiteY7" fmla="*/ 0 h 193675"/>
                    <a:gd name="connsiteX8" fmla="*/ 53975 w 180975"/>
                    <a:gd name="connsiteY8" fmla="*/ 50800 h 193675"/>
                    <a:gd name="connsiteX9" fmla="*/ 41275 w 180975"/>
                    <a:gd name="connsiteY9" fmla="*/ 6350 h 193675"/>
                    <a:gd name="connsiteX10" fmla="*/ 25400 w 180975"/>
                    <a:gd name="connsiteY10" fmla="*/ 117475 h 193675"/>
                    <a:gd name="connsiteX11" fmla="*/ 9525 w 180975"/>
                    <a:gd name="connsiteY11" fmla="*/ 69850 h 193675"/>
                    <a:gd name="connsiteX12" fmla="*/ 0 w 180975"/>
                    <a:gd name="connsiteY12" fmla="*/ 73025 h 193675"/>
                    <a:gd name="connsiteX13" fmla="*/ 0 w 180975"/>
                    <a:gd name="connsiteY13" fmla="*/ 73025 h 193675"/>
                    <a:gd name="connsiteX14" fmla="*/ 0 w 180975"/>
                    <a:gd name="connsiteY14" fmla="*/ 73025 h 19367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</a:cxnLst>
                  <a:rect l="l" t="t" r="r" b="b"/>
                  <a:pathLst>
                    <a:path w="180975" h="193675">
                      <a:moveTo>
                        <a:pt x="180975" y="193675"/>
                      </a:moveTo>
                      <a:lnTo>
                        <a:pt x="158750" y="171450"/>
                      </a:lnTo>
                      <a:lnTo>
                        <a:pt x="149225" y="15875"/>
                      </a:lnTo>
                      <a:lnTo>
                        <a:pt x="139700" y="114300"/>
                      </a:lnTo>
                      <a:lnTo>
                        <a:pt x="130175" y="82550"/>
                      </a:lnTo>
                      <a:lnTo>
                        <a:pt x="104775" y="184150"/>
                      </a:lnTo>
                      <a:lnTo>
                        <a:pt x="88900" y="104775"/>
                      </a:lnTo>
                      <a:lnTo>
                        <a:pt x="60325" y="0"/>
                      </a:lnTo>
                      <a:lnTo>
                        <a:pt x="53975" y="50800"/>
                      </a:lnTo>
                      <a:lnTo>
                        <a:pt x="41275" y="6350"/>
                      </a:lnTo>
                      <a:lnTo>
                        <a:pt x="25400" y="117475"/>
                      </a:lnTo>
                      <a:lnTo>
                        <a:pt x="9525" y="69850"/>
                      </a:lnTo>
                      <a:lnTo>
                        <a:pt x="0" y="73025"/>
                      </a:lnTo>
                      <a:lnTo>
                        <a:pt x="0" y="73025"/>
                      </a:lnTo>
                      <a:lnTo>
                        <a:pt x="0" y="73025"/>
                      </a:lnTo>
                    </a:path>
                  </a:pathLst>
                </a:custGeom>
                <a:noFill/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27" name="Rectangle 126">
                <a:extLst>
                  <a:ext uri="{FF2B5EF4-FFF2-40B4-BE49-F238E27FC236}">
                    <a16:creationId xmlns:a16="http://schemas.microsoft.com/office/drawing/2014/main" id="{DDED0F45-F19A-2A4A-8FFA-9299DE623888}"/>
                  </a:ext>
                </a:extLst>
              </p:cNvPr>
              <p:cNvSpPr/>
              <p:nvPr/>
            </p:nvSpPr>
            <p:spPr>
              <a:xfrm>
                <a:off x="4270703" y="6052977"/>
                <a:ext cx="45719" cy="168275"/>
              </a:xfrm>
              <a:prstGeom prst="rect">
                <a:avLst/>
              </a:prstGeom>
              <a:solidFill>
                <a:schemeClr val="bg1"/>
              </a:solidFill>
              <a:ln w="317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8A7C6899-1F05-204C-B8C3-74CDDB6BC037}"/>
                  </a:ext>
                </a:extLst>
              </p:cNvPr>
              <p:cNvSpPr txBox="1"/>
              <p:nvPr/>
            </p:nvSpPr>
            <p:spPr>
              <a:xfrm>
                <a:off x="2676424" y="6443746"/>
                <a:ext cx="33374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5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apE</a:t>
                </a:r>
                <a:endParaRPr lang="en-GB" sz="5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C920DFA3-2D70-634B-8156-B2EBA1DCC06F}"/>
                  </a:ext>
                </a:extLst>
              </p:cNvPr>
              <p:cNvSpPr txBox="1"/>
              <p:nvPr/>
            </p:nvSpPr>
            <p:spPr>
              <a:xfrm>
                <a:off x="3388829" y="6443746"/>
                <a:ext cx="38183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5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orphan</a:t>
                </a: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50AEF3BF-8AC6-D74B-A660-32DEB84B9CD6}"/>
                  </a:ext>
                </a:extLst>
              </p:cNvPr>
              <p:cNvSpPr txBox="1"/>
              <p:nvPr/>
            </p:nvSpPr>
            <p:spPr>
              <a:xfrm>
                <a:off x="4248180" y="5517286"/>
                <a:ext cx="242374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75</a:t>
                </a:r>
              </a:p>
            </p:txBody>
          </p:sp>
          <p:sp>
            <p:nvSpPr>
              <p:cNvPr id="113" name="TextBox 112">
                <a:extLst>
                  <a:ext uri="{FF2B5EF4-FFF2-40B4-BE49-F238E27FC236}">
                    <a16:creationId xmlns:a16="http://schemas.microsoft.com/office/drawing/2014/main" id="{AD9061F4-7F44-BE40-B8E0-0426BE747E6B}"/>
                  </a:ext>
                </a:extLst>
              </p:cNvPr>
              <p:cNvSpPr txBox="1"/>
              <p:nvPr/>
            </p:nvSpPr>
            <p:spPr>
              <a:xfrm>
                <a:off x="4248180" y="5993445"/>
                <a:ext cx="242374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61</a:t>
                </a:r>
              </a:p>
            </p:txBody>
          </p:sp>
          <p:sp>
            <p:nvSpPr>
              <p:cNvPr id="26" name="Rectangle 25">
                <a:extLst>
                  <a:ext uri="{FF2B5EF4-FFF2-40B4-BE49-F238E27FC236}">
                    <a16:creationId xmlns:a16="http://schemas.microsoft.com/office/drawing/2014/main" id="{15005DD3-D1B7-DD45-9D33-D9D25F9A8813}"/>
                  </a:ext>
                </a:extLst>
              </p:cNvPr>
              <p:cNvSpPr/>
              <p:nvPr/>
            </p:nvSpPr>
            <p:spPr>
              <a:xfrm>
                <a:off x="3125797" y="6587823"/>
                <a:ext cx="850899" cy="71719"/>
              </a:xfrm>
              <a:prstGeom prst="rect">
                <a:avLst/>
              </a:prstGeom>
              <a:solidFill>
                <a:schemeClr val="accent5"/>
              </a:solidFill>
              <a:ln w="3175">
                <a:solidFill>
                  <a:schemeClr val="accent5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Rectangle 26">
                <a:extLst>
                  <a:ext uri="{FF2B5EF4-FFF2-40B4-BE49-F238E27FC236}">
                    <a16:creationId xmlns:a16="http://schemas.microsoft.com/office/drawing/2014/main" id="{FE6F80A3-E587-9048-AC21-4D2049C1EBD9}"/>
                  </a:ext>
                </a:extLst>
              </p:cNvPr>
              <p:cNvSpPr/>
              <p:nvPr/>
            </p:nvSpPr>
            <p:spPr>
              <a:xfrm>
                <a:off x="2681297" y="6587823"/>
                <a:ext cx="311149" cy="71719"/>
              </a:xfrm>
              <a:prstGeom prst="rect">
                <a:avLst/>
              </a:prstGeom>
              <a:solidFill>
                <a:schemeClr val="accent4"/>
              </a:solidFill>
              <a:ln w="3175">
                <a:solidFill>
                  <a:schemeClr val="accent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Rectangle 27">
                <a:extLst>
                  <a:ext uri="{FF2B5EF4-FFF2-40B4-BE49-F238E27FC236}">
                    <a16:creationId xmlns:a16="http://schemas.microsoft.com/office/drawing/2014/main" id="{788B5E6B-C436-6043-8B9F-D7C090776862}"/>
                  </a:ext>
                </a:extLst>
              </p:cNvPr>
              <p:cNvSpPr/>
              <p:nvPr/>
            </p:nvSpPr>
            <p:spPr>
              <a:xfrm>
                <a:off x="2398721" y="6587823"/>
                <a:ext cx="209549" cy="71719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3175">
                <a:solidFill>
                  <a:schemeClr val="bg1">
                    <a:lumMod val="6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Rectangle 28">
                <a:extLst>
                  <a:ext uri="{FF2B5EF4-FFF2-40B4-BE49-F238E27FC236}">
                    <a16:creationId xmlns:a16="http://schemas.microsoft.com/office/drawing/2014/main" id="{E584B9E3-1508-BA47-BEB9-A0C3AAA9CAA1}"/>
                  </a:ext>
                </a:extLst>
              </p:cNvPr>
              <p:cNvSpPr/>
              <p:nvPr/>
            </p:nvSpPr>
            <p:spPr>
              <a:xfrm>
                <a:off x="3989397" y="6587823"/>
                <a:ext cx="206375" cy="71719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3175">
                <a:solidFill>
                  <a:schemeClr val="bg1">
                    <a:lumMod val="6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3" name="Triangle 132">
                <a:extLst>
                  <a:ext uri="{FF2B5EF4-FFF2-40B4-BE49-F238E27FC236}">
                    <a16:creationId xmlns:a16="http://schemas.microsoft.com/office/drawing/2014/main" id="{FBD80473-D3AC-4044-90B2-E9DE9A988B40}"/>
                  </a:ext>
                </a:extLst>
              </p:cNvPr>
              <p:cNvSpPr/>
              <p:nvPr/>
            </p:nvSpPr>
            <p:spPr>
              <a:xfrm rot="5400000">
                <a:off x="4165605" y="6587682"/>
                <a:ext cx="128588" cy="72000"/>
              </a:xfrm>
              <a:prstGeom prst="triangle">
                <a:avLst/>
              </a:prstGeom>
              <a:solidFill>
                <a:schemeClr val="bg1">
                  <a:lumMod val="65000"/>
                </a:schemeClr>
              </a:solidFill>
              <a:ln w="3175">
                <a:solidFill>
                  <a:schemeClr val="bg1">
                    <a:lumMod val="6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4" name="Triangle 133">
                <a:extLst>
                  <a:ext uri="{FF2B5EF4-FFF2-40B4-BE49-F238E27FC236}">
                    <a16:creationId xmlns:a16="http://schemas.microsoft.com/office/drawing/2014/main" id="{3A2FD97F-D600-9346-BC3E-6FCB6347CD18}"/>
                  </a:ext>
                </a:extLst>
              </p:cNvPr>
              <p:cNvSpPr/>
              <p:nvPr/>
            </p:nvSpPr>
            <p:spPr>
              <a:xfrm rot="16200000">
                <a:off x="3025780" y="6587683"/>
                <a:ext cx="128588" cy="72000"/>
              </a:xfrm>
              <a:prstGeom prst="triangle">
                <a:avLst/>
              </a:prstGeom>
              <a:solidFill>
                <a:schemeClr val="accent5"/>
              </a:solidFill>
              <a:ln w="3175">
                <a:solidFill>
                  <a:schemeClr val="accent5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6" name="Triangle 135">
                <a:extLst>
                  <a:ext uri="{FF2B5EF4-FFF2-40B4-BE49-F238E27FC236}">
                    <a16:creationId xmlns:a16="http://schemas.microsoft.com/office/drawing/2014/main" id="{7D22F230-3B9A-B141-A7E2-BFD6BE6E6BF7}"/>
                  </a:ext>
                </a:extLst>
              </p:cNvPr>
              <p:cNvSpPr/>
              <p:nvPr/>
            </p:nvSpPr>
            <p:spPr>
              <a:xfrm rot="16200000">
                <a:off x="2584455" y="6587683"/>
                <a:ext cx="128588" cy="72000"/>
              </a:xfrm>
              <a:prstGeom prst="triangle">
                <a:avLst/>
              </a:prstGeom>
              <a:solidFill>
                <a:schemeClr val="accent4"/>
              </a:solidFill>
              <a:ln w="3175">
                <a:solidFill>
                  <a:schemeClr val="accent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7" name="Triangle 136">
                <a:extLst>
                  <a:ext uri="{FF2B5EF4-FFF2-40B4-BE49-F238E27FC236}">
                    <a16:creationId xmlns:a16="http://schemas.microsoft.com/office/drawing/2014/main" id="{A49047A3-8281-F74E-BF79-BB50466D2B7F}"/>
                  </a:ext>
                </a:extLst>
              </p:cNvPr>
              <p:cNvSpPr/>
              <p:nvPr/>
            </p:nvSpPr>
            <p:spPr>
              <a:xfrm rot="16200000">
                <a:off x="2298705" y="6587683"/>
                <a:ext cx="128588" cy="72000"/>
              </a:xfrm>
              <a:prstGeom prst="triangle">
                <a:avLst/>
              </a:prstGeom>
              <a:solidFill>
                <a:schemeClr val="bg1">
                  <a:lumMod val="65000"/>
                </a:schemeClr>
              </a:solidFill>
              <a:ln w="3175">
                <a:solidFill>
                  <a:schemeClr val="bg1">
                    <a:lumMod val="6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7" name="Rectangle 106">
                <a:extLst>
                  <a:ext uri="{FF2B5EF4-FFF2-40B4-BE49-F238E27FC236}">
                    <a16:creationId xmlns:a16="http://schemas.microsoft.com/office/drawing/2014/main" id="{DD1334CE-53BB-4247-AEEF-62B320944427}"/>
                  </a:ext>
                </a:extLst>
              </p:cNvPr>
              <p:cNvSpPr/>
              <p:nvPr/>
            </p:nvSpPr>
            <p:spPr>
              <a:xfrm>
                <a:off x="2324007" y="5591276"/>
                <a:ext cx="1946393" cy="1134319"/>
              </a:xfrm>
              <a:prstGeom prst="rect">
                <a:avLst/>
              </a:prstGeom>
              <a:noFill/>
              <a:ln w="6350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19" name="Straight Connector 118">
                <a:extLst>
                  <a:ext uri="{FF2B5EF4-FFF2-40B4-BE49-F238E27FC236}">
                    <a16:creationId xmlns:a16="http://schemas.microsoft.com/office/drawing/2014/main" id="{53FA16E0-FFA7-D846-BB75-69DFFEA3730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71972" y="6724548"/>
                <a:ext cx="36000" cy="0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86C6A13A-BE61-8844-AB00-54B942E78C4C}"/>
                  </a:ext>
                </a:extLst>
              </p:cNvPr>
              <p:cNvSpPr txBox="1"/>
              <p:nvPr/>
            </p:nvSpPr>
            <p:spPr>
              <a:xfrm>
                <a:off x="4248180" y="6648710"/>
                <a:ext cx="242374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</a:p>
            </p:txBody>
          </p:sp>
        </p:grpSp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6794C35B-77AF-6145-A011-2D41C53E3F1C}"/>
                </a:ext>
              </a:extLst>
            </p:cNvPr>
            <p:cNvGrpSpPr/>
            <p:nvPr/>
          </p:nvGrpSpPr>
          <p:grpSpPr>
            <a:xfrm>
              <a:off x="2233839" y="4782807"/>
              <a:ext cx="2256715" cy="1287823"/>
              <a:chOff x="2233839" y="4301173"/>
              <a:chExt cx="2256715" cy="1287823"/>
            </a:xfrm>
          </p:grpSpPr>
          <p:cxnSp>
            <p:nvCxnSpPr>
              <p:cNvPr id="120" name="Straight Connector 119">
                <a:extLst>
                  <a:ext uri="{FF2B5EF4-FFF2-40B4-BE49-F238E27FC236}">
                    <a16:creationId xmlns:a16="http://schemas.microsoft.com/office/drawing/2014/main" id="{21E4449D-B78E-0940-B8EF-74C1EB06C64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71972" y="4379139"/>
                <a:ext cx="36000" cy="0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1" name="Straight Connector 120">
                <a:extLst>
                  <a:ext uri="{FF2B5EF4-FFF2-40B4-BE49-F238E27FC236}">
                    <a16:creationId xmlns:a16="http://schemas.microsoft.com/office/drawing/2014/main" id="{54E6FB80-4B30-5241-A964-AC2358D62F7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71972" y="4842689"/>
                <a:ext cx="36000" cy="0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2" name="Straight Connector 121">
                <a:extLst>
                  <a:ext uri="{FF2B5EF4-FFF2-40B4-BE49-F238E27FC236}">
                    <a16:creationId xmlns:a16="http://schemas.microsoft.com/office/drawing/2014/main" id="{E87A48E3-6304-5541-B1DA-262FD0B30FD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71972" y="5512614"/>
                <a:ext cx="36000" cy="0"/>
              </a:xfrm>
              <a:prstGeom prst="line">
                <a:avLst/>
              </a:prstGeom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0" name="Straight Connector 89">
                <a:extLst>
                  <a:ext uri="{FF2B5EF4-FFF2-40B4-BE49-F238E27FC236}">
                    <a16:creationId xmlns:a16="http://schemas.microsoft.com/office/drawing/2014/main" id="{D67978A2-5C99-F843-89A7-832237949E26}"/>
                  </a:ext>
                </a:extLst>
              </p:cNvPr>
              <p:cNvCxnSpPr>
                <a:cxnSpLocks/>
                <a:endCxn id="96" idx="138"/>
              </p:cNvCxnSpPr>
              <p:nvPr/>
            </p:nvCxnSpPr>
            <p:spPr>
              <a:xfrm>
                <a:off x="2324011" y="4835487"/>
                <a:ext cx="1944000" cy="5677"/>
              </a:xfrm>
              <a:prstGeom prst="line">
                <a:avLst/>
              </a:prstGeom>
              <a:ln w="6350">
                <a:solidFill>
                  <a:schemeClr val="bg1">
                    <a:lumMod val="50000"/>
                  </a:schemeClr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2" name="TextBox 91">
                <a:extLst>
                  <a:ext uri="{FF2B5EF4-FFF2-40B4-BE49-F238E27FC236}">
                    <a16:creationId xmlns:a16="http://schemas.microsoft.com/office/drawing/2014/main" id="{0E41B0F4-3401-5E4E-8202-A9D160668830}"/>
                  </a:ext>
                </a:extLst>
              </p:cNvPr>
              <p:cNvSpPr txBox="1"/>
              <p:nvPr/>
            </p:nvSpPr>
            <p:spPr>
              <a:xfrm>
                <a:off x="4248180" y="4301173"/>
                <a:ext cx="242374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75</a:t>
                </a:r>
              </a:p>
            </p:txBody>
          </p:sp>
          <p:sp>
            <p:nvSpPr>
              <p:cNvPr id="94" name="TextBox 93">
                <a:extLst>
                  <a:ext uri="{FF2B5EF4-FFF2-40B4-BE49-F238E27FC236}">
                    <a16:creationId xmlns:a16="http://schemas.microsoft.com/office/drawing/2014/main" id="{EECAA0DF-950B-9043-9284-F47B08350AD1}"/>
                  </a:ext>
                </a:extLst>
              </p:cNvPr>
              <p:cNvSpPr txBox="1"/>
              <p:nvPr/>
            </p:nvSpPr>
            <p:spPr>
              <a:xfrm>
                <a:off x="4248180" y="5435108"/>
                <a:ext cx="242374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</a:p>
            </p:txBody>
          </p:sp>
          <p:sp>
            <p:nvSpPr>
              <p:cNvPr id="96" name="Freeform 95">
                <a:extLst>
                  <a:ext uri="{FF2B5EF4-FFF2-40B4-BE49-F238E27FC236}">
                    <a16:creationId xmlns:a16="http://schemas.microsoft.com/office/drawing/2014/main" id="{FA06CA3D-9A53-B84F-8A4E-C416547FACB6}"/>
                  </a:ext>
                </a:extLst>
              </p:cNvPr>
              <p:cNvSpPr/>
              <p:nvPr/>
            </p:nvSpPr>
            <p:spPr>
              <a:xfrm>
                <a:off x="2325456" y="4363715"/>
                <a:ext cx="1914525" cy="832624"/>
              </a:xfrm>
              <a:custGeom>
                <a:avLst/>
                <a:gdLst>
                  <a:gd name="connsiteX0" fmla="*/ 0 w 1914525"/>
                  <a:gd name="connsiteY0" fmla="*/ 742950 h 908050"/>
                  <a:gd name="connsiteX1" fmla="*/ 3175 w 1914525"/>
                  <a:gd name="connsiteY1" fmla="*/ 787400 h 908050"/>
                  <a:gd name="connsiteX2" fmla="*/ 28575 w 1914525"/>
                  <a:gd name="connsiteY2" fmla="*/ 457200 h 908050"/>
                  <a:gd name="connsiteX3" fmla="*/ 41275 w 1914525"/>
                  <a:gd name="connsiteY3" fmla="*/ 88900 h 908050"/>
                  <a:gd name="connsiteX4" fmla="*/ 50800 w 1914525"/>
                  <a:gd name="connsiteY4" fmla="*/ 155575 h 908050"/>
                  <a:gd name="connsiteX5" fmla="*/ 60325 w 1914525"/>
                  <a:gd name="connsiteY5" fmla="*/ 117475 h 908050"/>
                  <a:gd name="connsiteX6" fmla="*/ 82550 w 1914525"/>
                  <a:gd name="connsiteY6" fmla="*/ 476250 h 908050"/>
                  <a:gd name="connsiteX7" fmla="*/ 95250 w 1914525"/>
                  <a:gd name="connsiteY7" fmla="*/ 292100 h 908050"/>
                  <a:gd name="connsiteX8" fmla="*/ 123825 w 1914525"/>
                  <a:gd name="connsiteY8" fmla="*/ 228600 h 908050"/>
                  <a:gd name="connsiteX9" fmla="*/ 133350 w 1914525"/>
                  <a:gd name="connsiteY9" fmla="*/ 307975 h 908050"/>
                  <a:gd name="connsiteX10" fmla="*/ 155575 w 1914525"/>
                  <a:gd name="connsiteY10" fmla="*/ 165100 h 908050"/>
                  <a:gd name="connsiteX11" fmla="*/ 174625 w 1914525"/>
                  <a:gd name="connsiteY11" fmla="*/ 276225 h 908050"/>
                  <a:gd name="connsiteX12" fmla="*/ 193675 w 1914525"/>
                  <a:gd name="connsiteY12" fmla="*/ 53975 h 908050"/>
                  <a:gd name="connsiteX13" fmla="*/ 206375 w 1914525"/>
                  <a:gd name="connsiteY13" fmla="*/ 0 h 908050"/>
                  <a:gd name="connsiteX14" fmla="*/ 225425 w 1914525"/>
                  <a:gd name="connsiteY14" fmla="*/ 276225 h 908050"/>
                  <a:gd name="connsiteX15" fmla="*/ 244475 w 1914525"/>
                  <a:gd name="connsiteY15" fmla="*/ 231775 h 908050"/>
                  <a:gd name="connsiteX16" fmla="*/ 254000 w 1914525"/>
                  <a:gd name="connsiteY16" fmla="*/ 165100 h 908050"/>
                  <a:gd name="connsiteX17" fmla="*/ 254000 w 1914525"/>
                  <a:gd name="connsiteY17" fmla="*/ 165100 h 908050"/>
                  <a:gd name="connsiteX18" fmla="*/ 269875 w 1914525"/>
                  <a:gd name="connsiteY18" fmla="*/ 438150 h 908050"/>
                  <a:gd name="connsiteX19" fmla="*/ 304800 w 1914525"/>
                  <a:gd name="connsiteY19" fmla="*/ 495300 h 908050"/>
                  <a:gd name="connsiteX20" fmla="*/ 307975 w 1914525"/>
                  <a:gd name="connsiteY20" fmla="*/ 555625 h 908050"/>
                  <a:gd name="connsiteX21" fmla="*/ 314325 w 1914525"/>
                  <a:gd name="connsiteY21" fmla="*/ 355600 h 908050"/>
                  <a:gd name="connsiteX22" fmla="*/ 346075 w 1914525"/>
                  <a:gd name="connsiteY22" fmla="*/ 177800 h 908050"/>
                  <a:gd name="connsiteX23" fmla="*/ 358775 w 1914525"/>
                  <a:gd name="connsiteY23" fmla="*/ 292100 h 908050"/>
                  <a:gd name="connsiteX24" fmla="*/ 365125 w 1914525"/>
                  <a:gd name="connsiteY24" fmla="*/ 368300 h 908050"/>
                  <a:gd name="connsiteX25" fmla="*/ 384175 w 1914525"/>
                  <a:gd name="connsiteY25" fmla="*/ 508000 h 908050"/>
                  <a:gd name="connsiteX26" fmla="*/ 396875 w 1914525"/>
                  <a:gd name="connsiteY26" fmla="*/ 342900 h 908050"/>
                  <a:gd name="connsiteX27" fmla="*/ 412750 w 1914525"/>
                  <a:gd name="connsiteY27" fmla="*/ 479425 h 908050"/>
                  <a:gd name="connsiteX28" fmla="*/ 428625 w 1914525"/>
                  <a:gd name="connsiteY28" fmla="*/ 317500 h 908050"/>
                  <a:gd name="connsiteX29" fmla="*/ 438150 w 1914525"/>
                  <a:gd name="connsiteY29" fmla="*/ 365125 h 908050"/>
                  <a:gd name="connsiteX30" fmla="*/ 457200 w 1914525"/>
                  <a:gd name="connsiteY30" fmla="*/ 146050 h 908050"/>
                  <a:gd name="connsiteX31" fmla="*/ 463550 w 1914525"/>
                  <a:gd name="connsiteY31" fmla="*/ 295275 h 908050"/>
                  <a:gd name="connsiteX32" fmla="*/ 479425 w 1914525"/>
                  <a:gd name="connsiteY32" fmla="*/ 381000 h 908050"/>
                  <a:gd name="connsiteX33" fmla="*/ 498475 w 1914525"/>
                  <a:gd name="connsiteY33" fmla="*/ 320675 h 908050"/>
                  <a:gd name="connsiteX34" fmla="*/ 504825 w 1914525"/>
                  <a:gd name="connsiteY34" fmla="*/ 288925 h 908050"/>
                  <a:gd name="connsiteX35" fmla="*/ 539750 w 1914525"/>
                  <a:gd name="connsiteY35" fmla="*/ 361950 h 908050"/>
                  <a:gd name="connsiteX36" fmla="*/ 549275 w 1914525"/>
                  <a:gd name="connsiteY36" fmla="*/ 282575 h 908050"/>
                  <a:gd name="connsiteX37" fmla="*/ 561975 w 1914525"/>
                  <a:gd name="connsiteY37" fmla="*/ 336550 h 908050"/>
                  <a:gd name="connsiteX38" fmla="*/ 577850 w 1914525"/>
                  <a:gd name="connsiteY38" fmla="*/ 285750 h 908050"/>
                  <a:gd name="connsiteX39" fmla="*/ 581025 w 1914525"/>
                  <a:gd name="connsiteY39" fmla="*/ 320675 h 908050"/>
                  <a:gd name="connsiteX40" fmla="*/ 593725 w 1914525"/>
                  <a:gd name="connsiteY40" fmla="*/ 415925 h 908050"/>
                  <a:gd name="connsiteX41" fmla="*/ 600075 w 1914525"/>
                  <a:gd name="connsiteY41" fmla="*/ 368300 h 908050"/>
                  <a:gd name="connsiteX42" fmla="*/ 612775 w 1914525"/>
                  <a:gd name="connsiteY42" fmla="*/ 431800 h 908050"/>
                  <a:gd name="connsiteX43" fmla="*/ 619125 w 1914525"/>
                  <a:gd name="connsiteY43" fmla="*/ 387350 h 908050"/>
                  <a:gd name="connsiteX44" fmla="*/ 628650 w 1914525"/>
                  <a:gd name="connsiteY44" fmla="*/ 415925 h 908050"/>
                  <a:gd name="connsiteX45" fmla="*/ 635000 w 1914525"/>
                  <a:gd name="connsiteY45" fmla="*/ 330200 h 908050"/>
                  <a:gd name="connsiteX46" fmla="*/ 650875 w 1914525"/>
                  <a:gd name="connsiteY46" fmla="*/ 203200 h 908050"/>
                  <a:gd name="connsiteX47" fmla="*/ 666750 w 1914525"/>
                  <a:gd name="connsiteY47" fmla="*/ 536575 h 908050"/>
                  <a:gd name="connsiteX48" fmla="*/ 673100 w 1914525"/>
                  <a:gd name="connsiteY48" fmla="*/ 396875 h 908050"/>
                  <a:gd name="connsiteX49" fmla="*/ 688975 w 1914525"/>
                  <a:gd name="connsiteY49" fmla="*/ 523875 h 908050"/>
                  <a:gd name="connsiteX50" fmla="*/ 698500 w 1914525"/>
                  <a:gd name="connsiteY50" fmla="*/ 203200 h 908050"/>
                  <a:gd name="connsiteX51" fmla="*/ 720725 w 1914525"/>
                  <a:gd name="connsiteY51" fmla="*/ 311150 h 908050"/>
                  <a:gd name="connsiteX52" fmla="*/ 727075 w 1914525"/>
                  <a:gd name="connsiteY52" fmla="*/ 260350 h 908050"/>
                  <a:gd name="connsiteX53" fmla="*/ 739775 w 1914525"/>
                  <a:gd name="connsiteY53" fmla="*/ 425450 h 908050"/>
                  <a:gd name="connsiteX54" fmla="*/ 742950 w 1914525"/>
                  <a:gd name="connsiteY54" fmla="*/ 498475 h 908050"/>
                  <a:gd name="connsiteX55" fmla="*/ 755650 w 1914525"/>
                  <a:gd name="connsiteY55" fmla="*/ 501650 h 908050"/>
                  <a:gd name="connsiteX56" fmla="*/ 765175 w 1914525"/>
                  <a:gd name="connsiteY56" fmla="*/ 463550 h 908050"/>
                  <a:gd name="connsiteX57" fmla="*/ 781050 w 1914525"/>
                  <a:gd name="connsiteY57" fmla="*/ 504825 h 908050"/>
                  <a:gd name="connsiteX58" fmla="*/ 796925 w 1914525"/>
                  <a:gd name="connsiteY58" fmla="*/ 479425 h 908050"/>
                  <a:gd name="connsiteX59" fmla="*/ 803275 w 1914525"/>
                  <a:gd name="connsiteY59" fmla="*/ 669925 h 908050"/>
                  <a:gd name="connsiteX60" fmla="*/ 822325 w 1914525"/>
                  <a:gd name="connsiteY60" fmla="*/ 482600 h 908050"/>
                  <a:gd name="connsiteX61" fmla="*/ 838200 w 1914525"/>
                  <a:gd name="connsiteY61" fmla="*/ 457200 h 908050"/>
                  <a:gd name="connsiteX62" fmla="*/ 850900 w 1914525"/>
                  <a:gd name="connsiteY62" fmla="*/ 396875 h 908050"/>
                  <a:gd name="connsiteX63" fmla="*/ 854075 w 1914525"/>
                  <a:gd name="connsiteY63" fmla="*/ 523875 h 908050"/>
                  <a:gd name="connsiteX64" fmla="*/ 873125 w 1914525"/>
                  <a:gd name="connsiteY64" fmla="*/ 450850 h 908050"/>
                  <a:gd name="connsiteX65" fmla="*/ 889000 w 1914525"/>
                  <a:gd name="connsiteY65" fmla="*/ 498475 h 908050"/>
                  <a:gd name="connsiteX66" fmla="*/ 911225 w 1914525"/>
                  <a:gd name="connsiteY66" fmla="*/ 403225 h 908050"/>
                  <a:gd name="connsiteX67" fmla="*/ 923925 w 1914525"/>
                  <a:gd name="connsiteY67" fmla="*/ 231775 h 908050"/>
                  <a:gd name="connsiteX68" fmla="*/ 942975 w 1914525"/>
                  <a:gd name="connsiteY68" fmla="*/ 415925 h 908050"/>
                  <a:gd name="connsiteX69" fmla="*/ 958850 w 1914525"/>
                  <a:gd name="connsiteY69" fmla="*/ 504825 h 908050"/>
                  <a:gd name="connsiteX70" fmla="*/ 962025 w 1914525"/>
                  <a:gd name="connsiteY70" fmla="*/ 454025 h 908050"/>
                  <a:gd name="connsiteX71" fmla="*/ 974725 w 1914525"/>
                  <a:gd name="connsiteY71" fmla="*/ 317500 h 908050"/>
                  <a:gd name="connsiteX72" fmla="*/ 984250 w 1914525"/>
                  <a:gd name="connsiteY72" fmla="*/ 320675 h 908050"/>
                  <a:gd name="connsiteX73" fmla="*/ 996950 w 1914525"/>
                  <a:gd name="connsiteY73" fmla="*/ 381000 h 908050"/>
                  <a:gd name="connsiteX74" fmla="*/ 1009650 w 1914525"/>
                  <a:gd name="connsiteY74" fmla="*/ 600075 h 908050"/>
                  <a:gd name="connsiteX75" fmla="*/ 1031875 w 1914525"/>
                  <a:gd name="connsiteY75" fmla="*/ 736600 h 908050"/>
                  <a:gd name="connsiteX76" fmla="*/ 1069975 w 1914525"/>
                  <a:gd name="connsiteY76" fmla="*/ 514350 h 908050"/>
                  <a:gd name="connsiteX77" fmla="*/ 1079500 w 1914525"/>
                  <a:gd name="connsiteY77" fmla="*/ 546100 h 908050"/>
                  <a:gd name="connsiteX78" fmla="*/ 1085850 w 1914525"/>
                  <a:gd name="connsiteY78" fmla="*/ 488950 h 908050"/>
                  <a:gd name="connsiteX79" fmla="*/ 1101725 w 1914525"/>
                  <a:gd name="connsiteY79" fmla="*/ 536575 h 908050"/>
                  <a:gd name="connsiteX80" fmla="*/ 1108075 w 1914525"/>
                  <a:gd name="connsiteY80" fmla="*/ 431800 h 908050"/>
                  <a:gd name="connsiteX81" fmla="*/ 1133475 w 1914525"/>
                  <a:gd name="connsiteY81" fmla="*/ 536575 h 908050"/>
                  <a:gd name="connsiteX82" fmla="*/ 1127125 w 1914525"/>
                  <a:gd name="connsiteY82" fmla="*/ 374650 h 908050"/>
                  <a:gd name="connsiteX83" fmla="*/ 1146175 w 1914525"/>
                  <a:gd name="connsiteY83" fmla="*/ 523875 h 908050"/>
                  <a:gd name="connsiteX84" fmla="*/ 1162050 w 1914525"/>
                  <a:gd name="connsiteY84" fmla="*/ 349250 h 908050"/>
                  <a:gd name="connsiteX85" fmla="*/ 1177925 w 1914525"/>
                  <a:gd name="connsiteY85" fmla="*/ 444500 h 908050"/>
                  <a:gd name="connsiteX86" fmla="*/ 1181100 w 1914525"/>
                  <a:gd name="connsiteY86" fmla="*/ 282575 h 908050"/>
                  <a:gd name="connsiteX87" fmla="*/ 1193800 w 1914525"/>
                  <a:gd name="connsiteY87" fmla="*/ 320675 h 908050"/>
                  <a:gd name="connsiteX88" fmla="*/ 1196975 w 1914525"/>
                  <a:gd name="connsiteY88" fmla="*/ 206375 h 908050"/>
                  <a:gd name="connsiteX89" fmla="*/ 1216025 w 1914525"/>
                  <a:gd name="connsiteY89" fmla="*/ 400050 h 908050"/>
                  <a:gd name="connsiteX90" fmla="*/ 1250950 w 1914525"/>
                  <a:gd name="connsiteY90" fmla="*/ 536575 h 908050"/>
                  <a:gd name="connsiteX91" fmla="*/ 1270000 w 1914525"/>
                  <a:gd name="connsiteY91" fmla="*/ 263525 h 908050"/>
                  <a:gd name="connsiteX92" fmla="*/ 1279525 w 1914525"/>
                  <a:gd name="connsiteY92" fmla="*/ 393700 h 908050"/>
                  <a:gd name="connsiteX93" fmla="*/ 1285875 w 1914525"/>
                  <a:gd name="connsiteY93" fmla="*/ 260350 h 908050"/>
                  <a:gd name="connsiteX94" fmla="*/ 1311275 w 1914525"/>
                  <a:gd name="connsiteY94" fmla="*/ 650875 h 908050"/>
                  <a:gd name="connsiteX95" fmla="*/ 1330325 w 1914525"/>
                  <a:gd name="connsiteY95" fmla="*/ 682625 h 908050"/>
                  <a:gd name="connsiteX96" fmla="*/ 1346200 w 1914525"/>
                  <a:gd name="connsiteY96" fmla="*/ 349250 h 908050"/>
                  <a:gd name="connsiteX97" fmla="*/ 1365250 w 1914525"/>
                  <a:gd name="connsiteY97" fmla="*/ 282575 h 908050"/>
                  <a:gd name="connsiteX98" fmla="*/ 1377950 w 1914525"/>
                  <a:gd name="connsiteY98" fmla="*/ 536575 h 908050"/>
                  <a:gd name="connsiteX99" fmla="*/ 1390650 w 1914525"/>
                  <a:gd name="connsiteY99" fmla="*/ 473075 h 908050"/>
                  <a:gd name="connsiteX100" fmla="*/ 1406525 w 1914525"/>
                  <a:gd name="connsiteY100" fmla="*/ 584200 h 908050"/>
                  <a:gd name="connsiteX101" fmla="*/ 1416050 w 1914525"/>
                  <a:gd name="connsiteY101" fmla="*/ 460375 h 908050"/>
                  <a:gd name="connsiteX102" fmla="*/ 1428750 w 1914525"/>
                  <a:gd name="connsiteY102" fmla="*/ 669925 h 908050"/>
                  <a:gd name="connsiteX103" fmla="*/ 1444625 w 1914525"/>
                  <a:gd name="connsiteY103" fmla="*/ 454025 h 908050"/>
                  <a:gd name="connsiteX104" fmla="*/ 1463675 w 1914525"/>
                  <a:gd name="connsiteY104" fmla="*/ 536575 h 908050"/>
                  <a:gd name="connsiteX105" fmla="*/ 1485900 w 1914525"/>
                  <a:gd name="connsiteY105" fmla="*/ 260350 h 908050"/>
                  <a:gd name="connsiteX106" fmla="*/ 1501775 w 1914525"/>
                  <a:gd name="connsiteY106" fmla="*/ 323850 h 908050"/>
                  <a:gd name="connsiteX107" fmla="*/ 1504950 w 1914525"/>
                  <a:gd name="connsiteY107" fmla="*/ 444500 h 908050"/>
                  <a:gd name="connsiteX108" fmla="*/ 1520825 w 1914525"/>
                  <a:gd name="connsiteY108" fmla="*/ 603250 h 908050"/>
                  <a:gd name="connsiteX109" fmla="*/ 1533525 w 1914525"/>
                  <a:gd name="connsiteY109" fmla="*/ 638175 h 908050"/>
                  <a:gd name="connsiteX110" fmla="*/ 1546225 w 1914525"/>
                  <a:gd name="connsiteY110" fmla="*/ 422275 h 908050"/>
                  <a:gd name="connsiteX111" fmla="*/ 1549400 w 1914525"/>
                  <a:gd name="connsiteY111" fmla="*/ 450850 h 908050"/>
                  <a:gd name="connsiteX112" fmla="*/ 1562100 w 1914525"/>
                  <a:gd name="connsiteY112" fmla="*/ 368300 h 908050"/>
                  <a:gd name="connsiteX113" fmla="*/ 1574800 w 1914525"/>
                  <a:gd name="connsiteY113" fmla="*/ 508000 h 908050"/>
                  <a:gd name="connsiteX114" fmla="*/ 1584325 w 1914525"/>
                  <a:gd name="connsiteY114" fmla="*/ 831850 h 908050"/>
                  <a:gd name="connsiteX115" fmla="*/ 1593850 w 1914525"/>
                  <a:gd name="connsiteY115" fmla="*/ 908050 h 908050"/>
                  <a:gd name="connsiteX116" fmla="*/ 1606550 w 1914525"/>
                  <a:gd name="connsiteY116" fmla="*/ 850900 h 908050"/>
                  <a:gd name="connsiteX117" fmla="*/ 1622425 w 1914525"/>
                  <a:gd name="connsiteY117" fmla="*/ 895350 h 908050"/>
                  <a:gd name="connsiteX118" fmla="*/ 1641475 w 1914525"/>
                  <a:gd name="connsiteY118" fmla="*/ 555625 h 908050"/>
                  <a:gd name="connsiteX119" fmla="*/ 1657350 w 1914525"/>
                  <a:gd name="connsiteY119" fmla="*/ 171450 h 908050"/>
                  <a:gd name="connsiteX120" fmla="*/ 1679575 w 1914525"/>
                  <a:gd name="connsiteY120" fmla="*/ 368300 h 908050"/>
                  <a:gd name="connsiteX121" fmla="*/ 1685925 w 1914525"/>
                  <a:gd name="connsiteY121" fmla="*/ 311150 h 908050"/>
                  <a:gd name="connsiteX122" fmla="*/ 1701800 w 1914525"/>
                  <a:gd name="connsiteY122" fmla="*/ 368300 h 908050"/>
                  <a:gd name="connsiteX123" fmla="*/ 1714500 w 1914525"/>
                  <a:gd name="connsiteY123" fmla="*/ 206375 h 908050"/>
                  <a:gd name="connsiteX124" fmla="*/ 1739900 w 1914525"/>
                  <a:gd name="connsiteY124" fmla="*/ 384175 h 908050"/>
                  <a:gd name="connsiteX125" fmla="*/ 1762125 w 1914525"/>
                  <a:gd name="connsiteY125" fmla="*/ 479425 h 908050"/>
                  <a:gd name="connsiteX126" fmla="*/ 1765300 w 1914525"/>
                  <a:gd name="connsiteY126" fmla="*/ 365125 h 908050"/>
                  <a:gd name="connsiteX127" fmla="*/ 1790700 w 1914525"/>
                  <a:gd name="connsiteY127" fmla="*/ 444500 h 908050"/>
                  <a:gd name="connsiteX128" fmla="*/ 1803400 w 1914525"/>
                  <a:gd name="connsiteY128" fmla="*/ 393700 h 908050"/>
                  <a:gd name="connsiteX129" fmla="*/ 1816100 w 1914525"/>
                  <a:gd name="connsiteY129" fmla="*/ 539750 h 908050"/>
                  <a:gd name="connsiteX130" fmla="*/ 1825625 w 1914525"/>
                  <a:gd name="connsiteY130" fmla="*/ 485775 h 908050"/>
                  <a:gd name="connsiteX131" fmla="*/ 1851025 w 1914525"/>
                  <a:gd name="connsiteY131" fmla="*/ 577850 h 908050"/>
                  <a:gd name="connsiteX132" fmla="*/ 1851025 w 1914525"/>
                  <a:gd name="connsiteY132" fmla="*/ 457200 h 908050"/>
                  <a:gd name="connsiteX133" fmla="*/ 1866900 w 1914525"/>
                  <a:gd name="connsiteY133" fmla="*/ 396875 h 908050"/>
                  <a:gd name="connsiteX134" fmla="*/ 1870075 w 1914525"/>
                  <a:gd name="connsiteY134" fmla="*/ 555625 h 908050"/>
                  <a:gd name="connsiteX135" fmla="*/ 1885950 w 1914525"/>
                  <a:gd name="connsiteY135" fmla="*/ 409575 h 908050"/>
                  <a:gd name="connsiteX136" fmla="*/ 1889125 w 1914525"/>
                  <a:gd name="connsiteY136" fmla="*/ 488950 h 908050"/>
                  <a:gd name="connsiteX137" fmla="*/ 1901825 w 1914525"/>
                  <a:gd name="connsiteY137" fmla="*/ 460375 h 908050"/>
                  <a:gd name="connsiteX138" fmla="*/ 1914525 w 1914525"/>
                  <a:gd name="connsiteY138" fmla="*/ 520700 h 90805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  <a:cxn ang="0">
                    <a:pos x="connsiteX69" y="connsiteY69"/>
                  </a:cxn>
                  <a:cxn ang="0">
                    <a:pos x="connsiteX70" y="connsiteY70"/>
                  </a:cxn>
                  <a:cxn ang="0">
                    <a:pos x="connsiteX71" y="connsiteY71"/>
                  </a:cxn>
                  <a:cxn ang="0">
                    <a:pos x="connsiteX72" y="connsiteY72"/>
                  </a:cxn>
                  <a:cxn ang="0">
                    <a:pos x="connsiteX73" y="connsiteY73"/>
                  </a:cxn>
                  <a:cxn ang="0">
                    <a:pos x="connsiteX74" y="connsiteY74"/>
                  </a:cxn>
                  <a:cxn ang="0">
                    <a:pos x="connsiteX75" y="connsiteY75"/>
                  </a:cxn>
                  <a:cxn ang="0">
                    <a:pos x="connsiteX76" y="connsiteY76"/>
                  </a:cxn>
                  <a:cxn ang="0">
                    <a:pos x="connsiteX77" y="connsiteY77"/>
                  </a:cxn>
                  <a:cxn ang="0">
                    <a:pos x="connsiteX78" y="connsiteY78"/>
                  </a:cxn>
                  <a:cxn ang="0">
                    <a:pos x="connsiteX79" y="connsiteY79"/>
                  </a:cxn>
                  <a:cxn ang="0">
                    <a:pos x="connsiteX80" y="connsiteY80"/>
                  </a:cxn>
                  <a:cxn ang="0">
                    <a:pos x="connsiteX81" y="connsiteY81"/>
                  </a:cxn>
                  <a:cxn ang="0">
                    <a:pos x="connsiteX82" y="connsiteY82"/>
                  </a:cxn>
                  <a:cxn ang="0">
                    <a:pos x="connsiteX83" y="connsiteY83"/>
                  </a:cxn>
                  <a:cxn ang="0">
                    <a:pos x="connsiteX84" y="connsiteY84"/>
                  </a:cxn>
                  <a:cxn ang="0">
                    <a:pos x="connsiteX85" y="connsiteY85"/>
                  </a:cxn>
                  <a:cxn ang="0">
                    <a:pos x="connsiteX86" y="connsiteY86"/>
                  </a:cxn>
                  <a:cxn ang="0">
                    <a:pos x="connsiteX87" y="connsiteY87"/>
                  </a:cxn>
                  <a:cxn ang="0">
                    <a:pos x="connsiteX88" y="connsiteY88"/>
                  </a:cxn>
                  <a:cxn ang="0">
                    <a:pos x="connsiteX89" y="connsiteY89"/>
                  </a:cxn>
                  <a:cxn ang="0">
                    <a:pos x="connsiteX90" y="connsiteY90"/>
                  </a:cxn>
                  <a:cxn ang="0">
                    <a:pos x="connsiteX91" y="connsiteY91"/>
                  </a:cxn>
                  <a:cxn ang="0">
                    <a:pos x="connsiteX92" y="connsiteY92"/>
                  </a:cxn>
                  <a:cxn ang="0">
                    <a:pos x="connsiteX93" y="connsiteY93"/>
                  </a:cxn>
                  <a:cxn ang="0">
                    <a:pos x="connsiteX94" y="connsiteY94"/>
                  </a:cxn>
                  <a:cxn ang="0">
                    <a:pos x="connsiteX95" y="connsiteY95"/>
                  </a:cxn>
                  <a:cxn ang="0">
                    <a:pos x="connsiteX96" y="connsiteY96"/>
                  </a:cxn>
                  <a:cxn ang="0">
                    <a:pos x="connsiteX97" y="connsiteY97"/>
                  </a:cxn>
                  <a:cxn ang="0">
                    <a:pos x="connsiteX98" y="connsiteY98"/>
                  </a:cxn>
                  <a:cxn ang="0">
                    <a:pos x="connsiteX99" y="connsiteY99"/>
                  </a:cxn>
                  <a:cxn ang="0">
                    <a:pos x="connsiteX100" y="connsiteY100"/>
                  </a:cxn>
                  <a:cxn ang="0">
                    <a:pos x="connsiteX101" y="connsiteY101"/>
                  </a:cxn>
                  <a:cxn ang="0">
                    <a:pos x="connsiteX102" y="connsiteY102"/>
                  </a:cxn>
                  <a:cxn ang="0">
                    <a:pos x="connsiteX103" y="connsiteY103"/>
                  </a:cxn>
                  <a:cxn ang="0">
                    <a:pos x="connsiteX104" y="connsiteY104"/>
                  </a:cxn>
                  <a:cxn ang="0">
                    <a:pos x="connsiteX105" y="connsiteY105"/>
                  </a:cxn>
                  <a:cxn ang="0">
                    <a:pos x="connsiteX106" y="connsiteY106"/>
                  </a:cxn>
                  <a:cxn ang="0">
                    <a:pos x="connsiteX107" y="connsiteY107"/>
                  </a:cxn>
                  <a:cxn ang="0">
                    <a:pos x="connsiteX108" y="connsiteY108"/>
                  </a:cxn>
                  <a:cxn ang="0">
                    <a:pos x="connsiteX109" y="connsiteY109"/>
                  </a:cxn>
                  <a:cxn ang="0">
                    <a:pos x="connsiteX110" y="connsiteY110"/>
                  </a:cxn>
                  <a:cxn ang="0">
                    <a:pos x="connsiteX111" y="connsiteY111"/>
                  </a:cxn>
                  <a:cxn ang="0">
                    <a:pos x="connsiteX112" y="connsiteY112"/>
                  </a:cxn>
                  <a:cxn ang="0">
                    <a:pos x="connsiteX113" y="connsiteY113"/>
                  </a:cxn>
                  <a:cxn ang="0">
                    <a:pos x="connsiteX114" y="connsiteY114"/>
                  </a:cxn>
                  <a:cxn ang="0">
                    <a:pos x="connsiteX115" y="connsiteY115"/>
                  </a:cxn>
                  <a:cxn ang="0">
                    <a:pos x="connsiteX116" y="connsiteY116"/>
                  </a:cxn>
                  <a:cxn ang="0">
                    <a:pos x="connsiteX117" y="connsiteY117"/>
                  </a:cxn>
                  <a:cxn ang="0">
                    <a:pos x="connsiteX118" y="connsiteY118"/>
                  </a:cxn>
                  <a:cxn ang="0">
                    <a:pos x="connsiteX119" y="connsiteY119"/>
                  </a:cxn>
                  <a:cxn ang="0">
                    <a:pos x="connsiteX120" y="connsiteY120"/>
                  </a:cxn>
                  <a:cxn ang="0">
                    <a:pos x="connsiteX121" y="connsiteY121"/>
                  </a:cxn>
                  <a:cxn ang="0">
                    <a:pos x="connsiteX122" y="connsiteY122"/>
                  </a:cxn>
                  <a:cxn ang="0">
                    <a:pos x="connsiteX123" y="connsiteY123"/>
                  </a:cxn>
                  <a:cxn ang="0">
                    <a:pos x="connsiteX124" y="connsiteY124"/>
                  </a:cxn>
                  <a:cxn ang="0">
                    <a:pos x="connsiteX125" y="connsiteY125"/>
                  </a:cxn>
                  <a:cxn ang="0">
                    <a:pos x="connsiteX126" y="connsiteY126"/>
                  </a:cxn>
                  <a:cxn ang="0">
                    <a:pos x="connsiteX127" y="connsiteY127"/>
                  </a:cxn>
                  <a:cxn ang="0">
                    <a:pos x="connsiteX128" y="connsiteY128"/>
                  </a:cxn>
                  <a:cxn ang="0">
                    <a:pos x="connsiteX129" y="connsiteY129"/>
                  </a:cxn>
                  <a:cxn ang="0">
                    <a:pos x="connsiteX130" y="connsiteY130"/>
                  </a:cxn>
                  <a:cxn ang="0">
                    <a:pos x="connsiteX131" y="connsiteY131"/>
                  </a:cxn>
                  <a:cxn ang="0">
                    <a:pos x="connsiteX132" y="connsiteY132"/>
                  </a:cxn>
                  <a:cxn ang="0">
                    <a:pos x="connsiteX133" y="connsiteY133"/>
                  </a:cxn>
                  <a:cxn ang="0">
                    <a:pos x="connsiteX134" y="connsiteY134"/>
                  </a:cxn>
                  <a:cxn ang="0">
                    <a:pos x="connsiteX135" y="connsiteY135"/>
                  </a:cxn>
                  <a:cxn ang="0">
                    <a:pos x="connsiteX136" y="connsiteY136"/>
                  </a:cxn>
                  <a:cxn ang="0">
                    <a:pos x="connsiteX137" y="connsiteY137"/>
                  </a:cxn>
                  <a:cxn ang="0">
                    <a:pos x="connsiteX138" y="connsiteY138"/>
                  </a:cxn>
                </a:cxnLst>
                <a:rect l="l" t="t" r="r" b="b"/>
                <a:pathLst>
                  <a:path w="1914525" h="908050">
                    <a:moveTo>
                      <a:pt x="0" y="742950"/>
                    </a:moveTo>
                    <a:lnTo>
                      <a:pt x="3175" y="787400"/>
                    </a:lnTo>
                    <a:lnTo>
                      <a:pt x="28575" y="457200"/>
                    </a:lnTo>
                    <a:lnTo>
                      <a:pt x="41275" y="88900"/>
                    </a:lnTo>
                    <a:lnTo>
                      <a:pt x="50800" y="155575"/>
                    </a:lnTo>
                    <a:lnTo>
                      <a:pt x="60325" y="117475"/>
                    </a:lnTo>
                    <a:lnTo>
                      <a:pt x="82550" y="476250"/>
                    </a:lnTo>
                    <a:lnTo>
                      <a:pt x="95250" y="292100"/>
                    </a:lnTo>
                    <a:lnTo>
                      <a:pt x="123825" y="228600"/>
                    </a:lnTo>
                    <a:lnTo>
                      <a:pt x="133350" y="307975"/>
                    </a:lnTo>
                    <a:lnTo>
                      <a:pt x="155575" y="165100"/>
                    </a:lnTo>
                    <a:lnTo>
                      <a:pt x="174625" y="276225"/>
                    </a:lnTo>
                    <a:lnTo>
                      <a:pt x="193675" y="53975"/>
                    </a:lnTo>
                    <a:lnTo>
                      <a:pt x="206375" y="0"/>
                    </a:lnTo>
                    <a:lnTo>
                      <a:pt x="225425" y="276225"/>
                    </a:lnTo>
                    <a:lnTo>
                      <a:pt x="244475" y="231775"/>
                    </a:lnTo>
                    <a:lnTo>
                      <a:pt x="254000" y="165100"/>
                    </a:lnTo>
                    <a:lnTo>
                      <a:pt x="254000" y="165100"/>
                    </a:lnTo>
                    <a:lnTo>
                      <a:pt x="269875" y="438150"/>
                    </a:lnTo>
                    <a:lnTo>
                      <a:pt x="304800" y="495300"/>
                    </a:lnTo>
                    <a:lnTo>
                      <a:pt x="307975" y="555625"/>
                    </a:lnTo>
                    <a:lnTo>
                      <a:pt x="314325" y="355600"/>
                    </a:lnTo>
                    <a:lnTo>
                      <a:pt x="346075" y="177800"/>
                    </a:lnTo>
                    <a:lnTo>
                      <a:pt x="358775" y="292100"/>
                    </a:lnTo>
                    <a:lnTo>
                      <a:pt x="365125" y="368300"/>
                    </a:lnTo>
                    <a:lnTo>
                      <a:pt x="384175" y="508000"/>
                    </a:lnTo>
                    <a:lnTo>
                      <a:pt x="396875" y="342900"/>
                    </a:lnTo>
                    <a:lnTo>
                      <a:pt x="412750" y="479425"/>
                    </a:lnTo>
                    <a:lnTo>
                      <a:pt x="428625" y="317500"/>
                    </a:lnTo>
                    <a:lnTo>
                      <a:pt x="438150" y="365125"/>
                    </a:lnTo>
                    <a:lnTo>
                      <a:pt x="457200" y="146050"/>
                    </a:lnTo>
                    <a:lnTo>
                      <a:pt x="463550" y="295275"/>
                    </a:lnTo>
                    <a:lnTo>
                      <a:pt x="479425" y="381000"/>
                    </a:lnTo>
                    <a:lnTo>
                      <a:pt x="498475" y="320675"/>
                    </a:lnTo>
                    <a:lnTo>
                      <a:pt x="504825" y="288925"/>
                    </a:lnTo>
                    <a:lnTo>
                      <a:pt x="539750" y="361950"/>
                    </a:lnTo>
                    <a:lnTo>
                      <a:pt x="549275" y="282575"/>
                    </a:lnTo>
                    <a:lnTo>
                      <a:pt x="561975" y="336550"/>
                    </a:lnTo>
                    <a:lnTo>
                      <a:pt x="577850" y="285750"/>
                    </a:lnTo>
                    <a:lnTo>
                      <a:pt x="581025" y="320675"/>
                    </a:lnTo>
                    <a:lnTo>
                      <a:pt x="593725" y="415925"/>
                    </a:lnTo>
                    <a:lnTo>
                      <a:pt x="600075" y="368300"/>
                    </a:lnTo>
                    <a:lnTo>
                      <a:pt x="612775" y="431800"/>
                    </a:lnTo>
                    <a:lnTo>
                      <a:pt x="619125" y="387350"/>
                    </a:lnTo>
                    <a:lnTo>
                      <a:pt x="628650" y="415925"/>
                    </a:lnTo>
                    <a:lnTo>
                      <a:pt x="635000" y="330200"/>
                    </a:lnTo>
                    <a:lnTo>
                      <a:pt x="650875" y="203200"/>
                    </a:lnTo>
                    <a:lnTo>
                      <a:pt x="666750" y="536575"/>
                    </a:lnTo>
                    <a:lnTo>
                      <a:pt x="673100" y="396875"/>
                    </a:lnTo>
                    <a:lnTo>
                      <a:pt x="688975" y="523875"/>
                    </a:lnTo>
                    <a:lnTo>
                      <a:pt x="698500" y="203200"/>
                    </a:lnTo>
                    <a:lnTo>
                      <a:pt x="720725" y="311150"/>
                    </a:lnTo>
                    <a:lnTo>
                      <a:pt x="727075" y="260350"/>
                    </a:lnTo>
                    <a:lnTo>
                      <a:pt x="739775" y="425450"/>
                    </a:lnTo>
                    <a:lnTo>
                      <a:pt x="742950" y="498475"/>
                    </a:lnTo>
                    <a:lnTo>
                      <a:pt x="755650" y="501650"/>
                    </a:lnTo>
                    <a:lnTo>
                      <a:pt x="765175" y="463550"/>
                    </a:lnTo>
                    <a:lnTo>
                      <a:pt x="781050" y="504825"/>
                    </a:lnTo>
                    <a:lnTo>
                      <a:pt x="796925" y="479425"/>
                    </a:lnTo>
                    <a:lnTo>
                      <a:pt x="803275" y="669925"/>
                    </a:lnTo>
                    <a:lnTo>
                      <a:pt x="822325" y="482600"/>
                    </a:lnTo>
                    <a:lnTo>
                      <a:pt x="838200" y="457200"/>
                    </a:lnTo>
                    <a:lnTo>
                      <a:pt x="850900" y="396875"/>
                    </a:lnTo>
                    <a:cubicBezTo>
                      <a:pt x="851958" y="439208"/>
                      <a:pt x="853017" y="481542"/>
                      <a:pt x="854075" y="523875"/>
                    </a:cubicBezTo>
                    <a:lnTo>
                      <a:pt x="873125" y="450850"/>
                    </a:lnTo>
                    <a:lnTo>
                      <a:pt x="889000" y="498475"/>
                    </a:lnTo>
                    <a:lnTo>
                      <a:pt x="911225" y="403225"/>
                    </a:lnTo>
                    <a:lnTo>
                      <a:pt x="923925" y="231775"/>
                    </a:lnTo>
                    <a:lnTo>
                      <a:pt x="942975" y="415925"/>
                    </a:lnTo>
                    <a:lnTo>
                      <a:pt x="958850" y="504825"/>
                    </a:lnTo>
                    <a:lnTo>
                      <a:pt x="962025" y="454025"/>
                    </a:lnTo>
                    <a:lnTo>
                      <a:pt x="974725" y="317500"/>
                    </a:lnTo>
                    <a:lnTo>
                      <a:pt x="984250" y="320675"/>
                    </a:lnTo>
                    <a:lnTo>
                      <a:pt x="996950" y="381000"/>
                    </a:lnTo>
                    <a:lnTo>
                      <a:pt x="1009650" y="600075"/>
                    </a:lnTo>
                    <a:lnTo>
                      <a:pt x="1031875" y="736600"/>
                    </a:lnTo>
                    <a:lnTo>
                      <a:pt x="1069975" y="514350"/>
                    </a:lnTo>
                    <a:lnTo>
                      <a:pt x="1079500" y="546100"/>
                    </a:lnTo>
                    <a:lnTo>
                      <a:pt x="1085850" y="488950"/>
                    </a:lnTo>
                    <a:lnTo>
                      <a:pt x="1101725" y="536575"/>
                    </a:lnTo>
                    <a:lnTo>
                      <a:pt x="1108075" y="431800"/>
                    </a:lnTo>
                    <a:lnTo>
                      <a:pt x="1133475" y="536575"/>
                    </a:lnTo>
                    <a:lnTo>
                      <a:pt x="1127125" y="374650"/>
                    </a:lnTo>
                    <a:lnTo>
                      <a:pt x="1146175" y="523875"/>
                    </a:lnTo>
                    <a:lnTo>
                      <a:pt x="1162050" y="349250"/>
                    </a:lnTo>
                    <a:lnTo>
                      <a:pt x="1177925" y="444500"/>
                    </a:lnTo>
                    <a:cubicBezTo>
                      <a:pt x="1178983" y="390525"/>
                      <a:pt x="1180042" y="336550"/>
                      <a:pt x="1181100" y="282575"/>
                    </a:cubicBezTo>
                    <a:lnTo>
                      <a:pt x="1193800" y="320675"/>
                    </a:lnTo>
                    <a:cubicBezTo>
                      <a:pt x="1194858" y="282575"/>
                      <a:pt x="1195917" y="244475"/>
                      <a:pt x="1196975" y="206375"/>
                    </a:cubicBezTo>
                    <a:lnTo>
                      <a:pt x="1216025" y="400050"/>
                    </a:lnTo>
                    <a:lnTo>
                      <a:pt x="1250950" y="536575"/>
                    </a:lnTo>
                    <a:lnTo>
                      <a:pt x="1270000" y="263525"/>
                    </a:lnTo>
                    <a:lnTo>
                      <a:pt x="1279525" y="393700"/>
                    </a:lnTo>
                    <a:lnTo>
                      <a:pt x="1285875" y="260350"/>
                    </a:lnTo>
                    <a:lnTo>
                      <a:pt x="1311275" y="650875"/>
                    </a:lnTo>
                    <a:lnTo>
                      <a:pt x="1330325" y="682625"/>
                    </a:lnTo>
                    <a:lnTo>
                      <a:pt x="1346200" y="349250"/>
                    </a:lnTo>
                    <a:lnTo>
                      <a:pt x="1365250" y="282575"/>
                    </a:lnTo>
                    <a:lnTo>
                      <a:pt x="1377950" y="536575"/>
                    </a:lnTo>
                    <a:lnTo>
                      <a:pt x="1390650" y="473075"/>
                    </a:lnTo>
                    <a:lnTo>
                      <a:pt x="1406525" y="584200"/>
                    </a:lnTo>
                    <a:lnTo>
                      <a:pt x="1416050" y="460375"/>
                    </a:lnTo>
                    <a:lnTo>
                      <a:pt x="1428750" y="669925"/>
                    </a:lnTo>
                    <a:lnTo>
                      <a:pt x="1444625" y="454025"/>
                    </a:lnTo>
                    <a:lnTo>
                      <a:pt x="1463675" y="536575"/>
                    </a:lnTo>
                    <a:lnTo>
                      <a:pt x="1485900" y="260350"/>
                    </a:lnTo>
                    <a:lnTo>
                      <a:pt x="1501775" y="323850"/>
                    </a:lnTo>
                    <a:cubicBezTo>
                      <a:pt x="1502833" y="364067"/>
                      <a:pt x="1503892" y="404283"/>
                      <a:pt x="1504950" y="444500"/>
                    </a:cubicBezTo>
                    <a:lnTo>
                      <a:pt x="1520825" y="603250"/>
                    </a:lnTo>
                    <a:lnTo>
                      <a:pt x="1533525" y="638175"/>
                    </a:lnTo>
                    <a:lnTo>
                      <a:pt x="1546225" y="422275"/>
                    </a:lnTo>
                    <a:lnTo>
                      <a:pt x="1549400" y="450850"/>
                    </a:lnTo>
                    <a:lnTo>
                      <a:pt x="1562100" y="368300"/>
                    </a:lnTo>
                    <a:lnTo>
                      <a:pt x="1574800" y="508000"/>
                    </a:lnTo>
                    <a:lnTo>
                      <a:pt x="1584325" y="831850"/>
                    </a:lnTo>
                    <a:lnTo>
                      <a:pt x="1593850" y="908050"/>
                    </a:lnTo>
                    <a:lnTo>
                      <a:pt x="1606550" y="850900"/>
                    </a:lnTo>
                    <a:lnTo>
                      <a:pt x="1622425" y="895350"/>
                    </a:lnTo>
                    <a:lnTo>
                      <a:pt x="1641475" y="555625"/>
                    </a:lnTo>
                    <a:lnTo>
                      <a:pt x="1657350" y="171450"/>
                    </a:lnTo>
                    <a:lnTo>
                      <a:pt x="1679575" y="368300"/>
                    </a:lnTo>
                    <a:lnTo>
                      <a:pt x="1685925" y="311150"/>
                    </a:lnTo>
                    <a:lnTo>
                      <a:pt x="1701800" y="368300"/>
                    </a:lnTo>
                    <a:lnTo>
                      <a:pt x="1714500" y="206375"/>
                    </a:lnTo>
                    <a:lnTo>
                      <a:pt x="1739900" y="384175"/>
                    </a:lnTo>
                    <a:lnTo>
                      <a:pt x="1762125" y="479425"/>
                    </a:lnTo>
                    <a:cubicBezTo>
                      <a:pt x="1763183" y="441325"/>
                      <a:pt x="1764242" y="403225"/>
                      <a:pt x="1765300" y="365125"/>
                    </a:cubicBezTo>
                    <a:lnTo>
                      <a:pt x="1790700" y="444500"/>
                    </a:lnTo>
                    <a:lnTo>
                      <a:pt x="1803400" y="393700"/>
                    </a:lnTo>
                    <a:lnTo>
                      <a:pt x="1816100" y="539750"/>
                    </a:lnTo>
                    <a:lnTo>
                      <a:pt x="1825625" y="485775"/>
                    </a:lnTo>
                    <a:lnTo>
                      <a:pt x="1851025" y="577850"/>
                    </a:lnTo>
                    <a:lnTo>
                      <a:pt x="1851025" y="457200"/>
                    </a:lnTo>
                    <a:lnTo>
                      <a:pt x="1866900" y="396875"/>
                    </a:lnTo>
                    <a:cubicBezTo>
                      <a:pt x="1867958" y="449792"/>
                      <a:pt x="1869017" y="502708"/>
                      <a:pt x="1870075" y="555625"/>
                    </a:cubicBezTo>
                    <a:lnTo>
                      <a:pt x="1885950" y="409575"/>
                    </a:lnTo>
                    <a:lnTo>
                      <a:pt x="1889125" y="488950"/>
                    </a:lnTo>
                    <a:lnTo>
                      <a:pt x="1901825" y="460375"/>
                    </a:lnTo>
                    <a:lnTo>
                      <a:pt x="1914525" y="520700"/>
                    </a:lnTo>
                  </a:path>
                </a:pathLst>
              </a:cu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4" name="TextBox 113">
                <a:extLst>
                  <a:ext uri="{FF2B5EF4-FFF2-40B4-BE49-F238E27FC236}">
                    <a16:creationId xmlns:a16="http://schemas.microsoft.com/office/drawing/2014/main" id="{B51A7C2F-72F8-2442-AE38-1203FC2AFC1A}"/>
                  </a:ext>
                </a:extLst>
              </p:cNvPr>
              <p:cNvSpPr txBox="1"/>
              <p:nvPr/>
            </p:nvSpPr>
            <p:spPr>
              <a:xfrm>
                <a:off x="4248180" y="4767370"/>
                <a:ext cx="242374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400" dirty="0">
                    <a:latin typeface="Arial" panose="020B0604020202020204" pitchFamily="34" charset="0"/>
                    <a:cs typeface="Arial" panose="020B0604020202020204" pitchFamily="34" charset="0"/>
                  </a:rPr>
                  <a:t>62</a:t>
                </a:r>
              </a:p>
            </p:txBody>
          </p:sp>
          <p:sp>
            <p:nvSpPr>
              <p:cNvPr id="81" name="Rectangle 80">
                <a:extLst>
                  <a:ext uri="{FF2B5EF4-FFF2-40B4-BE49-F238E27FC236}">
                    <a16:creationId xmlns:a16="http://schemas.microsoft.com/office/drawing/2014/main" id="{3DA73ACD-93DC-E249-831A-75567B41F27F}"/>
                  </a:ext>
                </a:extLst>
              </p:cNvPr>
              <p:cNvSpPr/>
              <p:nvPr/>
            </p:nvSpPr>
            <p:spPr>
              <a:xfrm>
                <a:off x="3116272" y="5376614"/>
                <a:ext cx="805043" cy="70379"/>
              </a:xfrm>
              <a:prstGeom prst="rect">
                <a:avLst/>
              </a:prstGeom>
              <a:solidFill>
                <a:schemeClr val="accent5"/>
              </a:solidFill>
              <a:ln w="3175">
                <a:solidFill>
                  <a:schemeClr val="accent5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" name="Rectangle 81">
                <a:extLst>
                  <a:ext uri="{FF2B5EF4-FFF2-40B4-BE49-F238E27FC236}">
                    <a16:creationId xmlns:a16="http://schemas.microsoft.com/office/drawing/2014/main" id="{0C51CB31-E28F-8444-AF7B-1FCC14D96B8A}"/>
                  </a:ext>
                </a:extLst>
              </p:cNvPr>
              <p:cNvSpPr/>
              <p:nvPr/>
            </p:nvSpPr>
            <p:spPr>
              <a:xfrm>
                <a:off x="3959134" y="5375026"/>
                <a:ext cx="220764" cy="73554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3175">
                <a:solidFill>
                  <a:schemeClr val="bg1">
                    <a:lumMod val="6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Rectangle 82">
                <a:extLst>
                  <a:ext uri="{FF2B5EF4-FFF2-40B4-BE49-F238E27FC236}">
                    <a16:creationId xmlns:a16="http://schemas.microsoft.com/office/drawing/2014/main" id="{7A6C77BE-1A21-C240-A116-5B50AB0D8E11}"/>
                  </a:ext>
                </a:extLst>
              </p:cNvPr>
              <p:cNvSpPr/>
              <p:nvPr/>
            </p:nvSpPr>
            <p:spPr>
              <a:xfrm>
                <a:off x="2681297" y="5375026"/>
                <a:ext cx="312114" cy="73554"/>
              </a:xfrm>
              <a:prstGeom prst="rect">
                <a:avLst/>
              </a:prstGeom>
              <a:solidFill>
                <a:schemeClr val="accent4"/>
              </a:solidFill>
              <a:ln w="3175">
                <a:solidFill>
                  <a:schemeClr val="accent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" name="Rectangle 83">
                <a:extLst>
                  <a:ext uri="{FF2B5EF4-FFF2-40B4-BE49-F238E27FC236}">
                    <a16:creationId xmlns:a16="http://schemas.microsoft.com/office/drawing/2014/main" id="{48D64FC1-5B48-DD4A-B0FD-4737BF7908BF}"/>
                  </a:ext>
                </a:extLst>
              </p:cNvPr>
              <p:cNvSpPr/>
              <p:nvPr/>
            </p:nvSpPr>
            <p:spPr>
              <a:xfrm>
                <a:off x="2398722" y="5375026"/>
                <a:ext cx="208867" cy="73554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3175">
                <a:solidFill>
                  <a:schemeClr val="bg1">
                    <a:lumMod val="6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2" name="Triangle 141">
                <a:extLst>
                  <a:ext uri="{FF2B5EF4-FFF2-40B4-BE49-F238E27FC236}">
                    <a16:creationId xmlns:a16="http://schemas.microsoft.com/office/drawing/2014/main" id="{18AAE49B-81B8-CA48-98B4-022AB8ABC4D3}"/>
                  </a:ext>
                </a:extLst>
              </p:cNvPr>
              <p:cNvSpPr/>
              <p:nvPr/>
            </p:nvSpPr>
            <p:spPr>
              <a:xfrm rot="5400000">
                <a:off x="4143380" y="5375803"/>
                <a:ext cx="128588" cy="72000"/>
              </a:xfrm>
              <a:prstGeom prst="triangle">
                <a:avLst/>
              </a:prstGeom>
              <a:solidFill>
                <a:schemeClr val="bg1">
                  <a:lumMod val="65000"/>
                </a:schemeClr>
              </a:solidFill>
              <a:ln w="3175">
                <a:solidFill>
                  <a:schemeClr val="bg1">
                    <a:lumMod val="6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3" name="Triangle 142">
                <a:extLst>
                  <a:ext uri="{FF2B5EF4-FFF2-40B4-BE49-F238E27FC236}">
                    <a16:creationId xmlns:a16="http://schemas.microsoft.com/office/drawing/2014/main" id="{48F45BB6-79C4-5549-872F-FE5F60DDEC56}"/>
                  </a:ext>
                </a:extLst>
              </p:cNvPr>
              <p:cNvSpPr/>
              <p:nvPr/>
            </p:nvSpPr>
            <p:spPr>
              <a:xfrm rot="16200000">
                <a:off x="3019430" y="5375804"/>
                <a:ext cx="128588" cy="72000"/>
              </a:xfrm>
              <a:prstGeom prst="triangle">
                <a:avLst/>
              </a:prstGeom>
              <a:solidFill>
                <a:schemeClr val="accent5"/>
              </a:solidFill>
              <a:ln w="3175">
                <a:solidFill>
                  <a:schemeClr val="accent5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4" name="Triangle 143">
                <a:extLst>
                  <a:ext uri="{FF2B5EF4-FFF2-40B4-BE49-F238E27FC236}">
                    <a16:creationId xmlns:a16="http://schemas.microsoft.com/office/drawing/2014/main" id="{9651DBDE-29FF-3645-916D-882FA29EB933}"/>
                  </a:ext>
                </a:extLst>
              </p:cNvPr>
              <p:cNvSpPr/>
              <p:nvPr/>
            </p:nvSpPr>
            <p:spPr>
              <a:xfrm rot="16200000">
                <a:off x="2584455" y="5375804"/>
                <a:ext cx="128588" cy="72000"/>
              </a:xfrm>
              <a:prstGeom prst="triangle">
                <a:avLst/>
              </a:prstGeom>
              <a:solidFill>
                <a:schemeClr val="accent4"/>
              </a:solidFill>
              <a:ln w="3175">
                <a:solidFill>
                  <a:schemeClr val="accent4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5" name="Triangle 144">
                <a:extLst>
                  <a:ext uri="{FF2B5EF4-FFF2-40B4-BE49-F238E27FC236}">
                    <a16:creationId xmlns:a16="http://schemas.microsoft.com/office/drawing/2014/main" id="{BCBCE70B-F5D4-9C48-A8A4-7B7F646EDBDF}"/>
                  </a:ext>
                </a:extLst>
              </p:cNvPr>
              <p:cNvSpPr/>
              <p:nvPr/>
            </p:nvSpPr>
            <p:spPr>
              <a:xfrm rot="16200000">
                <a:off x="2298705" y="5375804"/>
                <a:ext cx="128588" cy="72000"/>
              </a:xfrm>
              <a:prstGeom prst="triangle">
                <a:avLst/>
              </a:prstGeom>
              <a:solidFill>
                <a:schemeClr val="bg1">
                  <a:lumMod val="65000"/>
                </a:schemeClr>
              </a:solidFill>
              <a:ln w="3175">
                <a:solidFill>
                  <a:schemeClr val="bg1">
                    <a:lumMod val="6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Rectangle 9">
                <a:extLst>
                  <a:ext uri="{FF2B5EF4-FFF2-40B4-BE49-F238E27FC236}">
                    <a16:creationId xmlns:a16="http://schemas.microsoft.com/office/drawing/2014/main" id="{5EC159AB-CA50-2841-B5DC-F988D84C6B45}"/>
                  </a:ext>
                </a:extLst>
              </p:cNvPr>
              <p:cNvSpPr/>
              <p:nvPr/>
            </p:nvSpPr>
            <p:spPr>
              <a:xfrm>
                <a:off x="2233839" y="4306279"/>
                <a:ext cx="388307" cy="71720"/>
              </a:xfrm>
              <a:prstGeom prst="rect">
                <a:avLst/>
              </a:prstGeom>
              <a:solidFill>
                <a:schemeClr val="bg1"/>
              </a:solidFill>
              <a:ln w="63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9" name="Rectangle 98">
                <a:extLst>
                  <a:ext uri="{FF2B5EF4-FFF2-40B4-BE49-F238E27FC236}">
                    <a16:creationId xmlns:a16="http://schemas.microsoft.com/office/drawing/2014/main" id="{7C7D465F-9036-7D45-B1FC-071BB5B30AF3}"/>
                  </a:ext>
                </a:extLst>
              </p:cNvPr>
              <p:cNvSpPr/>
              <p:nvPr/>
            </p:nvSpPr>
            <p:spPr>
              <a:xfrm>
                <a:off x="2324007" y="4378935"/>
                <a:ext cx="1946393" cy="1134319"/>
              </a:xfrm>
              <a:prstGeom prst="rect">
                <a:avLst/>
              </a:prstGeom>
              <a:noFill/>
              <a:ln w="6350"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1" name="TextBox 90">
                <a:extLst>
                  <a:ext uri="{FF2B5EF4-FFF2-40B4-BE49-F238E27FC236}">
                    <a16:creationId xmlns:a16="http://schemas.microsoft.com/office/drawing/2014/main" id="{CECDEAD7-0A93-944A-925D-77F91C19A0FA}"/>
                  </a:ext>
                </a:extLst>
              </p:cNvPr>
              <p:cNvSpPr txBox="1"/>
              <p:nvPr/>
            </p:nvSpPr>
            <p:spPr>
              <a:xfrm>
                <a:off x="2676424" y="5216579"/>
                <a:ext cx="33374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5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apE</a:t>
                </a:r>
                <a:endParaRPr lang="en-GB" sz="5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5" name="TextBox 94">
                <a:extLst>
                  <a:ext uri="{FF2B5EF4-FFF2-40B4-BE49-F238E27FC236}">
                    <a16:creationId xmlns:a16="http://schemas.microsoft.com/office/drawing/2014/main" id="{3AD0CA06-5A86-3F46-8C44-C9A5B84603E4}"/>
                  </a:ext>
                </a:extLst>
              </p:cNvPr>
              <p:cNvSpPr txBox="1"/>
              <p:nvPr/>
            </p:nvSpPr>
            <p:spPr>
              <a:xfrm>
                <a:off x="3339929" y="5216579"/>
                <a:ext cx="38183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5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orphan</a:t>
                </a:r>
              </a:p>
            </p:txBody>
          </p:sp>
        </p:grpSp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D157F4A4-F525-4843-9819-7BE051470A22}"/>
                </a:ext>
              </a:extLst>
            </p:cNvPr>
            <p:cNvGrpSpPr/>
            <p:nvPr/>
          </p:nvGrpSpPr>
          <p:grpSpPr>
            <a:xfrm>
              <a:off x="2322707" y="6307297"/>
              <a:ext cx="2166547" cy="1283344"/>
              <a:chOff x="2322707" y="3103403"/>
              <a:chExt cx="2166547" cy="1283344"/>
            </a:xfrm>
          </p:grpSpPr>
          <p:grpSp>
            <p:nvGrpSpPr>
              <p:cNvPr id="11" name="Group 10">
                <a:extLst>
                  <a:ext uri="{FF2B5EF4-FFF2-40B4-BE49-F238E27FC236}">
                    <a16:creationId xmlns:a16="http://schemas.microsoft.com/office/drawing/2014/main" id="{C2C72C6C-949C-8C4C-821A-1FCDC1A531CF}"/>
                  </a:ext>
                </a:extLst>
              </p:cNvPr>
              <p:cNvGrpSpPr/>
              <p:nvPr/>
            </p:nvGrpSpPr>
            <p:grpSpPr>
              <a:xfrm>
                <a:off x="2322707" y="3103403"/>
                <a:ext cx="2166547" cy="1283344"/>
                <a:chOff x="3065360" y="3460677"/>
                <a:chExt cx="2166547" cy="1283344"/>
              </a:xfrm>
            </p:grpSpPr>
            <p:sp>
              <p:nvSpPr>
                <p:cNvPr id="106" name="Rectangle 105">
                  <a:extLst>
                    <a:ext uri="{FF2B5EF4-FFF2-40B4-BE49-F238E27FC236}">
                      <a16:creationId xmlns:a16="http://schemas.microsoft.com/office/drawing/2014/main" id="{7C10B22E-6697-F245-B842-597ABA8606C6}"/>
                    </a:ext>
                  </a:extLst>
                </p:cNvPr>
                <p:cNvSpPr/>
                <p:nvPr/>
              </p:nvSpPr>
              <p:spPr>
                <a:xfrm>
                  <a:off x="3065360" y="3528350"/>
                  <a:ext cx="1946393" cy="1134319"/>
                </a:xfrm>
                <a:prstGeom prst="rect">
                  <a:avLst/>
                </a:prstGeom>
                <a:noFill/>
                <a:ln w="6350"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23" name="Straight Connector 122">
                  <a:extLst>
                    <a:ext uri="{FF2B5EF4-FFF2-40B4-BE49-F238E27FC236}">
                      <a16:creationId xmlns:a16="http://schemas.microsoft.com/office/drawing/2014/main" id="{8604DA61-5E80-5347-B9A6-785FA002932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013325" y="3527425"/>
                  <a:ext cx="36000" cy="0"/>
                </a:xfrm>
                <a:prstGeom prst="line">
                  <a:avLst/>
                </a:prstGeom>
                <a:ln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4" name="Straight Connector 123">
                  <a:extLst>
                    <a:ext uri="{FF2B5EF4-FFF2-40B4-BE49-F238E27FC236}">
                      <a16:creationId xmlns:a16="http://schemas.microsoft.com/office/drawing/2014/main" id="{FB862963-A898-F048-9CAC-09A94874D9C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013325" y="4022725"/>
                  <a:ext cx="36000" cy="0"/>
                </a:xfrm>
                <a:prstGeom prst="line">
                  <a:avLst/>
                </a:prstGeom>
                <a:ln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5" name="Straight Connector 124">
                  <a:extLst>
                    <a:ext uri="{FF2B5EF4-FFF2-40B4-BE49-F238E27FC236}">
                      <a16:creationId xmlns:a16="http://schemas.microsoft.com/office/drawing/2014/main" id="{7CD4BDAD-5A55-1643-B1F7-92B57FAC2C2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013325" y="4664075"/>
                  <a:ext cx="36000" cy="0"/>
                </a:xfrm>
                <a:prstGeom prst="line">
                  <a:avLst/>
                </a:prstGeom>
                <a:ln>
                  <a:solidFill>
                    <a:schemeClr val="bg1">
                      <a:lumMod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9" name="Group 8">
                  <a:extLst>
                    <a:ext uri="{FF2B5EF4-FFF2-40B4-BE49-F238E27FC236}">
                      <a16:creationId xmlns:a16="http://schemas.microsoft.com/office/drawing/2014/main" id="{AA7BA9FC-6B9E-CA46-95BF-C75F41875E6B}"/>
                    </a:ext>
                  </a:extLst>
                </p:cNvPr>
                <p:cNvGrpSpPr/>
                <p:nvPr/>
              </p:nvGrpSpPr>
              <p:grpSpPr>
                <a:xfrm>
                  <a:off x="3066415" y="3460677"/>
                  <a:ext cx="2165492" cy="1283344"/>
                  <a:chOff x="3066415" y="3460677"/>
                  <a:chExt cx="2165492" cy="1283344"/>
                </a:xfrm>
              </p:grpSpPr>
              <p:cxnSp>
                <p:nvCxnSpPr>
                  <p:cNvPr id="65" name="Straight Connector 64">
                    <a:extLst>
                      <a:ext uri="{FF2B5EF4-FFF2-40B4-BE49-F238E27FC236}">
                        <a16:creationId xmlns:a16="http://schemas.microsoft.com/office/drawing/2014/main" id="{1FE6474C-B059-3C49-8A32-F47F077DE6B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3066415" y="4021494"/>
                    <a:ext cx="1944000" cy="0"/>
                  </a:xfrm>
                  <a:prstGeom prst="line">
                    <a:avLst/>
                  </a:prstGeom>
                  <a:ln w="6350">
                    <a:solidFill>
                      <a:schemeClr val="bg1">
                        <a:lumMod val="50000"/>
                      </a:schemeClr>
                    </a:solidFill>
                    <a:prstDash val="sysDash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7" name="Freeform 36">
                    <a:extLst>
                      <a:ext uri="{FF2B5EF4-FFF2-40B4-BE49-F238E27FC236}">
                        <a16:creationId xmlns:a16="http://schemas.microsoft.com/office/drawing/2014/main" id="{22DCED95-473C-CD43-9EF9-95773E0292A9}"/>
                      </a:ext>
                    </a:extLst>
                  </p:cNvPr>
                  <p:cNvSpPr/>
                  <p:nvPr/>
                </p:nvSpPr>
                <p:spPr>
                  <a:xfrm>
                    <a:off x="3076575" y="3546279"/>
                    <a:ext cx="1939925" cy="930977"/>
                  </a:xfrm>
                  <a:custGeom>
                    <a:avLst/>
                    <a:gdLst>
                      <a:gd name="connsiteX0" fmla="*/ 0 w 1946275"/>
                      <a:gd name="connsiteY0" fmla="*/ 558800 h 850900"/>
                      <a:gd name="connsiteX1" fmla="*/ 12700 w 1946275"/>
                      <a:gd name="connsiteY1" fmla="*/ 695325 h 850900"/>
                      <a:gd name="connsiteX2" fmla="*/ 34925 w 1946275"/>
                      <a:gd name="connsiteY2" fmla="*/ 244475 h 850900"/>
                      <a:gd name="connsiteX3" fmla="*/ 41275 w 1946275"/>
                      <a:gd name="connsiteY3" fmla="*/ 279400 h 850900"/>
                      <a:gd name="connsiteX4" fmla="*/ 47625 w 1946275"/>
                      <a:gd name="connsiteY4" fmla="*/ 228600 h 850900"/>
                      <a:gd name="connsiteX5" fmla="*/ 57150 w 1946275"/>
                      <a:gd name="connsiteY5" fmla="*/ 273050 h 850900"/>
                      <a:gd name="connsiteX6" fmla="*/ 79375 w 1946275"/>
                      <a:gd name="connsiteY6" fmla="*/ 539750 h 850900"/>
                      <a:gd name="connsiteX7" fmla="*/ 95250 w 1946275"/>
                      <a:gd name="connsiteY7" fmla="*/ 330200 h 850900"/>
                      <a:gd name="connsiteX8" fmla="*/ 101600 w 1946275"/>
                      <a:gd name="connsiteY8" fmla="*/ 358775 h 850900"/>
                      <a:gd name="connsiteX9" fmla="*/ 114300 w 1946275"/>
                      <a:gd name="connsiteY9" fmla="*/ 231775 h 850900"/>
                      <a:gd name="connsiteX10" fmla="*/ 114300 w 1946275"/>
                      <a:gd name="connsiteY10" fmla="*/ 231775 h 850900"/>
                      <a:gd name="connsiteX11" fmla="*/ 127000 w 1946275"/>
                      <a:gd name="connsiteY11" fmla="*/ 206375 h 850900"/>
                      <a:gd name="connsiteX12" fmla="*/ 136525 w 1946275"/>
                      <a:gd name="connsiteY12" fmla="*/ 336550 h 850900"/>
                      <a:gd name="connsiteX13" fmla="*/ 142875 w 1946275"/>
                      <a:gd name="connsiteY13" fmla="*/ 254000 h 850900"/>
                      <a:gd name="connsiteX14" fmla="*/ 149225 w 1946275"/>
                      <a:gd name="connsiteY14" fmla="*/ 260350 h 850900"/>
                      <a:gd name="connsiteX15" fmla="*/ 168275 w 1946275"/>
                      <a:gd name="connsiteY15" fmla="*/ 114300 h 850900"/>
                      <a:gd name="connsiteX16" fmla="*/ 171450 w 1946275"/>
                      <a:gd name="connsiteY16" fmla="*/ 177800 h 850900"/>
                      <a:gd name="connsiteX17" fmla="*/ 177800 w 1946275"/>
                      <a:gd name="connsiteY17" fmla="*/ 136525 h 850900"/>
                      <a:gd name="connsiteX18" fmla="*/ 190500 w 1946275"/>
                      <a:gd name="connsiteY18" fmla="*/ 38100 h 850900"/>
                      <a:gd name="connsiteX19" fmla="*/ 200025 w 1946275"/>
                      <a:gd name="connsiteY19" fmla="*/ 57150 h 850900"/>
                      <a:gd name="connsiteX20" fmla="*/ 209550 w 1946275"/>
                      <a:gd name="connsiteY20" fmla="*/ 0 h 850900"/>
                      <a:gd name="connsiteX21" fmla="*/ 225425 w 1946275"/>
                      <a:gd name="connsiteY21" fmla="*/ 228600 h 850900"/>
                      <a:gd name="connsiteX22" fmla="*/ 225425 w 1946275"/>
                      <a:gd name="connsiteY22" fmla="*/ 228600 h 850900"/>
                      <a:gd name="connsiteX23" fmla="*/ 250825 w 1946275"/>
                      <a:gd name="connsiteY23" fmla="*/ 209550 h 850900"/>
                      <a:gd name="connsiteX24" fmla="*/ 263525 w 1946275"/>
                      <a:gd name="connsiteY24" fmla="*/ 266700 h 850900"/>
                      <a:gd name="connsiteX25" fmla="*/ 273050 w 1946275"/>
                      <a:gd name="connsiteY25" fmla="*/ 206375 h 850900"/>
                      <a:gd name="connsiteX26" fmla="*/ 288925 w 1946275"/>
                      <a:gd name="connsiteY26" fmla="*/ 434975 h 850900"/>
                      <a:gd name="connsiteX27" fmla="*/ 317500 w 1946275"/>
                      <a:gd name="connsiteY27" fmla="*/ 206375 h 850900"/>
                      <a:gd name="connsiteX28" fmla="*/ 333375 w 1946275"/>
                      <a:gd name="connsiteY28" fmla="*/ 273050 h 850900"/>
                      <a:gd name="connsiteX29" fmla="*/ 349250 w 1946275"/>
                      <a:gd name="connsiteY29" fmla="*/ 193675 h 850900"/>
                      <a:gd name="connsiteX30" fmla="*/ 358775 w 1946275"/>
                      <a:gd name="connsiteY30" fmla="*/ 301625 h 850900"/>
                      <a:gd name="connsiteX31" fmla="*/ 371475 w 1946275"/>
                      <a:gd name="connsiteY31" fmla="*/ 209550 h 850900"/>
                      <a:gd name="connsiteX32" fmla="*/ 384175 w 1946275"/>
                      <a:gd name="connsiteY32" fmla="*/ 434975 h 850900"/>
                      <a:gd name="connsiteX33" fmla="*/ 396875 w 1946275"/>
                      <a:gd name="connsiteY33" fmla="*/ 371475 h 850900"/>
                      <a:gd name="connsiteX34" fmla="*/ 415925 w 1946275"/>
                      <a:gd name="connsiteY34" fmla="*/ 473075 h 850900"/>
                      <a:gd name="connsiteX35" fmla="*/ 425450 w 1946275"/>
                      <a:gd name="connsiteY35" fmla="*/ 304800 h 850900"/>
                      <a:gd name="connsiteX36" fmla="*/ 438150 w 1946275"/>
                      <a:gd name="connsiteY36" fmla="*/ 336550 h 850900"/>
                      <a:gd name="connsiteX37" fmla="*/ 460375 w 1946275"/>
                      <a:gd name="connsiteY37" fmla="*/ 146050 h 850900"/>
                      <a:gd name="connsiteX38" fmla="*/ 466725 w 1946275"/>
                      <a:gd name="connsiteY38" fmla="*/ 266700 h 850900"/>
                      <a:gd name="connsiteX39" fmla="*/ 473075 w 1946275"/>
                      <a:gd name="connsiteY39" fmla="*/ 234950 h 850900"/>
                      <a:gd name="connsiteX40" fmla="*/ 485775 w 1946275"/>
                      <a:gd name="connsiteY40" fmla="*/ 276225 h 850900"/>
                      <a:gd name="connsiteX41" fmla="*/ 501650 w 1946275"/>
                      <a:gd name="connsiteY41" fmla="*/ 250825 h 850900"/>
                      <a:gd name="connsiteX42" fmla="*/ 514350 w 1946275"/>
                      <a:gd name="connsiteY42" fmla="*/ 342900 h 850900"/>
                      <a:gd name="connsiteX43" fmla="*/ 530225 w 1946275"/>
                      <a:gd name="connsiteY43" fmla="*/ 260350 h 850900"/>
                      <a:gd name="connsiteX44" fmla="*/ 533400 w 1946275"/>
                      <a:gd name="connsiteY44" fmla="*/ 336550 h 850900"/>
                      <a:gd name="connsiteX45" fmla="*/ 555625 w 1946275"/>
                      <a:gd name="connsiteY45" fmla="*/ 257175 h 850900"/>
                      <a:gd name="connsiteX46" fmla="*/ 558800 w 1946275"/>
                      <a:gd name="connsiteY46" fmla="*/ 317500 h 850900"/>
                      <a:gd name="connsiteX47" fmla="*/ 584200 w 1946275"/>
                      <a:gd name="connsiteY47" fmla="*/ 263525 h 850900"/>
                      <a:gd name="connsiteX48" fmla="*/ 587375 w 1946275"/>
                      <a:gd name="connsiteY48" fmla="*/ 336550 h 850900"/>
                      <a:gd name="connsiteX49" fmla="*/ 600075 w 1946275"/>
                      <a:gd name="connsiteY49" fmla="*/ 301625 h 850900"/>
                      <a:gd name="connsiteX50" fmla="*/ 600075 w 1946275"/>
                      <a:gd name="connsiteY50" fmla="*/ 333375 h 850900"/>
                      <a:gd name="connsiteX51" fmla="*/ 619125 w 1946275"/>
                      <a:gd name="connsiteY51" fmla="*/ 304800 h 850900"/>
                      <a:gd name="connsiteX52" fmla="*/ 622300 w 1946275"/>
                      <a:gd name="connsiteY52" fmla="*/ 361950 h 850900"/>
                      <a:gd name="connsiteX53" fmla="*/ 641350 w 1946275"/>
                      <a:gd name="connsiteY53" fmla="*/ 190500 h 850900"/>
                      <a:gd name="connsiteX54" fmla="*/ 676275 w 1946275"/>
                      <a:gd name="connsiteY54" fmla="*/ 609600 h 850900"/>
                      <a:gd name="connsiteX55" fmla="*/ 692150 w 1946275"/>
                      <a:gd name="connsiteY55" fmla="*/ 571500 h 850900"/>
                      <a:gd name="connsiteX56" fmla="*/ 688975 w 1946275"/>
                      <a:gd name="connsiteY56" fmla="*/ 600075 h 850900"/>
                      <a:gd name="connsiteX57" fmla="*/ 704850 w 1946275"/>
                      <a:gd name="connsiteY57" fmla="*/ 485775 h 850900"/>
                      <a:gd name="connsiteX58" fmla="*/ 714375 w 1946275"/>
                      <a:gd name="connsiteY58" fmla="*/ 571500 h 850900"/>
                      <a:gd name="connsiteX59" fmla="*/ 723900 w 1946275"/>
                      <a:gd name="connsiteY59" fmla="*/ 504825 h 850900"/>
                      <a:gd name="connsiteX60" fmla="*/ 730250 w 1946275"/>
                      <a:gd name="connsiteY60" fmla="*/ 565150 h 850900"/>
                      <a:gd name="connsiteX61" fmla="*/ 739775 w 1946275"/>
                      <a:gd name="connsiteY61" fmla="*/ 520700 h 850900"/>
                      <a:gd name="connsiteX62" fmla="*/ 752475 w 1946275"/>
                      <a:gd name="connsiteY62" fmla="*/ 355600 h 850900"/>
                      <a:gd name="connsiteX63" fmla="*/ 765175 w 1946275"/>
                      <a:gd name="connsiteY63" fmla="*/ 361950 h 850900"/>
                      <a:gd name="connsiteX64" fmla="*/ 771525 w 1946275"/>
                      <a:gd name="connsiteY64" fmla="*/ 406400 h 850900"/>
                      <a:gd name="connsiteX65" fmla="*/ 790575 w 1946275"/>
                      <a:gd name="connsiteY65" fmla="*/ 549275 h 850900"/>
                      <a:gd name="connsiteX66" fmla="*/ 803275 w 1946275"/>
                      <a:gd name="connsiteY66" fmla="*/ 581025 h 850900"/>
                      <a:gd name="connsiteX67" fmla="*/ 815975 w 1946275"/>
                      <a:gd name="connsiteY67" fmla="*/ 768350 h 850900"/>
                      <a:gd name="connsiteX68" fmla="*/ 825500 w 1946275"/>
                      <a:gd name="connsiteY68" fmla="*/ 752475 h 850900"/>
                      <a:gd name="connsiteX69" fmla="*/ 835025 w 1946275"/>
                      <a:gd name="connsiteY69" fmla="*/ 803275 h 850900"/>
                      <a:gd name="connsiteX70" fmla="*/ 844550 w 1946275"/>
                      <a:gd name="connsiteY70" fmla="*/ 850900 h 850900"/>
                      <a:gd name="connsiteX71" fmla="*/ 860425 w 1946275"/>
                      <a:gd name="connsiteY71" fmla="*/ 663575 h 850900"/>
                      <a:gd name="connsiteX72" fmla="*/ 860425 w 1946275"/>
                      <a:gd name="connsiteY72" fmla="*/ 701675 h 850900"/>
                      <a:gd name="connsiteX73" fmla="*/ 869950 w 1946275"/>
                      <a:gd name="connsiteY73" fmla="*/ 609600 h 850900"/>
                      <a:gd name="connsiteX74" fmla="*/ 885825 w 1946275"/>
                      <a:gd name="connsiteY74" fmla="*/ 647700 h 850900"/>
                      <a:gd name="connsiteX75" fmla="*/ 892175 w 1946275"/>
                      <a:gd name="connsiteY75" fmla="*/ 549275 h 850900"/>
                      <a:gd name="connsiteX76" fmla="*/ 908050 w 1946275"/>
                      <a:gd name="connsiteY76" fmla="*/ 688975 h 850900"/>
                      <a:gd name="connsiteX77" fmla="*/ 927100 w 1946275"/>
                      <a:gd name="connsiteY77" fmla="*/ 619125 h 850900"/>
                      <a:gd name="connsiteX78" fmla="*/ 939800 w 1946275"/>
                      <a:gd name="connsiteY78" fmla="*/ 444500 h 850900"/>
                      <a:gd name="connsiteX79" fmla="*/ 962025 w 1946275"/>
                      <a:gd name="connsiteY79" fmla="*/ 425450 h 850900"/>
                      <a:gd name="connsiteX80" fmla="*/ 974725 w 1946275"/>
                      <a:gd name="connsiteY80" fmla="*/ 619125 h 850900"/>
                      <a:gd name="connsiteX81" fmla="*/ 984250 w 1946275"/>
                      <a:gd name="connsiteY81" fmla="*/ 581025 h 850900"/>
                      <a:gd name="connsiteX82" fmla="*/ 996950 w 1946275"/>
                      <a:gd name="connsiteY82" fmla="*/ 619125 h 850900"/>
                      <a:gd name="connsiteX83" fmla="*/ 1009650 w 1946275"/>
                      <a:gd name="connsiteY83" fmla="*/ 498475 h 850900"/>
                      <a:gd name="connsiteX84" fmla="*/ 1022350 w 1946275"/>
                      <a:gd name="connsiteY84" fmla="*/ 628650 h 850900"/>
                      <a:gd name="connsiteX85" fmla="*/ 1044575 w 1946275"/>
                      <a:gd name="connsiteY85" fmla="*/ 536575 h 850900"/>
                      <a:gd name="connsiteX86" fmla="*/ 1057275 w 1946275"/>
                      <a:gd name="connsiteY86" fmla="*/ 552450 h 850900"/>
                      <a:gd name="connsiteX87" fmla="*/ 1063625 w 1946275"/>
                      <a:gd name="connsiteY87" fmla="*/ 466725 h 850900"/>
                      <a:gd name="connsiteX88" fmla="*/ 1089025 w 1946275"/>
                      <a:gd name="connsiteY88" fmla="*/ 606425 h 850900"/>
                      <a:gd name="connsiteX89" fmla="*/ 1098550 w 1946275"/>
                      <a:gd name="connsiteY89" fmla="*/ 581025 h 850900"/>
                      <a:gd name="connsiteX90" fmla="*/ 1117600 w 1946275"/>
                      <a:gd name="connsiteY90" fmla="*/ 650875 h 850900"/>
                      <a:gd name="connsiteX91" fmla="*/ 1120775 w 1946275"/>
                      <a:gd name="connsiteY91" fmla="*/ 549275 h 850900"/>
                      <a:gd name="connsiteX92" fmla="*/ 1127125 w 1946275"/>
                      <a:gd name="connsiteY92" fmla="*/ 476250 h 850900"/>
                      <a:gd name="connsiteX93" fmla="*/ 1146175 w 1946275"/>
                      <a:gd name="connsiteY93" fmla="*/ 561975 h 850900"/>
                      <a:gd name="connsiteX94" fmla="*/ 1162050 w 1946275"/>
                      <a:gd name="connsiteY94" fmla="*/ 450850 h 850900"/>
                      <a:gd name="connsiteX95" fmla="*/ 1181100 w 1946275"/>
                      <a:gd name="connsiteY95" fmla="*/ 565150 h 850900"/>
                      <a:gd name="connsiteX96" fmla="*/ 1181100 w 1946275"/>
                      <a:gd name="connsiteY96" fmla="*/ 688975 h 850900"/>
                      <a:gd name="connsiteX97" fmla="*/ 1193800 w 1946275"/>
                      <a:gd name="connsiteY97" fmla="*/ 647700 h 850900"/>
                      <a:gd name="connsiteX98" fmla="*/ 1200150 w 1946275"/>
                      <a:gd name="connsiteY98" fmla="*/ 688975 h 850900"/>
                      <a:gd name="connsiteX99" fmla="*/ 1216025 w 1946275"/>
                      <a:gd name="connsiteY99" fmla="*/ 587375 h 850900"/>
                      <a:gd name="connsiteX100" fmla="*/ 1219200 w 1946275"/>
                      <a:gd name="connsiteY100" fmla="*/ 644525 h 850900"/>
                      <a:gd name="connsiteX101" fmla="*/ 1235075 w 1946275"/>
                      <a:gd name="connsiteY101" fmla="*/ 441325 h 850900"/>
                      <a:gd name="connsiteX102" fmla="*/ 1250950 w 1946275"/>
                      <a:gd name="connsiteY102" fmla="*/ 609600 h 850900"/>
                      <a:gd name="connsiteX103" fmla="*/ 1260475 w 1946275"/>
                      <a:gd name="connsiteY103" fmla="*/ 444500 h 850900"/>
                      <a:gd name="connsiteX104" fmla="*/ 1273175 w 1946275"/>
                      <a:gd name="connsiteY104" fmla="*/ 558800 h 850900"/>
                      <a:gd name="connsiteX105" fmla="*/ 1285875 w 1946275"/>
                      <a:gd name="connsiteY105" fmla="*/ 447675 h 850900"/>
                      <a:gd name="connsiteX106" fmla="*/ 1304925 w 1946275"/>
                      <a:gd name="connsiteY106" fmla="*/ 628650 h 850900"/>
                      <a:gd name="connsiteX107" fmla="*/ 1311275 w 1946275"/>
                      <a:gd name="connsiteY107" fmla="*/ 546100 h 850900"/>
                      <a:gd name="connsiteX108" fmla="*/ 1327150 w 1946275"/>
                      <a:gd name="connsiteY108" fmla="*/ 536575 h 850900"/>
                      <a:gd name="connsiteX109" fmla="*/ 1339850 w 1946275"/>
                      <a:gd name="connsiteY109" fmla="*/ 377825 h 850900"/>
                      <a:gd name="connsiteX110" fmla="*/ 1355725 w 1946275"/>
                      <a:gd name="connsiteY110" fmla="*/ 527050 h 850900"/>
                      <a:gd name="connsiteX111" fmla="*/ 1374775 w 1946275"/>
                      <a:gd name="connsiteY111" fmla="*/ 584200 h 850900"/>
                      <a:gd name="connsiteX112" fmla="*/ 1377950 w 1946275"/>
                      <a:gd name="connsiteY112" fmla="*/ 717550 h 850900"/>
                      <a:gd name="connsiteX113" fmla="*/ 1387475 w 1946275"/>
                      <a:gd name="connsiteY113" fmla="*/ 660400 h 850900"/>
                      <a:gd name="connsiteX114" fmla="*/ 1409700 w 1946275"/>
                      <a:gd name="connsiteY114" fmla="*/ 609600 h 850900"/>
                      <a:gd name="connsiteX115" fmla="*/ 1416050 w 1946275"/>
                      <a:gd name="connsiteY115" fmla="*/ 527050 h 850900"/>
                      <a:gd name="connsiteX116" fmla="*/ 1419225 w 1946275"/>
                      <a:gd name="connsiteY116" fmla="*/ 609600 h 850900"/>
                      <a:gd name="connsiteX117" fmla="*/ 1422400 w 1946275"/>
                      <a:gd name="connsiteY117" fmla="*/ 523875 h 850900"/>
                      <a:gd name="connsiteX118" fmla="*/ 1447800 w 1946275"/>
                      <a:gd name="connsiteY118" fmla="*/ 609600 h 850900"/>
                      <a:gd name="connsiteX119" fmla="*/ 1454150 w 1946275"/>
                      <a:gd name="connsiteY119" fmla="*/ 549275 h 850900"/>
                      <a:gd name="connsiteX120" fmla="*/ 1463675 w 1946275"/>
                      <a:gd name="connsiteY120" fmla="*/ 615950 h 850900"/>
                      <a:gd name="connsiteX121" fmla="*/ 1463675 w 1946275"/>
                      <a:gd name="connsiteY121" fmla="*/ 657225 h 850900"/>
                      <a:gd name="connsiteX122" fmla="*/ 1476375 w 1946275"/>
                      <a:gd name="connsiteY122" fmla="*/ 517525 h 850900"/>
                      <a:gd name="connsiteX123" fmla="*/ 1495425 w 1946275"/>
                      <a:gd name="connsiteY123" fmla="*/ 517525 h 850900"/>
                      <a:gd name="connsiteX124" fmla="*/ 1508125 w 1946275"/>
                      <a:gd name="connsiteY124" fmla="*/ 717550 h 850900"/>
                      <a:gd name="connsiteX125" fmla="*/ 1520825 w 1946275"/>
                      <a:gd name="connsiteY125" fmla="*/ 800100 h 850900"/>
                      <a:gd name="connsiteX126" fmla="*/ 1536700 w 1946275"/>
                      <a:gd name="connsiteY126" fmla="*/ 711200 h 850900"/>
                      <a:gd name="connsiteX127" fmla="*/ 1552575 w 1946275"/>
                      <a:gd name="connsiteY127" fmla="*/ 612775 h 850900"/>
                      <a:gd name="connsiteX128" fmla="*/ 1562100 w 1946275"/>
                      <a:gd name="connsiteY128" fmla="*/ 536575 h 850900"/>
                      <a:gd name="connsiteX129" fmla="*/ 1574800 w 1946275"/>
                      <a:gd name="connsiteY129" fmla="*/ 574675 h 850900"/>
                      <a:gd name="connsiteX130" fmla="*/ 1590675 w 1946275"/>
                      <a:gd name="connsiteY130" fmla="*/ 476250 h 850900"/>
                      <a:gd name="connsiteX131" fmla="*/ 1593850 w 1946275"/>
                      <a:gd name="connsiteY131" fmla="*/ 482600 h 850900"/>
                      <a:gd name="connsiteX132" fmla="*/ 1616075 w 1946275"/>
                      <a:gd name="connsiteY132" fmla="*/ 368300 h 850900"/>
                      <a:gd name="connsiteX133" fmla="*/ 1635125 w 1946275"/>
                      <a:gd name="connsiteY133" fmla="*/ 120650 h 850900"/>
                      <a:gd name="connsiteX134" fmla="*/ 1644650 w 1946275"/>
                      <a:gd name="connsiteY134" fmla="*/ 254000 h 850900"/>
                      <a:gd name="connsiteX135" fmla="*/ 1657350 w 1946275"/>
                      <a:gd name="connsiteY135" fmla="*/ 196850 h 850900"/>
                      <a:gd name="connsiteX136" fmla="*/ 1673225 w 1946275"/>
                      <a:gd name="connsiteY136" fmla="*/ 266700 h 850900"/>
                      <a:gd name="connsiteX137" fmla="*/ 1701800 w 1946275"/>
                      <a:gd name="connsiteY137" fmla="*/ 225425 h 850900"/>
                      <a:gd name="connsiteX138" fmla="*/ 1701800 w 1946275"/>
                      <a:gd name="connsiteY138" fmla="*/ 387350 h 850900"/>
                      <a:gd name="connsiteX139" fmla="*/ 1714500 w 1946275"/>
                      <a:gd name="connsiteY139" fmla="*/ 454025 h 850900"/>
                      <a:gd name="connsiteX140" fmla="*/ 1730375 w 1946275"/>
                      <a:gd name="connsiteY140" fmla="*/ 552450 h 850900"/>
                      <a:gd name="connsiteX141" fmla="*/ 1743075 w 1946275"/>
                      <a:gd name="connsiteY141" fmla="*/ 355600 h 850900"/>
                      <a:gd name="connsiteX142" fmla="*/ 1765300 w 1946275"/>
                      <a:gd name="connsiteY142" fmla="*/ 282575 h 850900"/>
                      <a:gd name="connsiteX143" fmla="*/ 1768475 w 1946275"/>
                      <a:gd name="connsiteY143" fmla="*/ 377825 h 850900"/>
                      <a:gd name="connsiteX144" fmla="*/ 1793875 w 1946275"/>
                      <a:gd name="connsiteY144" fmla="*/ 431800 h 850900"/>
                      <a:gd name="connsiteX145" fmla="*/ 1803400 w 1946275"/>
                      <a:gd name="connsiteY145" fmla="*/ 565150 h 850900"/>
                      <a:gd name="connsiteX146" fmla="*/ 1812925 w 1946275"/>
                      <a:gd name="connsiteY146" fmla="*/ 520700 h 850900"/>
                      <a:gd name="connsiteX147" fmla="*/ 1822450 w 1946275"/>
                      <a:gd name="connsiteY147" fmla="*/ 568325 h 850900"/>
                      <a:gd name="connsiteX148" fmla="*/ 1835150 w 1946275"/>
                      <a:gd name="connsiteY148" fmla="*/ 441325 h 850900"/>
                      <a:gd name="connsiteX149" fmla="*/ 1841500 w 1946275"/>
                      <a:gd name="connsiteY149" fmla="*/ 231775 h 850900"/>
                      <a:gd name="connsiteX150" fmla="*/ 1857375 w 1946275"/>
                      <a:gd name="connsiteY150" fmla="*/ 203200 h 850900"/>
                      <a:gd name="connsiteX151" fmla="*/ 1873250 w 1946275"/>
                      <a:gd name="connsiteY151" fmla="*/ 336550 h 850900"/>
                      <a:gd name="connsiteX152" fmla="*/ 1870075 w 1946275"/>
                      <a:gd name="connsiteY152" fmla="*/ 288925 h 850900"/>
                      <a:gd name="connsiteX153" fmla="*/ 1895475 w 1946275"/>
                      <a:gd name="connsiteY153" fmla="*/ 457200 h 850900"/>
                      <a:gd name="connsiteX154" fmla="*/ 1911350 w 1946275"/>
                      <a:gd name="connsiteY154" fmla="*/ 244475 h 850900"/>
                      <a:gd name="connsiteX155" fmla="*/ 1930400 w 1946275"/>
                      <a:gd name="connsiteY155" fmla="*/ 111125 h 850900"/>
                      <a:gd name="connsiteX156" fmla="*/ 1936750 w 1946275"/>
                      <a:gd name="connsiteY156" fmla="*/ 155575 h 850900"/>
                      <a:gd name="connsiteX157" fmla="*/ 1946275 w 1946275"/>
                      <a:gd name="connsiteY157" fmla="*/ 269875 h 850900"/>
                      <a:gd name="connsiteX0" fmla="*/ 0 w 1939925"/>
                      <a:gd name="connsiteY0" fmla="*/ 558800 h 850900"/>
                      <a:gd name="connsiteX1" fmla="*/ 12700 w 1939925"/>
                      <a:gd name="connsiteY1" fmla="*/ 695325 h 850900"/>
                      <a:gd name="connsiteX2" fmla="*/ 34925 w 1939925"/>
                      <a:gd name="connsiteY2" fmla="*/ 244475 h 850900"/>
                      <a:gd name="connsiteX3" fmla="*/ 41275 w 1939925"/>
                      <a:gd name="connsiteY3" fmla="*/ 279400 h 850900"/>
                      <a:gd name="connsiteX4" fmla="*/ 47625 w 1939925"/>
                      <a:gd name="connsiteY4" fmla="*/ 228600 h 850900"/>
                      <a:gd name="connsiteX5" fmla="*/ 57150 w 1939925"/>
                      <a:gd name="connsiteY5" fmla="*/ 273050 h 850900"/>
                      <a:gd name="connsiteX6" fmla="*/ 79375 w 1939925"/>
                      <a:gd name="connsiteY6" fmla="*/ 539750 h 850900"/>
                      <a:gd name="connsiteX7" fmla="*/ 95250 w 1939925"/>
                      <a:gd name="connsiteY7" fmla="*/ 330200 h 850900"/>
                      <a:gd name="connsiteX8" fmla="*/ 101600 w 1939925"/>
                      <a:gd name="connsiteY8" fmla="*/ 358775 h 850900"/>
                      <a:gd name="connsiteX9" fmla="*/ 114300 w 1939925"/>
                      <a:gd name="connsiteY9" fmla="*/ 231775 h 850900"/>
                      <a:gd name="connsiteX10" fmla="*/ 114300 w 1939925"/>
                      <a:gd name="connsiteY10" fmla="*/ 231775 h 850900"/>
                      <a:gd name="connsiteX11" fmla="*/ 127000 w 1939925"/>
                      <a:gd name="connsiteY11" fmla="*/ 206375 h 850900"/>
                      <a:gd name="connsiteX12" fmla="*/ 136525 w 1939925"/>
                      <a:gd name="connsiteY12" fmla="*/ 336550 h 850900"/>
                      <a:gd name="connsiteX13" fmla="*/ 142875 w 1939925"/>
                      <a:gd name="connsiteY13" fmla="*/ 254000 h 850900"/>
                      <a:gd name="connsiteX14" fmla="*/ 149225 w 1939925"/>
                      <a:gd name="connsiteY14" fmla="*/ 260350 h 850900"/>
                      <a:gd name="connsiteX15" fmla="*/ 168275 w 1939925"/>
                      <a:gd name="connsiteY15" fmla="*/ 114300 h 850900"/>
                      <a:gd name="connsiteX16" fmla="*/ 171450 w 1939925"/>
                      <a:gd name="connsiteY16" fmla="*/ 177800 h 850900"/>
                      <a:gd name="connsiteX17" fmla="*/ 177800 w 1939925"/>
                      <a:gd name="connsiteY17" fmla="*/ 136525 h 850900"/>
                      <a:gd name="connsiteX18" fmla="*/ 190500 w 1939925"/>
                      <a:gd name="connsiteY18" fmla="*/ 38100 h 850900"/>
                      <a:gd name="connsiteX19" fmla="*/ 200025 w 1939925"/>
                      <a:gd name="connsiteY19" fmla="*/ 57150 h 850900"/>
                      <a:gd name="connsiteX20" fmla="*/ 209550 w 1939925"/>
                      <a:gd name="connsiteY20" fmla="*/ 0 h 850900"/>
                      <a:gd name="connsiteX21" fmla="*/ 225425 w 1939925"/>
                      <a:gd name="connsiteY21" fmla="*/ 228600 h 850900"/>
                      <a:gd name="connsiteX22" fmla="*/ 225425 w 1939925"/>
                      <a:gd name="connsiteY22" fmla="*/ 228600 h 850900"/>
                      <a:gd name="connsiteX23" fmla="*/ 250825 w 1939925"/>
                      <a:gd name="connsiteY23" fmla="*/ 209550 h 850900"/>
                      <a:gd name="connsiteX24" fmla="*/ 263525 w 1939925"/>
                      <a:gd name="connsiteY24" fmla="*/ 266700 h 850900"/>
                      <a:gd name="connsiteX25" fmla="*/ 273050 w 1939925"/>
                      <a:gd name="connsiteY25" fmla="*/ 206375 h 850900"/>
                      <a:gd name="connsiteX26" fmla="*/ 288925 w 1939925"/>
                      <a:gd name="connsiteY26" fmla="*/ 434975 h 850900"/>
                      <a:gd name="connsiteX27" fmla="*/ 317500 w 1939925"/>
                      <a:gd name="connsiteY27" fmla="*/ 206375 h 850900"/>
                      <a:gd name="connsiteX28" fmla="*/ 333375 w 1939925"/>
                      <a:gd name="connsiteY28" fmla="*/ 273050 h 850900"/>
                      <a:gd name="connsiteX29" fmla="*/ 349250 w 1939925"/>
                      <a:gd name="connsiteY29" fmla="*/ 193675 h 850900"/>
                      <a:gd name="connsiteX30" fmla="*/ 358775 w 1939925"/>
                      <a:gd name="connsiteY30" fmla="*/ 301625 h 850900"/>
                      <a:gd name="connsiteX31" fmla="*/ 371475 w 1939925"/>
                      <a:gd name="connsiteY31" fmla="*/ 209550 h 850900"/>
                      <a:gd name="connsiteX32" fmla="*/ 384175 w 1939925"/>
                      <a:gd name="connsiteY32" fmla="*/ 434975 h 850900"/>
                      <a:gd name="connsiteX33" fmla="*/ 396875 w 1939925"/>
                      <a:gd name="connsiteY33" fmla="*/ 371475 h 850900"/>
                      <a:gd name="connsiteX34" fmla="*/ 415925 w 1939925"/>
                      <a:gd name="connsiteY34" fmla="*/ 473075 h 850900"/>
                      <a:gd name="connsiteX35" fmla="*/ 425450 w 1939925"/>
                      <a:gd name="connsiteY35" fmla="*/ 304800 h 850900"/>
                      <a:gd name="connsiteX36" fmla="*/ 438150 w 1939925"/>
                      <a:gd name="connsiteY36" fmla="*/ 336550 h 850900"/>
                      <a:gd name="connsiteX37" fmla="*/ 460375 w 1939925"/>
                      <a:gd name="connsiteY37" fmla="*/ 146050 h 850900"/>
                      <a:gd name="connsiteX38" fmla="*/ 466725 w 1939925"/>
                      <a:gd name="connsiteY38" fmla="*/ 266700 h 850900"/>
                      <a:gd name="connsiteX39" fmla="*/ 473075 w 1939925"/>
                      <a:gd name="connsiteY39" fmla="*/ 234950 h 850900"/>
                      <a:gd name="connsiteX40" fmla="*/ 485775 w 1939925"/>
                      <a:gd name="connsiteY40" fmla="*/ 276225 h 850900"/>
                      <a:gd name="connsiteX41" fmla="*/ 501650 w 1939925"/>
                      <a:gd name="connsiteY41" fmla="*/ 250825 h 850900"/>
                      <a:gd name="connsiteX42" fmla="*/ 514350 w 1939925"/>
                      <a:gd name="connsiteY42" fmla="*/ 342900 h 850900"/>
                      <a:gd name="connsiteX43" fmla="*/ 530225 w 1939925"/>
                      <a:gd name="connsiteY43" fmla="*/ 260350 h 850900"/>
                      <a:gd name="connsiteX44" fmla="*/ 533400 w 1939925"/>
                      <a:gd name="connsiteY44" fmla="*/ 336550 h 850900"/>
                      <a:gd name="connsiteX45" fmla="*/ 555625 w 1939925"/>
                      <a:gd name="connsiteY45" fmla="*/ 257175 h 850900"/>
                      <a:gd name="connsiteX46" fmla="*/ 558800 w 1939925"/>
                      <a:gd name="connsiteY46" fmla="*/ 317500 h 850900"/>
                      <a:gd name="connsiteX47" fmla="*/ 584200 w 1939925"/>
                      <a:gd name="connsiteY47" fmla="*/ 263525 h 850900"/>
                      <a:gd name="connsiteX48" fmla="*/ 587375 w 1939925"/>
                      <a:gd name="connsiteY48" fmla="*/ 336550 h 850900"/>
                      <a:gd name="connsiteX49" fmla="*/ 600075 w 1939925"/>
                      <a:gd name="connsiteY49" fmla="*/ 301625 h 850900"/>
                      <a:gd name="connsiteX50" fmla="*/ 600075 w 1939925"/>
                      <a:gd name="connsiteY50" fmla="*/ 333375 h 850900"/>
                      <a:gd name="connsiteX51" fmla="*/ 619125 w 1939925"/>
                      <a:gd name="connsiteY51" fmla="*/ 304800 h 850900"/>
                      <a:gd name="connsiteX52" fmla="*/ 622300 w 1939925"/>
                      <a:gd name="connsiteY52" fmla="*/ 361950 h 850900"/>
                      <a:gd name="connsiteX53" fmla="*/ 641350 w 1939925"/>
                      <a:gd name="connsiteY53" fmla="*/ 190500 h 850900"/>
                      <a:gd name="connsiteX54" fmla="*/ 676275 w 1939925"/>
                      <a:gd name="connsiteY54" fmla="*/ 609600 h 850900"/>
                      <a:gd name="connsiteX55" fmla="*/ 692150 w 1939925"/>
                      <a:gd name="connsiteY55" fmla="*/ 571500 h 850900"/>
                      <a:gd name="connsiteX56" fmla="*/ 688975 w 1939925"/>
                      <a:gd name="connsiteY56" fmla="*/ 600075 h 850900"/>
                      <a:gd name="connsiteX57" fmla="*/ 704850 w 1939925"/>
                      <a:gd name="connsiteY57" fmla="*/ 485775 h 850900"/>
                      <a:gd name="connsiteX58" fmla="*/ 714375 w 1939925"/>
                      <a:gd name="connsiteY58" fmla="*/ 571500 h 850900"/>
                      <a:gd name="connsiteX59" fmla="*/ 723900 w 1939925"/>
                      <a:gd name="connsiteY59" fmla="*/ 504825 h 850900"/>
                      <a:gd name="connsiteX60" fmla="*/ 730250 w 1939925"/>
                      <a:gd name="connsiteY60" fmla="*/ 565150 h 850900"/>
                      <a:gd name="connsiteX61" fmla="*/ 739775 w 1939925"/>
                      <a:gd name="connsiteY61" fmla="*/ 520700 h 850900"/>
                      <a:gd name="connsiteX62" fmla="*/ 752475 w 1939925"/>
                      <a:gd name="connsiteY62" fmla="*/ 355600 h 850900"/>
                      <a:gd name="connsiteX63" fmla="*/ 765175 w 1939925"/>
                      <a:gd name="connsiteY63" fmla="*/ 361950 h 850900"/>
                      <a:gd name="connsiteX64" fmla="*/ 771525 w 1939925"/>
                      <a:gd name="connsiteY64" fmla="*/ 406400 h 850900"/>
                      <a:gd name="connsiteX65" fmla="*/ 790575 w 1939925"/>
                      <a:gd name="connsiteY65" fmla="*/ 549275 h 850900"/>
                      <a:gd name="connsiteX66" fmla="*/ 803275 w 1939925"/>
                      <a:gd name="connsiteY66" fmla="*/ 581025 h 850900"/>
                      <a:gd name="connsiteX67" fmla="*/ 815975 w 1939925"/>
                      <a:gd name="connsiteY67" fmla="*/ 768350 h 850900"/>
                      <a:gd name="connsiteX68" fmla="*/ 825500 w 1939925"/>
                      <a:gd name="connsiteY68" fmla="*/ 752475 h 850900"/>
                      <a:gd name="connsiteX69" fmla="*/ 835025 w 1939925"/>
                      <a:gd name="connsiteY69" fmla="*/ 803275 h 850900"/>
                      <a:gd name="connsiteX70" fmla="*/ 844550 w 1939925"/>
                      <a:gd name="connsiteY70" fmla="*/ 850900 h 850900"/>
                      <a:gd name="connsiteX71" fmla="*/ 860425 w 1939925"/>
                      <a:gd name="connsiteY71" fmla="*/ 663575 h 850900"/>
                      <a:gd name="connsiteX72" fmla="*/ 860425 w 1939925"/>
                      <a:gd name="connsiteY72" fmla="*/ 701675 h 850900"/>
                      <a:gd name="connsiteX73" fmla="*/ 869950 w 1939925"/>
                      <a:gd name="connsiteY73" fmla="*/ 609600 h 850900"/>
                      <a:gd name="connsiteX74" fmla="*/ 885825 w 1939925"/>
                      <a:gd name="connsiteY74" fmla="*/ 647700 h 850900"/>
                      <a:gd name="connsiteX75" fmla="*/ 892175 w 1939925"/>
                      <a:gd name="connsiteY75" fmla="*/ 549275 h 850900"/>
                      <a:gd name="connsiteX76" fmla="*/ 908050 w 1939925"/>
                      <a:gd name="connsiteY76" fmla="*/ 688975 h 850900"/>
                      <a:gd name="connsiteX77" fmla="*/ 927100 w 1939925"/>
                      <a:gd name="connsiteY77" fmla="*/ 619125 h 850900"/>
                      <a:gd name="connsiteX78" fmla="*/ 939800 w 1939925"/>
                      <a:gd name="connsiteY78" fmla="*/ 444500 h 850900"/>
                      <a:gd name="connsiteX79" fmla="*/ 962025 w 1939925"/>
                      <a:gd name="connsiteY79" fmla="*/ 425450 h 850900"/>
                      <a:gd name="connsiteX80" fmla="*/ 974725 w 1939925"/>
                      <a:gd name="connsiteY80" fmla="*/ 619125 h 850900"/>
                      <a:gd name="connsiteX81" fmla="*/ 984250 w 1939925"/>
                      <a:gd name="connsiteY81" fmla="*/ 581025 h 850900"/>
                      <a:gd name="connsiteX82" fmla="*/ 996950 w 1939925"/>
                      <a:gd name="connsiteY82" fmla="*/ 619125 h 850900"/>
                      <a:gd name="connsiteX83" fmla="*/ 1009650 w 1939925"/>
                      <a:gd name="connsiteY83" fmla="*/ 498475 h 850900"/>
                      <a:gd name="connsiteX84" fmla="*/ 1022350 w 1939925"/>
                      <a:gd name="connsiteY84" fmla="*/ 628650 h 850900"/>
                      <a:gd name="connsiteX85" fmla="*/ 1044575 w 1939925"/>
                      <a:gd name="connsiteY85" fmla="*/ 536575 h 850900"/>
                      <a:gd name="connsiteX86" fmla="*/ 1057275 w 1939925"/>
                      <a:gd name="connsiteY86" fmla="*/ 552450 h 850900"/>
                      <a:gd name="connsiteX87" fmla="*/ 1063625 w 1939925"/>
                      <a:gd name="connsiteY87" fmla="*/ 466725 h 850900"/>
                      <a:gd name="connsiteX88" fmla="*/ 1089025 w 1939925"/>
                      <a:gd name="connsiteY88" fmla="*/ 606425 h 850900"/>
                      <a:gd name="connsiteX89" fmla="*/ 1098550 w 1939925"/>
                      <a:gd name="connsiteY89" fmla="*/ 581025 h 850900"/>
                      <a:gd name="connsiteX90" fmla="*/ 1117600 w 1939925"/>
                      <a:gd name="connsiteY90" fmla="*/ 650875 h 850900"/>
                      <a:gd name="connsiteX91" fmla="*/ 1120775 w 1939925"/>
                      <a:gd name="connsiteY91" fmla="*/ 549275 h 850900"/>
                      <a:gd name="connsiteX92" fmla="*/ 1127125 w 1939925"/>
                      <a:gd name="connsiteY92" fmla="*/ 476250 h 850900"/>
                      <a:gd name="connsiteX93" fmla="*/ 1146175 w 1939925"/>
                      <a:gd name="connsiteY93" fmla="*/ 561975 h 850900"/>
                      <a:gd name="connsiteX94" fmla="*/ 1162050 w 1939925"/>
                      <a:gd name="connsiteY94" fmla="*/ 450850 h 850900"/>
                      <a:gd name="connsiteX95" fmla="*/ 1181100 w 1939925"/>
                      <a:gd name="connsiteY95" fmla="*/ 565150 h 850900"/>
                      <a:gd name="connsiteX96" fmla="*/ 1181100 w 1939925"/>
                      <a:gd name="connsiteY96" fmla="*/ 688975 h 850900"/>
                      <a:gd name="connsiteX97" fmla="*/ 1193800 w 1939925"/>
                      <a:gd name="connsiteY97" fmla="*/ 647700 h 850900"/>
                      <a:gd name="connsiteX98" fmla="*/ 1200150 w 1939925"/>
                      <a:gd name="connsiteY98" fmla="*/ 688975 h 850900"/>
                      <a:gd name="connsiteX99" fmla="*/ 1216025 w 1939925"/>
                      <a:gd name="connsiteY99" fmla="*/ 587375 h 850900"/>
                      <a:gd name="connsiteX100" fmla="*/ 1219200 w 1939925"/>
                      <a:gd name="connsiteY100" fmla="*/ 644525 h 850900"/>
                      <a:gd name="connsiteX101" fmla="*/ 1235075 w 1939925"/>
                      <a:gd name="connsiteY101" fmla="*/ 441325 h 850900"/>
                      <a:gd name="connsiteX102" fmla="*/ 1250950 w 1939925"/>
                      <a:gd name="connsiteY102" fmla="*/ 609600 h 850900"/>
                      <a:gd name="connsiteX103" fmla="*/ 1260475 w 1939925"/>
                      <a:gd name="connsiteY103" fmla="*/ 444500 h 850900"/>
                      <a:gd name="connsiteX104" fmla="*/ 1273175 w 1939925"/>
                      <a:gd name="connsiteY104" fmla="*/ 558800 h 850900"/>
                      <a:gd name="connsiteX105" fmla="*/ 1285875 w 1939925"/>
                      <a:gd name="connsiteY105" fmla="*/ 447675 h 850900"/>
                      <a:gd name="connsiteX106" fmla="*/ 1304925 w 1939925"/>
                      <a:gd name="connsiteY106" fmla="*/ 628650 h 850900"/>
                      <a:gd name="connsiteX107" fmla="*/ 1311275 w 1939925"/>
                      <a:gd name="connsiteY107" fmla="*/ 546100 h 850900"/>
                      <a:gd name="connsiteX108" fmla="*/ 1327150 w 1939925"/>
                      <a:gd name="connsiteY108" fmla="*/ 536575 h 850900"/>
                      <a:gd name="connsiteX109" fmla="*/ 1339850 w 1939925"/>
                      <a:gd name="connsiteY109" fmla="*/ 377825 h 850900"/>
                      <a:gd name="connsiteX110" fmla="*/ 1355725 w 1939925"/>
                      <a:gd name="connsiteY110" fmla="*/ 527050 h 850900"/>
                      <a:gd name="connsiteX111" fmla="*/ 1374775 w 1939925"/>
                      <a:gd name="connsiteY111" fmla="*/ 584200 h 850900"/>
                      <a:gd name="connsiteX112" fmla="*/ 1377950 w 1939925"/>
                      <a:gd name="connsiteY112" fmla="*/ 717550 h 850900"/>
                      <a:gd name="connsiteX113" fmla="*/ 1387475 w 1939925"/>
                      <a:gd name="connsiteY113" fmla="*/ 660400 h 850900"/>
                      <a:gd name="connsiteX114" fmla="*/ 1409700 w 1939925"/>
                      <a:gd name="connsiteY114" fmla="*/ 609600 h 850900"/>
                      <a:gd name="connsiteX115" fmla="*/ 1416050 w 1939925"/>
                      <a:gd name="connsiteY115" fmla="*/ 527050 h 850900"/>
                      <a:gd name="connsiteX116" fmla="*/ 1419225 w 1939925"/>
                      <a:gd name="connsiteY116" fmla="*/ 609600 h 850900"/>
                      <a:gd name="connsiteX117" fmla="*/ 1422400 w 1939925"/>
                      <a:gd name="connsiteY117" fmla="*/ 523875 h 850900"/>
                      <a:gd name="connsiteX118" fmla="*/ 1447800 w 1939925"/>
                      <a:gd name="connsiteY118" fmla="*/ 609600 h 850900"/>
                      <a:gd name="connsiteX119" fmla="*/ 1454150 w 1939925"/>
                      <a:gd name="connsiteY119" fmla="*/ 549275 h 850900"/>
                      <a:gd name="connsiteX120" fmla="*/ 1463675 w 1939925"/>
                      <a:gd name="connsiteY120" fmla="*/ 615950 h 850900"/>
                      <a:gd name="connsiteX121" fmla="*/ 1463675 w 1939925"/>
                      <a:gd name="connsiteY121" fmla="*/ 657225 h 850900"/>
                      <a:gd name="connsiteX122" fmla="*/ 1476375 w 1939925"/>
                      <a:gd name="connsiteY122" fmla="*/ 517525 h 850900"/>
                      <a:gd name="connsiteX123" fmla="*/ 1495425 w 1939925"/>
                      <a:gd name="connsiteY123" fmla="*/ 517525 h 850900"/>
                      <a:gd name="connsiteX124" fmla="*/ 1508125 w 1939925"/>
                      <a:gd name="connsiteY124" fmla="*/ 717550 h 850900"/>
                      <a:gd name="connsiteX125" fmla="*/ 1520825 w 1939925"/>
                      <a:gd name="connsiteY125" fmla="*/ 800100 h 850900"/>
                      <a:gd name="connsiteX126" fmla="*/ 1536700 w 1939925"/>
                      <a:gd name="connsiteY126" fmla="*/ 711200 h 850900"/>
                      <a:gd name="connsiteX127" fmla="*/ 1552575 w 1939925"/>
                      <a:gd name="connsiteY127" fmla="*/ 612775 h 850900"/>
                      <a:gd name="connsiteX128" fmla="*/ 1562100 w 1939925"/>
                      <a:gd name="connsiteY128" fmla="*/ 536575 h 850900"/>
                      <a:gd name="connsiteX129" fmla="*/ 1574800 w 1939925"/>
                      <a:gd name="connsiteY129" fmla="*/ 574675 h 850900"/>
                      <a:gd name="connsiteX130" fmla="*/ 1590675 w 1939925"/>
                      <a:gd name="connsiteY130" fmla="*/ 476250 h 850900"/>
                      <a:gd name="connsiteX131" fmla="*/ 1593850 w 1939925"/>
                      <a:gd name="connsiteY131" fmla="*/ 482600 h 850900"/>
                      <a:gd name="connsiteX132" fmla="*/ 1616075 w 1939925"/>
                      <a:gd name="connsiteY132" fmla="*/ 368300 h 850900"/>
                      <a:gd name="connsiteX133" fmla="*/ 1635125 w 1939925"/>
                      <a:gd name="connsiteY133" fmla="*/ 120650 h 850900"/>
                      <a:gd name="connsiteX134" fmla="*/ 1644650 w 1939925"/>
                      <a:gd name="connsiteY134" fmla="*/ 254000 h 850900"/>
                      <a:gd name="connsiteX135" fmla="*/ 1657350 w 1939925"/>
                      <a:gd name="connsiteY135" fmla="*/ 196850 h 850900"/>
                      <a:gd name="connsiteX136" fmla="*/ 1673225 w 1939925"/>
                      <a:gd name="connsiteY136" fmla="*/ 266700 h 850900"/>
                      <a:gd name="connsiteX137" fmla="*/ 1701800 w 1939925"/>
                      <a:gd name="connsiteY137" fmla="*/ 225425 h 850900"/>
                      <a:gd name="connsiteX138" fmla="*/ 1701800 w 1939925"/>
                      <a:gd name="connsiteY138" fmla="*/ 387350 h 850900"/>
                      <a:gd name="connsiteX139" fmla="*/ 1714500 w 1939925"/>
                      <a:gd name="connsiteY139" fmla="*/ 454025 h 850900"/>
                      <a:gd name="connsiteX140" fmla="*/ 1730375 w 1939925"/>
                      <a:gd name="connsiteY140" fmla="*/ 552450 h 850900"/>
                      <a:gd name="connsiteX141" fmla="*/ 1743075 w 1939925"/>
                      <a:gd name="connsiteY141" fmla="*/ 355600 h 850900"/>
                      <a:gd name="connsiteX142" fmla="*/ 1765300 w 1939925"/>
                      <a:gd name="connsiteY142" fmla="*/ 282575 h 850900"/>
                      <a:gd name="connsiteX143" fmla="*/ 1768475 w 1939925"/>
                      <a:gd name="connsiteY143" fmla="*/ 377825 h 850900"/>
                      <a:gd name="connsiteX144" fmla="*/ 1793875 w 1939925"/>
                      <a:gd name="connsiteY144" fmla="*/ 431800 h 850900"/>
                      <a:gd name="connsiteX145" fmla="*/ 1803400 w 1939925"/>
                      <a:gd name="connsiteY145" fmla="*/ 565150 h 850900"/>
                      <a:gd name="connsiteX146" fmla="*/ 1812925 w 1939925"/>
                      <a:gd name="connsiteY146" fmla="*/ 520700 h 850900"/>
                      <a:gd name="connsiteX147" fmla="*/ 1822450 w 1939925"/>
                      <a:gd name="connsiteY147" fmla="*/ 568325 h 850900"/>
                      <a:gd name="connsiteX148" fmla="*/ 1835150 w 1939925"/>
                      <a:gd name="connsiteY148" fmla="*/ 441325 h 850900"/>
                      <a:gd name="connsiteX149" fmla="*/ 1841500 w 1939925"/>
                      <a:gd name="connsiteY149" fmla="*/ 231775 h 850900"/>
                      <a:gd name="connsiteX150" fmla="*/ 1857375 w 1939925"/>
                      <a:gd name="connsiteY150" fmla="*/ 203200 h 850900"/>
                      <a:gd name="connsiteX151" fmla="*/ 1873250 w 1939925"/>
                      <a:gd name="connsiteY151" fmla="*/ 336550 h 850900"/>
                      <a:gd name="connsiteX152" fmla="*/ 1870075 w 1939925"/>
                      <a:gd name="connsiteY152" fmla="*/ 288925 h 850900"/>
                      <a:gd name="connsiteX153" fmla="*/ 1895475 w 1939925"/>
                      <a:gd name="connsiteY153" fmla="*/ 457200 h 850900"/>
                      <a:gd name="connsiteX154" fmla="*/ 1911350 w 1939925"/>
                      <a:gd name="connsiteY154" fmla="*/ 244475 h 850900"/>
                      <a:gd name="connsiteX155" fmla="*/ 1930400 w 1939925"/>
                      <a:gd name="connsiteY155" fmla="*/ 111125 h 850900"/>
                      <a:gd name="connsiteX156" fmla="*/ 1936750 w 1939925"/>
                      <a:gd name="connsiteY156" fmla="*/ 155575 h 850900"/>
                      <a:gd name="connsiteX157" fmla="*/ 1939925 w 1939925"/>
                      <a:gd name="connsiteY157" fmla="*/ 174625 h 85090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  <a:cxn ang="0">
                        <a:pos x="connsiteX3" y="connsiteY3"/>
                      </a:cxn>
                      <a:cxn ang="0">
                        <a:pos x="connsiteX4" y="connsiteY4"/>
                      </a:cxn>
                      <a:cxn ang="0">
                        <a:pos x="connsiteX5" y="connsiteY5"/>
                      </a:cxn>
                      <a:cxn ang="0">
                        <a:pos x="connsiteX6" y="connsiteY6"/>
                      </a:cxn>
                      <a:cxn ang="0">
                        <a:pos x="connsiteX7" y="connsiteY7"/>
                      </a:cxn>
                      <a:cxn ang="0">
                        <a:pos x="connsiteX8" y="connsiteY8"/>
                      </a:cxn>
                      <a:cxn ang="0">
                        <a:pos x="connsiteX9" y="connsiteY9"/>
                      </a:cxn>
                      <a:cxn ang="0">
                        <a:pos x="connsiteX10" y="connsiteY10"/>
                      </a:cxn>
                      <a:cxn ang="0">
                        <a:pos x="connsiteX11" y="connsiteY11"/>
                      </a:cxn>
                      <a:cxn ang="0">
                        <a:pos x="connsiteX12" y="connsiteY12"/>
                      </a:cxn>
                      <a:cxn ang="0">
                        <a:pos x="connsiteX13" y="connsiteY13"/>
                      </a:cxn>
                      <a:cxn ang="0">
                        <a:pos x="connsiteX14" y="connsiteY14"/>
                      </a:cxn>
                      <a:cxn ang="0">
                        <a:pos x="connsiteX15" y="connsiteY15"/>
                      </a:cxn>
                      <a:cxn ang="0">
                        <a:pos x="connsiteX16" y="connsiteY16"/>
                      </a:cxn>
                      <a:cxn ang="0">
                        <a:pos x="connsiteX17" y="connsiteY17"/>
                      </a:cxn>
                      <a:cxn ang="0">
                        <a:pos x="connsiteX18" y="connsiteY18"/>
                      </a:cxn>
                      <a:cxn ang="0">
                        <a:pos x="connsiteX19" y="connsiteY19"/>
                      </a:cxn>
                      <a:cxn ang="0">
                        <a:pos x="connsiteX20" y="connsiteY20"/>
                      </a:cxn>
                      <a:cxn ang="0">
                        <a:pos x="connsiteX21" y="connsiteY21"/>
                      </a:cxn>
                      <a:cxn ang="0">
                        <a:pos x="connsiteX22" y="connsiteY22"/>
                      </a:cxn>
                      <a:cxn ang="0">
                        <a:pos x="connsiteX23" y="connsiteY23"/>
                      </a:cxn>
                      <a:cxn ang="0">
                        <a:pos x="connsiteX24" y="connsiteY24"/>
                      </a:cxn>
                      <a:cxn ang="0">
                        <a:pos x="connsiteX25" y="connsiteY25"/>
                      </a:cxn>
                      <a:cxn ang="0">
                        <a:pos x="connsiteX26" y="connsiteY26"/>
                      </a:cxn>
                      <a:cxn ang="0">
                        <a:pos x="connsiteX27" y="connsiteY27"/>
                      </a:cxn>
                      <a:cxn ang="0">
                        <a:pos x="connsiteX28" y="connsiteY28"/>
                      </a:cxn>
                      <a:cxn ang="0">
                        <a:pos x="connsiteX29" y="connsiteY29"/>
                      </a:cxn>
                      <a:cxn ang="0">
                        <a:pos x="connsiteX30" y="connsiteY30"/>
                      </a:cxn>
                      <a:cxn ang="0">
                        <a:pos x="connsiteX31" y="connsiteY31"/>
                      </a:cxn>
                      <a:cxn ang="0">
                        <a:pos x="connsiteX32" y="connsiteY32"/>
                      </a:cxn>
                      <a:cxn ang="0">
                        <a:pos x="connsiteX33" y="connsiteY33"/>
                      </a:cxn>
                      <a:cxn ang="0">
                        <a:pos x="connsiteX34" y="connsiteY34"/>
                      </a:cxn>
                      <a:cxn ang="0">
                        <a:pos x="connsiteX35" y="connsiteY35"/>
                      </a:cxn>
                      <a:cxn ang="0">
                        <a:pos x="connsiteX36" y="connsiteY36"/>
                      </a:cxn>
                      <a:cxn ang="0">
                        <a:pos x="connsiteX37" y="connsiteY37"/>
                      </a:cxn>
                      <a:cxn ang="0">
                        <a:pos x="connsiteX38" y="connsiteY38"/>
                      </a:cxn>
                      <a:cxn ang="0">
                        <a:pos x="connsiteX39" y="connsiteY39"/>
                      </a:cxn>
                      <a:cxn ang="0">
                        <a:pos x="connsiteX40" y="connsiteY40"/>
                      </a:cxn>
                      <a:cxn ang="0">
                        <a:pos x="connsiteX41" y="connsiteY41"/>
                      </a:cxn>
                      <a:cxn ang="0">
                        <a:pos x="connsiteX42" y="connsiteY42"/>
                      </a:cxn>
                      <a:cxn ang="0">
                        <a:pos x="connsiteX43" y="connsiteY43"/>
                      </a:cxn>
                      <a:cxn ang="0">
                        <a:pos x="connsiteX44" y="connsiteY44"/>
                      </a:cxn>
                      <a:cxn ang="0">
                        <a:pos x="connsiteX45" y="connsiteY45"/>
                      </a:cxn>
                      <a:cxn ang="0">
                        <a:pos x="connsiteX46" y="connsiteY46"/>
                      </a:cxn>
                      <a:cxn ang="0">
                        <a:pos x="connsiteX47" y="connsiteY47"/>
                      </a:cxn>
                      <a:cxn ang="0">
                        <a:pos x="connsiteX48" y="connsiteY48"/>
                      </a:cxn>
                      <a:cxn ang="0">
                        <a:pos x="connsiteX49" y="connsiteY49"/>
                      </a:cxn>
                      <a:cxn ang="0">
                        <a:pos x="connsiteX50" y="connsiteY50"/>
                      </a:cxn>
                      <a:cxn ang="0">
                        <a:pos x="connsiteX51" y="connsiteY51"/>
                      </a:cxn>
                      <a:cxn ang="0">
                        <a:pos x="connsiteX52" y="connsiteY52"/>
                      </a:cxn>
                      <a:cxn ang="0">
                        <a:pos x="connsiteX53" y="connsiteY53"/>
                      </a:cxn>
                      <a:cxn ang="0">
                        <a:pos x="connsiteX54" y="connsiteY54"/>
                      </a:cxn>
                      <a:cxn ang="0">
                        <a:pos x="connsiteX55" y="connsiteY55"/>
                      </a:cxn>
                      <a:cxn ang="0">
                        <a:pos x="connsiteX56" y="connsiteY56"/>
                      </a:cxn>
                      <a:cxn ang="0">
                        <a:pos x="connsiteX57" y="connsiteY57"/>
                      </a:cxn>
                      <a:cxn ang="0">
                        <a:pos x="connsiteX58" y="connsiteY58"/>
                      </a:cxn>
                      <a:cxn ang="0">
                        <a:pos x="connsiteX59" y="connsiteY59"/>
                      </a:cxn>
                      <a:cxn ang="0">
                        <a:pos x="connsiteX60" y="connsiteY60"/>
                      </a:cxn>
                      <a:cxn ang="0">
                        <a:pos x="connsiteX61" y="connsiteY61"/>
                      </a:cxn>
                      <a:cxn ang="0">
                        <a:pos x="connsiteX62" y="connsiteY62"/>
                      </a:cxn>
                      <a:cxn ang="0">
                        <a:pos x="connsiteX63" y="connsiteY63"/>
                      </a:cxn>
                      <a:cxn ang="0">
                        <a:pos x="connsiteX64" y="connsiteY64"/>
                      </a:cxn>
                      <a:cxn ang="0">
                        <a:pos x="connsiteX65" y="connsiteY65"/>
                      </a:cxn>
                      <a:cxn ang="0">
                        <a:pos x="connsiteX66" y="connsiteY66"/>
                      </a:cxn>
                      <a:cxn ang="0">
                        <a:pos x="connsiteX67" y="connsiteY67"/>
                      </a:cxn>
                      <a:cxn ang="0">
                        <a:pos x="connsiteX68" y="connsiteY68"/>
                      </a:cxn>
                      <a:cxn ang="0">
                        <a:pos x="connsiteX69" y="connsiteY69"/>
                      </a:cxn>
                      <a:cxn ang="0">
                        <a:pos x="connsiteX70" y="connsiteY70"/>
                      </a:cxn>
                      <a:cxn ang="0">
                        <a:pos x="connsiteX71" y="connsiteY71"/>
                      </a:cxn>
                      <a:cxn ang="0">
                        <a:pos x="connsiteX72" y="connsiteY72"/>
                      </a:cxn>
                      <a:cxn ang="0">
                        <a:pos x="connsiteX73" y="connsiteY73"/>
                      </a:cxn>
                      <a:cxn ang="0">
                        <a:pos x="connsiteX74" y="connsiteY74"/>
                      </a:cxn>
                      <a:cxn ang="0">
                        <a:pos x="connsiteX75" y="connsiteY75"/>
                      </a:cxn>
                      <a:cxn ang="0">
                        <a:pos x="connsiteX76" y="connsiteY76"/>
                      </a:cxn>
                      <a:cxn ang="0">
                        <a:pos x="connsiteX77" y="connsiteY77"/>
                      </a:cxn>
                      <a:cxn ang="0">
                        <a:pos x="connsiteX78" y="connsiteY78"/>
                      </a:cxn>
                      <a:cxn ang="0">
                        <a:pos x="connsiteX79" y="connsiteY79"/>
                      </a:cxn>
                      <a:cxn ang="0">
                        <a:pos x="connsiteX80" y="connsiteY80"/>
                      </a:cxn>
                      <a:cxn ang="0">
                        <a:pos x="connsiteX81" y="connsiteY81"/>
                      </a:cxn>
                      <a:cxn ang="0">
                        <a:pos x="connsiteX82" y="connsiteY82"/>
                      </a:cxn>
                      <a:cxn ang="0">
                        <a:pos x="connsiteX83" y="connsiteY83"/>
                      </a:cxn>
                      <a:cxn ang="0">
                        <a:pos x="connsiteX84" y="connsiteY84"/>
                      </a:cxn>
                      <a:cxn ang="0">
                        <a:pos x="connsiteX85" y="connsiteY85"/>
                      </a:cxn>
                      <a:cxn ang="0">
                        <a:pos x="connsiteX86" y="connsiteY86"/>
                      </a:cxn>
                      <a:cxn ang="0">
                        <a:pos x="connsiteX87" y="connsiteY87"/>
                      </a:cxn>
                      <a:cxn ang="0">
                        <a:pos x="connsiteX88" y="connsiteY88"/>
                      </a:cxn>
                      <a:cxn ang="0">
                        <a:pos x="connsiteX89" y="connsiteY89"/>
                      </a:cxn>
                      <a:cxn ang="0">
                        <a:pos x="connsiteX90" y="connsiteY90"/>
                      </a:cxn>
                      <a:cxn ang="0">
                        <a:pos x="connsiteX91" y="connsiteY91"/>
                      </a:cxn>
                      <a:cxn ang="0">
                        <a:pos x="connsiteX92" y="connsiteY92"/>
                      </a:cxn>
                      <a:cxn ang="0">
                        <a:pos x="connsiteX93" y="connsiteY93"/>
                      </a:cxn>
                      <a:cxn ang="0">
                        <a:pos x="connsiteX94" y="connsiteY94"/>
                      </a:cxn>
                      <a:cxn ang="0">
                        <a:pos x="connsiteX95" y="connsiteY95"/>
                      </a:cxn>
                      <a:cxn ang="0">
                        <a:pos x="connsiteX96" y="connsiteY96"/>
                      </a:cxn>
                      <a:cxn ang="0">
                        <a:pos x="connsiteX97" y="connsiteY97"/>
                      </a:cxn>
                      <a:cxn ang="0">
                        <a:pos x="connsiteX98" y="connsiteY98"/>
                      </a:cxn>
                      <a:cxn ang="0">
                        <a:pos x="connsiteX99" y="connsiteY99"/>
                      </a:cxn>
                      <a:cxn ang="0">
                        <a:pos x="connsiteX100" y="connsiteY100"/>
                      </a:cxn>
                      <a:cxn ang="0">
                        <a:pos x="connsiteX101" y="connsiteY101"/>
                      </a:cxn>
                      <a:cxn ang="0">
                        <a:pos x="connsiteX102" y="connsiteY102"/>
                      </a:cxn>
                      <a:cxn ang="0">
                        <a:pos x="connsiteX103" y="connsiteY103"/>
                      </a:cxn>
                      <a:cxn ang="0">
                        <a:pos x="connsiteX104" y="connsiteY104"/>
                      </a:cxn>
                      <a:cxn ang="0">
                        <a:pos x="connsiteX105" y="connsiteY105"/>
                      </a:cxn>
                      <a:cxn ang="0">
                        <a:pos x="connsiteX106" y="connsiteY106"/>
                      </a:cxn>
                      <a:cxn ang="0">
                        <a:pos x="connsiteX107" y="connsiteY107"/>
                      </a:cxn>
                      <a:cxn ang="0">
                        <a:pos x="connsiteX108" y="connsiteY108"/>
                      </a:cxn>
                      <a:cxn ang="0">
                        <a:pos x="connsiteX109" y="connsiteY109"/>
                      </a:cxn>
                      <a:cxn ang="0">
                        <a:pos x="connsiteX110" y="connsiteY110"/>
                      </a:cxn>
                      <a:cxn ang="0">
                        <a:pos x="connsiteX111" y="connsiteY111"/>
                      </a:cxn>
                      <a:cxn ang="0">
                        <a:pos x="connsiteX112" y="connsiteY112"/>
                      </a:cxn>
                      <a:cxn ang="0">
                        <a:pos x="connsiteX113" y="connsiteY113"/>
                      </a:cxn>
                      <a:cxn ang="0">
                        <a:pos x="connsiteX114" y="connsiteY114"/>
                      </a:cxn>
                      <a:cxn ang="0">
                        <a:pos x="connsiteX115" y="connsiteY115"/>
                      </a:cxn>
                      <a:cxn ang="0">
                        <a:pos x="connsiteX116" y="connsiteY116"/>
                      </a:cxn>
                      <a:cxn ang="0">
                        <a:pos x="connsiteX117" y="connsiteY117"/>
                      </a:cxn>
                      <a:cxn ang="0">
                        <a:pos x="connsiteX118" y="connsiteY118"/>
                      </a:cxn>
                      <a:cxn ang="0">
                        <a:pos x="connsiteX119" y="connsiteY119"/>
                      </a:cxn>
                      <a:cxn ang="0">
                        <a:pos x="connsiteX120" y="connsiteY120"/>
                      </a:cxn>
                      <a:cxn ang="0">
                        <a:pos x="connsiteX121" y="connsiteY121"/>
                      </a:cxn>
                      <a:cxn ang="0">
                        <a:pos x="connsiteX122" y="connsiteY122"/>
                      </a:cxn>
                      <a:cxn ang="0">
                        <a:pos x="connsiteX123" y="connsiteY123"/>
                      </a:cxn>
                      <a:cxn ang="0">
                        <a:pos x="connsiteX124" y="connsiteY124"/>
                      </a:cxn>
                      <a:cxn ang="0">
                        <a:pos x="connsiteX125" y="connsiteY125"/>
                      </a:cxn>
                      <a:cxn ang="0">
                        <a:pos x="connsiteX126" y="connsiteY126"/>
                      </a:cxn>
                      <a:cxn ang="0">
                        <a:pos x="connsiteX127" y="connsiteY127"/>
                      </a:cxn>
                      <a:cxn ang="0">
                        <a:pos x="connsiteX128" y="connsiteY128"/>
                      </a:cxn>
                      <a:cxn ang="0">
                        <a:pos x="connsiteX129" y="connsiteY129"/>
                      </a:cxn>
                      <a:cxn ang="0">
                        <a:pos x="connsiteX130" y="connsiteY130"/>
                      </a:cxn>
                      <a:cxn ang="0">
                        <a:pos x="connsiteX131" y="connsiteY131"/>
                      </a:cxn>
                      <a:cxn ang="0">
                        <a:pos x="connsiteX132" y="connsiteY132"/>
                      </a:cxn>
                      <a:cxn ang="0">
                        <a:pos x="connsiteX133" y="connsiteY133"/>
                      </a:cxn>
                      <a:cxn ang="0">
                        <a:pos x="connsiteX134" y="connsiteY134"/>
                      </a:cxn>
                      <a:cxn ang="0">
                        <a:pos x="connsiteX135" y="connsiteY135"/>
                      </a:cxn>
                      <a:cxn ang="0">
                        <a:pos x="connsiteX136" y="connsiteY136"/>
                      </a:cxn>
                      <a:cxn ang="0">
                        <a:pos x="connsiteX137" y="connsiteY137"/>
                      </a:cxn>
                      <a:cxn ang="0">
                        <a:pos x="connsiteX138" y="connsiteY138"/>
                      </a:cxn>
                      <a:cxn ang="0">
                        <a:pos x="connsiteX139" y="connsiteY139"/>
                      </a:cxn>
                      <a:cxn ang="0">
                        <a:pos x="connsiteX140" y="connsiteY140"/>
                      </a:cxn>
                      <a:cxn ang="0">
                        <a:pos x="connsiteX141" y="connsiteY141"/>
                      </a:cxn>
                      <a:cxn ang="0">
                        <a:pos x="connsiteX142" y="connsiteY142"/>
                      </a:cxn>
                      <a:cxn ang="0">
                        <a:pos x="connsiteX143" y="connsiteY143"/>
                      </a:cxn>
                      <a:cxn ang="0">
                        <a:pos x="connsiteX144" y="connsiteY144"/>
                      </a:cxn>
                      <a:cxn ang="0">
                        <a:pos x="connsiteX145" y="connsiteY145"/>
                      </a:cxn>
                      <a:cxn ang="0">
                        <a:pos x="connsiteX146" y="connsiteY146"/>
                      </a:cxn>
                      <a:cxn ang="0">
                        <a:pos x="connsiteX147" y="connsiteY147"/>
                      </a:cxn>
                      <a:cxn ang="0">
                        <a:pos x="connsiteX148" y="connsiteY148"/>
                      </a:cxn>
                      <a:cxn ang="0">
                        <a:pos x="connsiteX149" y="connsiteY149"/>
                      </a:cxn>
                      <a:cxn ang="0">
                        <a:pos x="connsiteX150" y="connsiteY150"/>
                      </a:cxn>
                      <a:cxn ang="0">
                        <a:pos x="connsiteX151" y="connsiteY151"/>
                      </a:cxn>
                      <a:cxn ang="0">
                        <a:pos x="connsiteX152" y="connsiteY152"/>
                      </a:cxn>
                      <a:cxn ang="0">
                        <a:pos x="connsiteX153" y="connsiteY153"/>
                      </a:cxn>
                      <a:cxn ang="0">
                        <a:pos x="connsiteX154" y="connsiteY154"/>
                      </a:cxn>
                      <a:cxn ang="0">
                        <a:pos x="connsiteX155" y="connsiteY155"/>
                      </a:cxn>
                      <a:cxn ang="0">
                        <a:pos x="connsiteX156" y="connsiteY156"/>
                      </a:cxn>
                      <a:cxn ang="0">
                        <a:pos x="connsiteX157" y="connsiteY157"/>
                      </a:cxn>
                    </a:cxnLst>
                    <a:rect l="l" t="t" r="r" b="b"/>
                    <a:pathLst>
                      <a:path w="1939925" h="850900">
                        <a:moveTo>
                          <a:pt x="0" y="558800"/>
                        </a:moveTo>
                        <a:lnTo>
                          <a:pt x="12700" y="695325"/>
                        </a:lnTo>
                        <a:lnTo>
                          <a:pt x="34925" y="244475"/>
                        </a:lnTo>
                        <a:lnTo>
                          <a:pt x="41275" y="279400"/>
                        </a:lnTo>
                        <a:lnTo>
                          <a:pt x="47625" y="228600"/>
                        </a:lnTo>
                        <a:lnTo>
                          <a:pt x="57150" y="273050"/>
                        </a:lnTo>
                        <a:lnTo>
                          <a:pt x="79375" y="539750"/>
                        </a:lnTo>
                        <a:lnTo>
                          <a:pt x="95250" y="330200"/>
                        </a:lnTo>
                        <a:lnTo>
                          <a:pt x="101600" y="358775"/>
                        </a:lnTo>
                        <a:lnTo>
                          <a:pt x="114300" y="231775"/>
                        </a:lnTo>
                        <a:lnTo>
                          <a:pt x="114300" y="231775"/>
                        </a:lnTo>
                        <a:lnTo>
                          <a:pt x="127000" y="206375"/>
                        </a:lnTo>
                        <a:lnTo>
                          <a:pt x="136525" y="336550"/>
                        </a:lnTo>
                        <a:lnTo>
                          <a:pt x="142875" y="254000"/>
                        </a:lnTo>
                        <a:lnTo>
                          <a:pt x="149225" y="260350"/>
                        </a:lnTo>
                        <a:lnTo>
                          <a:pt x="168275" y="114300"/>
                        </a:lnTo>
                        <a:lnTo>
                          <a:pt x="171450" y="177800"/>
                        </a:lnTo>
                        <a:lnTo>
                          <a:pt x="177800" y="136525"/>
                        </a:lnTo>
                        <a:lnTo>
                          <a:pt x="190500" y="38100"/>
                        </a:lnTo>
                        <a:lnTo>
                          <a:pt x="200025" y="57150"/>
                        </a:lnTo>
                        <a:lnTo>
                          <a:pt x="209550" y="0"/>
                        </a:lnTo>
                        <a:lnTo>
                          <a:pt x="225425" y="228600"/>
                        </a:lnTo>
                        <a:lnTo>
                          <a:pt x="225425" y="228600"/>
                        </a:lnTo>
                        <a:lnTo>
                          <a:pt x="250825" y="209550"/>
                        </a:lnTo>
                        <a:lnTo>
                          <a:pt x="263525" y="266700"/>
                        </a:lnTo>
                        <a:lnTo>
                          <a:pt x="273050" y="206375"/>
                        </a:lnTo>
                        <a:lnTo>
                          <a:pt x="288925" y="434975"/>
                        </a:lnTo>
                        <a:lnTo>
                          <a:pt x="317500" y="206375"/>
                        </a:lnTo>
                        <a:lnTo>
                          <a:pt x="333375" y="273050"/>
                        </a:lnTo>
                        <a:lnTo>
                          <a:pt x="349250" y="193675"/>
                        </a:lnTo>
                        <a:lnTo>
                          <a:pt x="358775" y="301625"/>
                        </a:lnTo>
                        <a:lnTo>
                          <a:pt x="371475" y="209550"/>
                        </a:lnTo>
                        <a:lnTo>
                          <a:pt x="384175" y="434975"/>
                        </a:lnTo>
                        <a:lnTo>
                          <a:pt x="396875" y="371475"/>
                        </a:lnTo>
                        <a:lnTo>
                          <a:pt x="415925" y="473075"/>
                        </a:lnTo>
                        <a:lnTo>
                          <a:pt x="425450" y="304800"/>
                        </a:lnTo>
                        <a:lnTo>
                          <a:pt x="438150" y="336550"/>
                        </a:lnTo>
                        <a:lnTo>
                          <a:pt x="460375" y="146050"/>
                        </a:lnTo>
                        <a:lnTo>
                          <a:pt x="466725" y="266700"/>
                        </a:lnTo>
                        <a:lnTo>
                          <a:pt x="473075" y="234950"/>
                        </a:lnTo>
                        <a:lnTo>
                          <a:pt x="485775" y="276225"/>
                        </a:lnTo>
                        <a:lnTo>
                          <a:pt x="501650" y="250825"/>
                        </a:lnTo>
                        <a:lnTo>
                          <a:pt x="514350" y="342900"/>
                        </a:lnTo>
                        <a:lnTo>
                          <a:pt x="530225" y="260350"/>
                        </a:lnTo>
                        <a:lnTo>
                          <a:pt x="533400" y="336550"/>
                        </a:lnTo>
                        <a:lnTo>
                          <a:pt x="555625" y="257175"/>
                        </a:lnTo>
                        <a:lnTo>
                          <a:pt x="558800" y="317500"/>
                        </a:lnTo>
                        <a:lnTo>
                          <a:pt x="584200" y="263525"/>
                        </a:lnTo>
                        <a:lnTo>
                          <a:pt x="587375" y="336550"/>
                        </a:lnTo>
                        <a:lnTo>
                          <a:pt x="600075" y="301625"/>
                        </a:lnTo>
                        <a:lnTo>
                          <a:pt x="600075" y="333375"/>
                        </a:lnTo>
                        <a:lnTo>
                          <a:pt x="619125" y="304800"/>
                        </a:lnTo>
                        <a:lnTo>
                          <a:pt x="622300" y="361950"/>
                        </a:lnTo>
                        <a:lnTo>
                          <a:pt x="641350" y="190500"/>
                        </a:lnTo>
                        <a:lnTo>
                          <a:pt x="676275" y="609600"/>
                        </a:lnTo>
                        <a:lnTo>
                          <a:pt x="692150" y="571500"/>
                        </a:lnTo>
                        <a:lnTo>
                          <a:pt x="688975" y="600075"/>
                        </a:lnTo>
                        <a:lnTo>
                          <a:pt x="704850" y="485775"/>
                        </a:lnTo>
                        <a:lnTo>
                          <a:pt x="714375" y="571500"/>
                        </a:lnTo>
                        <a:lnTo>
                          <a:pt x="723900" y="504825"/>
                        </a:lnTo>
                        <a:lnTo>
                          <a:pt x="730250" y="565150"/>
                        </a:lnTo>
                        <a:lnTo>
                          <a:pt x="739775" y="520700"/>
                        </a:lnTo>
                        <a:lnTo>
                          <a:pt x="752475" y="355600"/>
                        </a:lnTo>
                        <a:lnTo>
                          <a:pt x="765175" y="361950"/>
                        </a:lnTo>
                        <a:lnTo>
                          <a:pt x="771525" y="406400"/>
                        </a:lnTo>
                        <a:lnTo>
                          <a:pt x="790575" y="549275"/>
                        </a:lnTo>
                        <a:lnTo>
                          <a:pt x="803275" y="581025"/>
                        </a:lnTo>
                        <a:lnTo>
                          <a:pt x="815975" y="768350"/>
                        </a:lnTo>
                        <a:lnTo>
                          <a:pt x="825500" y="752475"/>
                        </a:lnTo>
                        <a:lnTo>
                          <a:pt x="835025" y="803275"/>
                        </a:lnTo>
                        <a:lnTo>
                          <a:pt x="844550" y="850900"/>
                        </a:lnTo>
                        <a:lnTo>
                          <a:pt x="860425" y="663575"/>
                        </a:lnTo>
                        <a:lnTo>
                          <a:pt x="860425" y="701675"/>
                        </a:lnTo>
                        <a:lnTo>
                          <a:pt x="869950" y="609600"/>
                        </a:lnTo>
                        <a:lnTo>
                          <a:pt x="885825" y="647700"/>
                        </a:lnTo>
                        <a:lnTo>
                          <a:pt x="892175" y="549275"/>
                        </a:lnTo>
                        <a:lnTo>
                          <a:pt x="908050" y="688975"/>
                        </a:lnTo>
                        <a:lnTo>
                          <a:pt x="927100" y="619125"/>
                        </a:lnTo>
                        <a:lnTo>
                          <a:pt x="939800" y="444500"/>
                        </a:lnTo>
                        <a:lnTo>
                          <a:pt x="962025" y="425450"/>
                        </a:lnTo>
                        <a:lnTo>
                          <a:pt x="974725" y="619125"/>
                        </a:lnTo>
                        <a:lnTo>
                          <a:pt x="984250" y="581025"/>
                        </a:lnTo>
                        <a:lnTo>
                          <a:pt x="996950" y="619125"/>
                        </a:lnTo>
                        <a:lnTo>
                          <a:pt x="1009650" y="498475"/>
                        </a:lnTo>
                        <a:lnTo>
                          <a:pt x="1022350" y="628650"/>
                        </a:lnTo>
                        <a:lnTo>
                          <a:pt x="1044575" y="536575"/>
                        </a:lnTo>
                        <a:lnTo>
                          <a:pt x="1057275" y="552450"/>
                        </a:lnTo>
                        <a:lnTo>
                          <a:pt x="1063625" y="466725"/>
                        </a:lnTo>
                        <a:lnTo>
                          <a:pt x="1089025" y="606425"/>
                        </a:lnTo>
                        <a:lnTo>
                          <a:pt x="1098550" y="581025"/>
                        </a:lnTo>
                        <a:lnTo>
                          <a:pt x="1117600" y="650875"/>
                        </a:lnTo>
                        <a:cubicBezTo>
                          <a:pt x="1118658" y="617008"/>
                          <a:pt x="1119717" y="583142"/>
                          <a:pt x="1120775" y="549275"/>
                        </a:cubicBezTo>
                        <a:lnTo>
                          <a:pt x="1127125" y="476250"/>
                        </a:lnTo>
                        <a:lnTo>
                          <a:pt x="1146175" y="561975"/>
                        </a:lnTo>
                        <a:lnTo>
                          <a:pt x="1162050" y="450850"/>
                        </a:lnTo>
                        <a:lnTo>
                          <a:pt x="1181100" y="565150"/>
                        </a:lnTo>
                        <a:lnTo>
                          <a:pt x="1181100" y="688975"/>
                        </a:lnTo>
                        <a:lnTo>
                          <a:pt x="1193800" y="647700"/>
                        </a:lnTo>
                        <a:lnTo>
                          <a:pt x="1200150" y="688975"/>
                        </a:lnTo>
                        <a:lnTo>
                          <a:pt x="1216025" y="587375"/>
                        </a:lnTo>
                        <a:lnTo>
                          <a:pt x="1219200" y="644525"/>
                        </a:lnTo>
                        <a:lnTo>
                          <a:pt x="1235075" y="441325"/>
                        </a:lnTo>
                        <a:lnTo>
                          <a:pt x="1250950" y="609600"/>
                        </a:lnTo>
                        <a:lnTo>
                          <a:pt x="1260475" y="444500"/>
                        </a:lnTo>
                        <a:lnTo>
                          <a:pt x="1273175" y="558800"/>
                        </a:lnTo>
                        <a:lnTo>
                          <a:pt x="1285875" y="447675"/>
                        </a:lnTo>
                        <a:lnTo>
                          <a:pt x="1304925" y="628650"/>
                        </a:lnTo>
                        <a:lnTo>
                          <a:pt x="1311275" y="546100"/>
                        </a:lnTo>
                        <a:lnTo>
                          <a:pt x="1327150" y="536575"/>
                        </a:lnTo>
                        <a:lnTo>
                          <a:pt x="1339850" y="377825"/>
                        </a:lnTo>
                        <a:lnTo>
                          <a:pt x="1355725" y="527050"/>
                        </a:lnTo>
                        <a:lnTo>
                          <a:pt x="1374775" y="584200"/>
                        </a:lnTo>
                        <a:cubicBezTo>
                          <a:pt x="1375833" y="628650"/>
                          <a:pt x="1376892" y="673100"/>
                          <a:pt x="1377950" y="717550"/>
                        </a:cubicBezTo>
                        <a:lnTo>
                          <a:pt x="1387475" y="660400"/>
                        </a:lnTo>
                        <a:lnTo>
                          <a:pt x="1409700" y="609600"/>
                        </a:lnTo>
                        <a:lnTo>
                          <a:pt x="1416050" y="527050"/>
                        </a:lnTo>
                        <a:lnTo>
                          <a:pt x="1419225" y="609600"/>
                        </a:lnTo>
                        <a:lnTo>
                          <a:pt x="1422400" y="523875"/>
                        </a:lnTo>
                        <a:lnTo>
                          <a:pt x="1447800" y="609600"/>
                        </a:lnTo>
                        <a:lnTo>
                          <a:pt x="1454150" y="549275"/>
                        </a:lnTo>
                        <a:lnTo>
                          <a:pt x="1463675" y="615950"/>
                        </a:lnTo>
                        <a:lnTo>
                          <a:pt x="1463675" y="657225"/>
                        </a:lnTo>
                        <a:lnTo>
                          <a:pt x="1476375" y="517525"/>
                        </a:lnTo>
                        <a:lnTo>
                          <a:pt x="1495425" y="517525"/>
                        </a:lnTo>
                        <a:lnTo>
                          <a:pt x="1508125" y="717550"/>
                        </a:lnTo>
                        <a:lnTo>
                          <a:pt x="1520825" y="800100"/>
                        </a:lnTo>
                        <a:lnTo>
                          <a:pt x="1536700" y="711200"/>
                        </a:lnTo>
                        <a:lnTo>
                          <a:pt x="1552575" y="612775"/>
                        </a:lnTo>
                        <a:lnTo>
                          <a:pt x="1562100" y="536575"/>
                        </a:lnTo>
                        <a:lnTo>
                          <a:pt x="1574800" y="574675"/>
                        </a:lnTo>
                        <a:lnTo>
                          <a:pt x="1590675" y="476250"/>
                        </a:lnTo>
                        <a:lnTo>
                          <a:pt x="1593850" y="482600"/>
                        </a:lnTo>
                        <a:lnTo>
                          <a:pt x="1616075" y="368300"/>
                        </a:lnTo>
                        <a:lnTo>
                          <a:pt x="1635125" y="120650"/>
                        </a:lnTo>
                        <a:lnTo>
                          <a:pt x="1644650" y="254000"/>
                        </a:lnTo>
                        <a:lnTo>
                          <a:pt x="1657350" y="196850"/>
                        </a:lnTo>
                        <a:lnTo>
                          <a:pt x="1673225" y="266700"/>
                        </a:lnTo>
                        <a:lnTo>
                          <a:pt x="1701800" y="225425"/>
                        </a:lnTo>
                        <a:lnTo>
                          <a:pt x="1701800" y="387350"/>
                        </a:lnTo>
                        <a:lnTo>
                          <a:pt x="1714500" y="454025"/>
                        </a:lnTo>
                        <a:lnTo>
                          <a:pt x="1730375" y="552450"/>
                        </a:lnTo>
                        <a:lnTo>
                          <a:pt x="1743075" y="355600"/>
                        </a:lnTo>
                        <a:lnTo>
                          <a:pt x="1765300" y="282575"/>
                        </a:lnTo>
                        <a:lnTo>
                          <a:pt x="1768475" y="377825"/>
                        </a:lnTo>
                        <a:lnTo>
                          <a:pt x="1793875" y="431800"/>
                        </a:lnTo>
                        <a:lnTo>
                          <a:pt x="1803400" y="565150"/>
                        </a:lnTo>
                        <a:lnTo>
                          <a:pt x="1812925" y="520700"/>
                        </a:lnTo>
                        <a:lnTo>
                          <a:pt x="1822450" y="568325"/>
                        </a:lnTo>
                        <a:lnTo>
                          <a:pt x="1835150" y="441325"/>
                        </a:lnTo>
                        <a:lnTo>
                          <a:pt x="1841500" y="231775"/>
                        </a:lnTo>
                        <a:lnTo>
                          <a:pt x="1857375" y="203200"/>
                        </a:lnTo>
                        <a:lnTo>
                          <a:pt x="1873250" y="336550"/>
                        </a:lnTo>
                        <a:lnTo>
                          <a:pt x="1870075" y="288925"/>
                        </a:lnTo>
                        <a:lnTo>
                          <a:pt x="1895475" y="457200"/>
                        </a:lnTo>
                        <a:lnTo>
                          <a:pt x="1911350" y="244475"/>
                        </a:lnTo>
                        <a:lnTo>
                          <a:pt x="1930400" y="111125"/>
                        </a:lnTo>
                        <a:lnTo>
                          <a:pt x="1936750" y="155575"/>
                        </a:lnTo>
                        <a:cubicBezTo>
                          <a:pt x="1939925" y="193675"/>
                          <a:pt x="1936750" y="136525"/>
                          <a:pt x="1939925" y="174625"/>
                        </a:cubicBezTo>
                      </a:path>
                    </a:pathLst>
                  </a:custGeom>
                  <a:noFill/>
                  <a:ln w="317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7" name="TextBox 66">
                    <a:extLst>
                      <a:ext uri="{FF2B5EF4-FFF2-40B4-BE49-F238E27FC236}">
                        <a16:creationId xmlns:a16="http://schemas.microsoft.com/office/drawing/2014/main" id="{08F2A7AF-39C4-D14A-8FB6-92AE3FDF3D58}"/>
                      </a:ext>
                    </a:extLst>
                  </p:cNvPr>
                  <p:cNvSpPr txBox="1"/>
                  <p:nvPr/>
                </p:nvSpPr>
                <p:spPr>
                  <a:xfrm>
                    <a:off x="4989533" y="3460677"/>
                    <a:ext cx="242374" cy="1538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75</a:t>
                    </a:r>
                  </a:p>
                </p:txBody>
              </p:sp>
              <p:sp>
                <p:nvSpPr>
                  <p:cNvPr id="69" name="TextBox 68">
                    <a:extLst>
                      <a:ext uri="{FF2B5EF4-FFF2-40B4-BE49-F238E27FC236}">
                        <a16:creationId xmlns:a16="http://schemas.microsoft.com/office/drawing/2014/main" id="{DF022F56-3713-9641-BC6E-6FE3196282F1}"/>
                      </a:ext>
                    </a:extLst>
                  </p:cNvPr>
                  <p:cNvSpPr txBox="1"/>
                  <p:nvPr/>
                </p:nvSpPr>
                <p:spPr>
                  <a:xfrm>
                    <a:off x="4989533" y="4590133"/>
                    <a:ext cx="242374" cy="1538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0</a:t>
                    </a:r>
                  </a:p>
                </p:txBody>
              </p:sp>
              <p:sp>
                <p:nvSpPr>
                  <p:cNvPr id="115" name="TextBox 114">
                    <a:extLst>
                      <a:ext uri="{FF2B5EF4-FFF2-40B4-BE49-F238E27FC236}">
                        <a16:creationId xmlns:a16="http://schemas.microsoft.com/office/drawing/2014/main" id="{0DCD760B-54E2-6047-A164-54EEFB7568DE}"/>
                      </a:ext>
                    </a:extLst>
                  </p:cNvPr>
                  <p:cNvSpPr txBox="1"/>
                  <p:nvPr/>
                </p:nvSpPr>
                <p:spPr>
                  <a:xfrm>
                    <a:off x="4989533" y="3947409"/>
                    <a:ext cx="242374" cy="15388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4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8</a:t>
                    </a:r>
                  </a:p>
                </p:txBody>
              </p:sp>
              <p:sp>
                <p:nvSpPr>
                  <p:cNvPr id="58" name="Rectangle 57">
                    <a:extLst>
                      <a:ext uri="{FF2B5EF4-FFF2-40B4-BE49-F238E27FC236}">
                        <a16:creationId xmlns:a16="http://schemas.microsoft.com/office/drawing/2014/main" id="{DFBEB871-A2F4-BD47-8136-4312130F7560}"/>
                      </a:ext>
                    </a:extLst>
                  </p:cNvPr>
                  <p:cNvSpPr/>
                  <p:nvPr/>
                </p:nvSpPr>
                <p:spPr>
                  <a:xfrm>
                    <a:off x="3838575" y="4528334"/>
                    <a:ext cx="774700" cy="74327"/>
                  </a:xfrm>
                  <a:prstGeom prst="rect">
                    <a:avLst/>
                  </a:prstGeom>
                  <a:solidFill>
                    <a:schemeClr val="accent5"/>
                  </a:solidFill>
                  <a:ln w="3175">
                    <a:solidFill>
                      <a:schemeClr val="accent5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9" name="Rectangle 58">
                    <a:extLst>
                      <a:ext uri="{FF2B5EF4-FFF2-40B4-BE49-F238E27FC236}">
                        <a16:creationId xmlns:a16="http://schemas.microsoft.com/office/drawing/2014/main" id="{306AF98C-2E0E-9E45-BA64-36E66CD35EC3}"/>
                      </a:ext>
                    </a:extLst>
                  </p:cNvPr>
                  <p:cNvSpPr/>
                  <p:nvPr/>
                </p:nvSpPr>
                <p:spPr>
                  <a:xfrm>
                    <a:off x="3425825" y="4528335"/>
                    <a:ext cx="317500" cy="71148"/>
                  </a:xfrm>
                  <a:prstGeom prst="rect">
                    <a:avLst/>
                  </a:prstGeom>
                  <a:solidFill>
                    <a:schemeClr val="accent4"/>
                  </a:solidFill>
                  <a:ln w="3175">
                    <a:solidFill>
                      <a:schemeClr val="accent4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0" name="Rectangle 59">
                    <a:extLst>
                      <a:ext uri="{FF2B5EF4-FFF2-40B4-BE49-F238E27FC236}">
                        <a16:creationId xmlns:a16="http://schemas.microsoft.com/office/drawing/2014/main" id="{0933F864-D082-4E43-B051-EC6E67317928}"/>
                      </a:ext>
                    </a:extLst>
                  </p:cNvPr>
                  <p:cNvSpPr/>
                  <p:nvPr/>
                </p:nvSpPr>
                <p:spPr>
                  <a:xfrm>
                    <a:off x="3149600" y="4528335"/>
                    <a:ext cx="206374" cy="71148"/>
                  </a:xfrm>
                  <a:prstGeom prst="rect">
                    <a:avLst/>
                  </a:prstGeom>
                  <a:solidFill>
                    <a:schemeClr val="bg1">
                      <a:lumMod val="65000"/>
                    </a:schemeClr>
                  </a:solidFill>
                  <a:ln w="3175">
                    <a:solidFill>
                      <a:schemeClr val="bg1">
                        <a:lumMod val="6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1" name="Rectangle 60">
                    <a:extLst>
                      <a:ext uri="{FF2B5EF4-FFF2-40B4-BE49-F238E27FC236}">
                        <a16:creationId xmlns:a16="http://schemas.microsoft.com/office/drawing/2014/main" id="{BA5D2236-5B4A-AE4D-9997-A4B1EF82E90A}"/>
                      </a:ext>
                    </a:extLst>
                  </p:cNvPr>
                  <p:cNvSpPr/>
                  <p:nvPr/>
                </p:nvSpPr>
                <p:spPr>
                  <a:xfrm>
                    <a:off x="4673600" y="4528335"/>
                    <a:ext cx="238126" cy="71152"/>
                  </a:xfrm>
                  <a:prstGeom prst="rect">
                    <a:avLst/>
                  </a:prstGeom>
                  <a:solidFill>
                    <a:schemeClr val="bg1">
                      <a:lumMod val="65000"/>
                    </a:schemeClr>
                  </a:solidFill>
                  <a:ln w="3175">
                    <a:solidFill>
                      <a:schemeClr val="bg1">
                        <a:lumMod val="6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8" name="Triangle 137">
                    <a:extLst>
                      <a:ext uri="{FF2B5EF4-FFF2-40B4-BE49-F238E27FC236}">
                        <a16:creationId xmlns:a16="http://schemas.microsoft.com/office/drawing/2014/main" id="{580B46CE-BE05-5441-820E-F5D71F5560DD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4881558" y="4529497"/>
                    <a:ext cx="128588" cy="72000"/>
                  </a:xfrm>
                  <a:prstGeom prst="triangle">
                    <a:avLst/>
                  </a:prstGeom>
                  <a:solidFill>
                    <a:schemeClr val="bg1">
                      <a:lumMod val="65000"/>
                    </a:schemeClr>
                  </a:solidFill>
                  <a:ln w="3175">
                    <a:solidFill>
                      <a:schemeClr val="bg1">
                        <a:lumMod val="6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9" name="Triangle 138">
                    <a:extLst>
                      <a:ext uri="{FF2B5EF4-FFF2-40B4-BE49-F238E27FC236}">
                        <a16:creationId xmlns:a16="http://schemas.microsoft.com/office/drawing/2014/main" id="{CC2AA470-3075-A844-91E7-16DC943D2ED4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3744908" y="4529497"/>
                    <a:ext cx="128588" cy="72000"/>
                  </a:xfrm>
                  <a:prstGeom prst="triangle">
                    <a:avLst/>
                  </a:prstGeom>
                  <a:solidFill>
                    <a:schemeClr val="accent5"/>
                  </a:solidFill>
                  <a:ln w="3175">
                    <a:solidFill>
                      <a:schemeClr val="accent5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0" name="Triangle 139">
                    <a:extLst>
                      <a:ext uri="{FF2B5EF4-FFF2-40B4-BE49-F238E27FC236}">
                        <a16:creationId xmlns:a16="http://schemas.microsoft.com/office/drawing/2014/main" id="{3DA53E4E-72B2-9E4B-91F7-15645C949EC6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3332158" y="4529497"/>
                    <a:ext cx="128588" cy="72000"/>
                  </a:xfrm>
                  <a:prstGeom prst="triangle">
                    <a:avLst/>
                  </a:prstGeom>
                  <a:solidFill>
                    <a:schemeClr val="accent4"/>
                  </a:solidFill>
                  <a:ln w="3175">
                    <a:solidFill>
                      <a:schemeClr val="accent4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1" name="Triangle 140">
                    <a:extLst>
                      <a:ext uri="{FF2B5EF4-FFF2-40B4-BE49-F238E27FC236}">
                        <a16:creationId xmlns:a16="http://schemas.microsoft.com/office/drawing/2014/main" id="{FB42E80C-0FC4-2241-B420-AA16DC0452B4}"/>
                      </a:ext>
                    </a:extLst>
                  </p:cNvPr>
                  <p:cNvSpPr/>
                  <p:nvPr/>
                </p:nvSpPr>
                <p:spPr>
                  <a:xfrm rot="16200000">
                    <a:off x="3055933" y="4529497"/>
                    <a:ext cx="128588" cy="72000"/>
                  </a:xfrm>
                  <a:prstGeom prst="triangle">
                    <a:avLst/>
                  </a:prstGeom>
                  <a:solidFill>
                    <a:schemeClr val="bg1">
                      <a:lumMod val="65000"/>
                    </a:schemeClr>
                  </a:solidFill>
                  <a:ln w="3175">
                    <a:solidFill>
                      <a:schemeClr val="bg1">
                        <a:lumMod val="6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sp>
            <p:nvSpPr>
              <p:cNvPr id="97" name="TextBox 96">
                <a:extLst>
                  <a:ext uri="{FF2B5EF4-FFF2-40B4-BE49-F238E27FC236}">
                    <a16:creationId xmlns:a16="http://schemas.microsoft.com/office/drawing/2014/main" id="{B73203AC-5D11-AF48-ADD7-39C43882C4BF}"/>
                  </a:ext>
                </a:extLst>
              </p:cNvPr>
              <p:cNvSpPr txBox="1"/>
              <p:nvPr/>
            </p:nvSpPr>
            <p:spPr>
              <a:xfrm>
                <a:off x="2675124" y="4007661"/>
                <a:ext cx="33374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5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apE</a:t>
                </a:r>
                <a:endParaRPr lang="en-GB" sz="5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0" name="TextBox 99">
                <a:extLst>
                  <a:ext uri="{FF2B5EF4-FFF2-40B4-BE49-F238E27FC236}">
                    <a16:creationId xmlns:a16="http://schemas.microsoft.com/office/drawing/2014/main" id="{959538D8-153B-E745-9FFD-8D9D0A701C1C}"/>
                  </a:ext>
                </a:extLst>
              </p:cNvPr>
              <p:cNvSpPr txBox="1"/>
              <p:nvPr/>
            </p:nvSpPr>
            <p:spPr>
              <a:xfrm>
                <a:off x="3314179" y="4007661"/>
                <a:ext cx="38183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5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orphan</a:t>
                </a:r>
              </a:p>
            </p:txBody>
          </p:sp>
        </p:grp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C5654B84-5A1D-374F-859F-6630D6EBC16D}"/>
                </a:ext>
              </a:extLst>
            </p:cNvPr>
            <p:cNvSpPr txBox="1"/>
            <p:nvPr/>
          </p:nvSpPr>
          <p:spPr>
            <a:xfrm>
              <a:off x="2057254" y="3121852"/>
              <a:ext cx="1382110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(A) </a:t>
              </a:r>
              <a:r>
                <a:rPr lang="en-GB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P. fluorescens </a:t>
              </a:r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SBW25</a:t>
              </a: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23B01E81-7567-9640-8033-ADA554A4C5E5}"/>
                </a:ext>
              </a:extLst>
            </p:cNvPr>
            <p:cNvSpPr txBox="1"/>
            <p:nvPr/>
          </p:nvSpPr>
          <p:spPr>
            <a:xfrm>
              <a:off x="2068765" y="4617401"/>
              <a:ext cx="1149674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(B) </a:t>
              </a:r>
              <a:r>
                <a:rPr lang="en-GB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P. putida </a:t>
              </a:r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KT2440</a:t>
              </a: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C9DB4802-E09A-EA4A-85FB-F88A182B2A5E}"/>
                </a:ext>
              </a:extLst>
            </p:cNvPr>
            <p:cNvSpPr txBox="1"/>
            <p:nvPr/>
          </p:nvSpPr>
          <p:spPr>
            <a:xfrm>
              <a:off x="2059190" y="6123653"/>
              <a:ext cx="1277915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(C) </a:t>
              </a:r>
              <a:r>
                <a:rPr lang="en-GB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P. </a:t>
              </a:r>
              <a:r>
                <a:rPr lang="en-GB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yringae</a:t>
              </a:r>
              <a:r>
                <a:rPr lang="en-GB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DC3000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71A95036-B1EA-1A40-9D34-D100DC928A68}"/>
                </a:ext>
              </a:extLst>
            </p:cNvPr>
            <p:cNvSpPr txBox="1"/>
            <p:nvPr/>
          </p:nvSpPr>
          <p:spPr>
            <a:xfrm rot="16200000">
              <a:off x="4191029" y="3840443"/>
              <a:ext cx="681598" cy="184666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% GC Content</a:t>
              </a: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49CFFA40-67E9-8643-AF7B-1B3007E1582B}"/>
                </a:ext>
              </a:extLst>
            </p:cNvPr>
            <p:cNvSpPr txBox="1"/>
            <p:nvPr/>
          </p:nvSpPr>
          <p:spPr>
            <a:xfrm rot="16200000">
              <a:off x="4191029" y="6847723"/>
              <a:ext cx="681598" cy="184666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% GC Content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6A5DD5DD-7CD0-802D-E6C7-214E4AF2CC04}"/>
              </a:ext>
            </a:extLst>
          </p:cNvPr>
          <p:cNvSpPr txBox="1"/>
          <p:nvPr/>
        </p:nvSpPr>
        <p:spPr>
          <a:xfrm rot="18678800">
            <a:off x="500416" y="4934735"/>
            <a:ext cx="57672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solidFill>
                  <a:schemeClr val="bg1">
                    <a:lumMod val="75000"/>
                  </a:schemeClr>
                </a:solidFill>
              </a:rPr>
              <a:t>DRAFT FIGURE – DRAFT FIGURE – DRAFT FIGURE – DRAFT FIGURE </a:t>
            </a:r>
          </a:p>
        </p:txBody>
      </p:sp>
    </p:spTree>
    <p:extLst>
      <p:ext uri="{BB962C8B-B14F-4D97-AF65-F5344CB8AC3E}">
        <p14:creationId xmlns:p14="http://schemas.microsoft.com/office/powerpoint/2010/main" val="27983967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9</TotalTime>
  <Words>58</Words>
  <Application>Microsoft Macintosh PowerPoint</Application>
  <PresentationFormat>A4 Paper (210x297 mm)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rew Spiers</dc:creator>
  <cp:lastModifiedBy>Andrew Spiers</cp:lastModifiedBy>
  <cp:revision>66</cp:revision>
  <dcterms:created xsi:type="dcterms:W3CDTF">2021-07-20T12:28:49Z</dcterms:created>
  <dcterms:modified xsi:type="dcterms:W3CDTF">2022-08-15T14:04:40Z</dcterms:modified>
</cp:coreProperties>
</file>